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docProps/app.xml" ContentType="application/vnd.openxmlformats-officedocument.extended-properties+xml"/>
  <Override PartName="/docProps/core.xml" ContentType="application/vnd.openxmlformats-package.core-properties+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olors1.xml" ContentType="application/vnd.ms-office.chartcolorstyle+xml"/>
  <Override PartName="/ppt/charts/colors2.xml" ContentType="application/vnd.ms-office.chartcolorstyle+xml"/>
  <Override PartName="/ppt/charts/colors3.xml" ContentType="application/vnd.ms-office.chartcolorstyle+xml"/>
  <Override PartName="/ppt/charts/colors4.xml" ContentType="application/vnd.ms-office.chartcolorstyle+xml"/>
  <Override PartName="/ppt/charts/style1.xml" ContentType="application/vnd.ms-office.chartstyle+xml"/>
  <Override PartName="/ppt/charts/style2.xml" ContentType="application/vnd.ms-office.chartstyle+xml"/>
  <Override PartName="/ppt/charts/style3.xml" ContentType="application/vnd.ms-office.chartstyle+xml"/>
  <Override PartName="/ppt/charts/style4.xml" ContentType="application/vnd.ms-office.chartstyle+xml"/>
  <Override PartName="/ppt/drawings/drawing1.xml" ContentType="application/vnd.openxmlformats-officedocument.drawingml.chartshap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thumbnail" Target="docProps/thumbnail.jpeg"/>
   <Relationship Id="rId3" Type="http://schemas.openxmlformats.org/package/2006/relationships/metadata/core-properties" Target="docProps/core.xml"/>
   <Relationship Id="rId4"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308" r:id="rId2"/>
    <p:sldId id="301" r:id="rId3"/>
    <p:sldId id="299" r:id="rId4"/>
    <p:sldId id="272" r:id="rId5"/>
    <p:sldId id="273" r:id="rId6"/>
    <p:sldId id="307"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CC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0" d="100"/>
          <a:sy n="70" d="100"/>
        </p:scale>
        <p:origin x="714" y="72"/>
      </p:cViewPr>
      <p:guideLst/>
    </p:cSldViewPr>
  </p:slideViewPr>
  <p:notesTextViewPr>
    <p:cViewPr>
      <p:scale>
        <a:sx n="1" d="1"/>
        <a:sy n="1" d="1"/>
      </p:scale>
      <p:origin x="0" y="0"/>
    </p:cViewPr>
  </p:notesTextViewPr>
  <p:gridSpacing cx="76200" cy="76200"/>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10" Type="http://schemas.openxmlformats.org/officeDocument/2006/relationships/viewProps" Target="viewProps.xml"/>
   <Relationship Id="rId11" Type="http://schemas.openxmlformats.org/officeDocument/2006/relationships/theme" Target="theme/theme1.xml"/>
   <Relationship Id="rId12" Type="http://schemas.openxmlformats.org/officeDocument/2006/relationships/tableStyles" Target="tableStyles.xml"/>
   <Relationship Id="rId2" Type="http://schemas.openxmlformats.org/officeDocument/2006/relationships/slide" Target="slides/slide1.xml"/>
   <Relationship Id="rId3" Type="http://schemas.openxmlformats.org/officeDocument/2006/relationships/slide" Target="slides/slide2.xml"/>
   <Relationship Id="rId4" Type="http://schemas.openxmlformats.org/officeDocument/2006/relationships/slide" Target="slides/slide3.xml"/>
   <Relationship Id="rId5" Type="http://schemas.openxmlformats.org/officeDocument/2006/relationships/slide" Target="slides/slide4.xml"/>
   <Relationship Id="rId6" Type="http://schemas.openxmlformats.org/officeDocument/2006/relationships/slide" Target="slides/slide5.xml"/>
   <Relationship Id="rId7" Type="http://schemas.openxmlformats.org/officeDocument/2006/relationships/slide" Target="slides/slide6.xml"/>
   <Relationship Id="rId8" Type="http://schemas.openxmlformats.org/officeDocument/2006/relationships/notesMaster" Target="notesMasters/notesMaster1.xml"/>
   <Relationship Id="rId9" Type="http://schemas.openxmlformats.org/officeDocument/2006/relationships/presProps" Target="presProps.xml"/>
</Relationships>
</file>

<file path=ppt/charts/_rels/chart1.xml.rels><?xml version = '1.0' encoding = 'UTF-8' standalone = 'yes'?>
<Relationships xmlns="http://schemas.openxmlformats.org/package/2006/relationships">
   <Relationship Id="rId1" Type="http://schemas.microsoft.com/office/2011/relationships/chartStyle" Target="style1.xml"/>
   <Relationship Id="rId2" Type="http://schemas.microsoft.com/office/2011/relationships/chartColorStyle" Target="colors1.xml"/>
   <Relationship Id="rId3" Type="http://schemas.openxmlformats.org/officeDocument/2006/relationships/oleObject" TargetMode="External" Target="file:///C:/Users/gglinsky/Desktop/2015_2016%20VittorioS/2016_CSC%20VittorioS/HPATs%20BLastocyst%20Cells/HPATclassification.xlsx"/>
</Relationships>
</file>

<file path=ppt/charts/_rels/chart2.xml.rels><?xml version = '1.0' encoding = 'UTF-8' standalone = 'yes'?>
<Relationships xmlns="http://schemas.openxmlformats.org/package/2006/relationships">
   <Relationship Id="rId1" Type="http://schemas.microsoft.com/office/2011/relationships/chartStyle" Target="style2.xml"/>
   <Relationship Id="rId2" Type="http://schemas.microsoft.com/office/2011/relationships/chartColorStyle" Target="colors2.xml"/>
   <Relationship Id="rId3" Type="http://schemas.openxmlformats.org/officeDocument/2006/relationships/oleObject" TargetMode="External" Target="file:///C:/Users/gglinsky/Desktop/2015_2016%20VittorioS/2016_CSC%20VittorioS/HPATs%20BLastocyst%20Cells/HPATs%20Blastocysts.xlsx"/>
   <Relationship Id="rId4" Type="http://schemas.openxmlformats.org/officeDocument/2006/relationships/chartUserShapes" Target="../drawings/drawing1.xml"/>
</Relationships>
</file>

<file path=ppt/charts/_rels/chart3.xml.rels><?xml version = '1.0' encoding = 'UTF-8' standalone = 'yes'?>
<Relationships xmlns="http://schemas.openxmlformats.org/package/2006/relationships">
   <Relationship Id="rId1" Type="http://schemas.microsoft.com/office/2011/relationships/chartStyle" Target="style3.xml"/>
   <Relationship Id="rId2" Type="http://schemas.microsoft.com/office/2011/relationships/chartColorStyle" Target="colors3.xml"/>
   <Relationship Id="rId3" Type="http://schemas.openxmlformats.org/officeDocument/2006/relationships/oleObject" TargetMode="External" Target="file:///C:/Users/gglinsky/Desktop/2015_2016%20VittorioS/2016_CSC%20VittorioS/HPATs%20BLastocyst%20Cells/HPATs%20Blastocysts.xlsx"/>
</Relationships>
</file>

<file path=ppt/charts/_rels/chart4.xml.rels><?xml version = '1.0' encoding = 'UTF-8' standalone = 'yes'?>
<Relationships xmlns="http://schemas.openxmlformats.org/package/2006/relationships">
   <Relationship Id="rId1" Type="http://schemas.microsoft.com/office/2011/relationships/chartStyle" Target="style4.xml"/>
   <Relationship Id="rId2" Type="http://schemas.microsoft.com/office/2011/relationships/chartColorStyle" Target="colors4.xml"/>
   <Relationship Id="rId3" Type="http://schemas.openxmlformats.org/officeDocument/2006/relationships/oleObject" TargetMode="External" Target="file:///C:/Users/gglinsky/Desktop/2015_2016%20VittorioS/2016_CSC%20VittorioS/HPATs%20BLastocyst%20Cells/HPATs%20Blastocysts.xlsx"/>
</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600" b="0" i="0" u="none" strike="noStrike" kern="1200" spc="0" baseline="0">
                <a:solidFill>
                  <a:sysClr val="windowText" lastClr="000000"/>
                </a:solidFill>
                <a:latin typeface="+mn-lt"/>
                <a:ea typeface="+mn-ea"/>
                <a:cs typeface="+mn-cs"/>
              </a:defRPr>
            </a:pPr>
            <a:r>
              <a:rPr lang="en-US" sz="1600" b="1" i="0" baseline="0">
                <a:solidFill>
                  <a:sysClr val="windowText" lastClr="000000"/>
                </a:solidFill>
                <a:effectLst/>
              </a:rPr>
              <a:t>EXPRESSION PATTERNS OF THE HPAT21; HPAT15; HPAT2; AND TERT </a:t>
            </a:r>
          </a:p>
          <a:p>
            <a:pPr marL="0" marR="0" indent="0" algn="ctr" defTabSz="914400" rtl="0" eaLnBrk="1" fontAlgn="auto" latinLnBrk="0" hangingPunct="1">
              <a:lnSpc>
                <a:spcPct val="100000"/>
              </a:lnSpc>
              <a:spcBef>
                <a:spcPts val="0"/>
              </a:spcBef>
              <a:spcAft>
                <a:spcPts val="0"/>
              </a:spcAft>
              <a:buClrTx/>
              <a:buSzTx/>
              <a:buFontTx/>
              <a:buNone/>
              <a:tabLst/>
              <a:defRPr sz="1600">
                <a:solidFill>
                  <a:sysClr val="windowText" lastClr="000000"/>
                </a:solidFill>
              </a:defRPr>
            </a:pPr>
            <a:r>
              <a:rPr lang="en-US" sz="1600" b="1" i="0" baseline="0">
                <a:solidFill>
                  <a:sysClr val="windowText" lastClr="000000"/>
                </a:solidFill>
                <a:effectLst/>
              </a:rPr>
              <a:t>IN 241 HUMAN BLASTOCYST CELLS</a:t>
            </a:r>
            <a:endParaRPr lang="en-US" sz="1600">
              <a:solidFill>
                <a:sysClr val="windowText" lastClr="000000"/>
              </a:solidFill>
              <a:effectLst/>
            </a:endParaRPr>
          </a:p>
        </c:rich>
      </c:tx>
      <c:layout/>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6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1188937556066385E-2"/>
          <c:y val="0.14931095178809087"/>
          <c:w val="0.89268656516582268"/>
          <c:h val="0.74662376711490175"/>
        </c:manualLayout>
      </c:layout>
      <c:areaChart>
        <c:grouping val="stacked"/>
        <c:varyColors val="0"/>
        <c:ser>
          <c:idx val="0"/>
          <c:order val="0"/>
          <c:tx>
            <c:strRef>
              <c:f>Sheet1!$D$1</c:f>
              <c:strCache>
                <c:ptCount val="1"/>
                <c:pt idx="0">
                  <c:v>HPAT21</c:v>
                </c:pt>
              </c:strCache>
            </c:strRef>
          </c:tx>
          <c:spPr>
            <a:solidFill>
              <a:schemeClr val="accent1"/>
            </a:solidFill>
            <a:ln>
              <a:noFill/>
            </a:ln>
            <a:effectLst/>
          </c:spPr>
          <c:cat>
            <c:strRef>
              <c:f>Sheet1!$C$2:$C$242</c:f>
              <c:strCache>
                <c:ptCount val="241"/>
                <c:pt idx="0">
                  <c:v>early</c:v>
                </c:pt>
                <c:pt idx="1">
                  <c:v>early</c:v>
                </c:pt>
                <c:pt idx="2">
                  <c:v>early</c:v>
                </c:pt>
                <c:pt idx="3">
                  <c:v>early</c:v>
                </c:pt>
                <c:pt idx="4">
                  <c:v>early</c:v>
                </c:pt>
                <c:pt idx="5">
                  <c:v>early</c:v>
                </c:pt>
                <c:pt idx="6">
                  <c:v>early</c:v>
                </c:pt>
                <c:pt idx="7">
                  <c:v>early</c:v>
                </c:pt>
                <c:pt idx="8">
                  <c:v>early</c:v>
                </c:pt>
                <c:pt idx="9">
                  <c:v>early</c:v>
                </c:pt>
                <c:pt idx="10">
                  <c:v>early</c:v>
                </c:pt>
                <c:pt idx="11">
                  <c:v>early</c:v>
                </c:pt>
                <c:pt idx="12">
                  <c:v>early</c:v>
                </c:pt>
                <c:pt idx="13">
                  <c:v>early</c:v>
                </c:pt>
                <c:pt idx="14">
                  <c:v>early</c:v>
                </c:pt>
                <c:pt idx="15">
                  <c:v>early</c:v>
                </c:pt>
                <c:pt idx="16">
                  <c:v>early</c:v>
                </c:pt>
                <c:pt idx="17">
                  <c:v>early</c:v>
                </c:pt>
                <c:pt idx="18">
                  <c:v>early</c:v>
                </c:pt>
                <c:pt idx="19">
                  <c:v>early</c:v>
                </c:pt>
                <c:pt idx="20">
                  <c:v>early</c:v>
                </c:pt>
                <c:pt idx="21">
                  <c:v>early</c:v>
                </c:pt>
                <c:pt idx="22">
                  <c:v>early</c:v>
                </c:pt>
                <c:pt idx="23">
                  <c:v>early</c:v>
                </c:pt>
                <c:pt idx="24">
                  <c:v>early</c:v>
                </c:pt>
                <c:pt idx="25">
                  <c:v>early</c:v>
                </c:pt>
                <c:pt idx="26">
                  <c:v>early</c:v>
                </c:pt>
                <c:pt idx="27">
                  <c:v>early</c:v>
                </c:pt>
                <c:pt idx="28">
                  <c:v>early</c:v>
                </c:pt>
                <c:pt idx="29">
                  <c:v>early</c:v>
                </c:pt>
                <c:pt idx="30">
                  <c:v>early</c:v>
                </c:pt>
                <c:pt idx="31">
                  <c:v>early</c:v>
                </c:pt>
                <c:pt idx="32">
                  <c:v>early</c:v>
                </c:pt>
                <c:pt idx="33">
                  <c:v>late</c:v>
                </c:pt>
                <c:pt idx="34">
                  <c:v>late</c:v>
                </c:pt>
                <c:pt idx="35">
                  <c:v>late</c:v>
                </c:pt>
                <c:pt idx="36">
                  <c:v>late</c:v>
                </c:pt>
                <c:pt idx="37">
                  <c:v>late</c:v>
                </c:pt>
                <c:pt idx="38">
                  <c:v>late</c:v>
                </c:pt>
                <c:pt idx="39">
                  <c:v>late</c:v>
                </c:pt>
                <c:pt idx="40">
                  <c:v>late</c:v>
                </c:pt>
                <c:pt idx="41">
                  <c:v>late</c:v>
                </c:pt>
                <c:pt idx="42">
                  <c:v>late</c:v>
                </c:pt>
                <c:pt idx="43">
                  <c:v>late</c:v>
                </c:pt>
                <c:pt idx="44">
                  <c:v>late</c:v>
                </c:pt>
                <c:pt idx="45">
                  <c:v>late</c:v>
                </c:pt>
                <c:pt idx="46">
                  <c:v>late</c:v>
                </c:pt>
                <c:pt idx="47">
                  <c:v>late</c:v>
                </c:pt>
                <c:pt idx="48">
                  <c:v>late</c:v>
                </c:pt>
                <c:pt idx="49">
                  <c:v>late</c:v>
                </c:pt>
                <c:pt idx="50">
                  <c:v>late</c:v>
                </c:pt>
                <c:pt idx="51">
                  <c:v>late</c:v>
                </c:pt>
                <c:pt idx="52">
                  <c:v>late</c:v>
                </c:pt>
                <c:pt idx="53">
                  <c:v>late</c:v>
                </c:pt>
                <c:pt idx="54">
                  <c:v>late</c:v>
                </c:pt>
                <c:pt idx="55">
                  <c:v>late</c:v>
                </c:pt>
                <c:pt idx="56">
                  <c:v>late</c:v>
                </c:pt>
                <c:pt idx="57">
                  <c:v>late</c:v>
                </c:pt>
                <c:pt idx="58">
                  <c:v>late</c:v>
                </c:pt>
                <c:pt idx="59">
                  <c:v>late</c:v>
                </c:pt>
                <c:pt idx="60">
                  <c:v>late</c:v>
                </c:pt>
                <c:pt idx="61">
                  <c:v>late</c:v>
                </c:pt>
                <c:pt idx="62">
                  <c:v>late</c:v>
                </c:pt>
                <c:pt idx="63">
                  <c:v>late</c:v>
                </c:pt>
                <c:pt idx="64">
                  <c:v>late</c:v>
                </c:pt>
                <c:pt idx="65">
                  <c:v>late</c:v>
                </c:pt>
                <c:pt idx="66">
                  <c:v>late</c:v>
                </c:pt>
                <c:pt idx="67">
                  <c:v>late</c:v>
                </c:pt>
                <c:pt idx="68">
                  <c:v>late</c:v>
                </c:pt>
                <c:pt idx="69">
                  <c:v>late</c:v>
                </c:pt>
                <c:pt idx="70">
                  <c:v>late</c:v>
                </c:pt>
                <c:pt idx="71">
                  <c:v>late</c:v>
                </c:pt>
                <c:pt idx="72">
                  <c:v>late</c:v>
                </c:pt>
                <c:pt idx="73">
                  <c:v>late</c:v>
                </c:pt>
                <c:pt idx="74">
                  <c:v>late</c:v>
                </c:pt>
                <c:pt idx="75">
                  <c:v>late</c:v>
                </c:pt>
                <c:pt idx="76">
                  <c:v>late</c:v>
                </c:pt>
                <c:pt idx="77">
                  <c:v>late</c:v>
                </c:pt>
                <c:pt idx="78">
                  <c:v>late</c:v>
                </c:pt>
                <c:pt idx="79">
                  <c:v>late</c:v>
                </c:pt>
                <c:pt idx="80">
                  <c:v>late</c:v>
                </c:pt>
                <c:pt idx="81">
                  <c:v>late</c:v>
                </c:pt>
                <c:pt idx="82">
                  <c:v>late</c:v>
                </c:pt>
                <c:pt idx="83">
                  <c:v>late</c:v>
                </c:pt>
                <c:pt idx="84">
                  <c:v>late</c:v>
                </c:pt>
                <c:pt idx="85">
                  <c:v>late</c:v>
                </c:pt>
                <c:pt idx="86">
                  <c:v>late</c:v>
                </c:pt>
                <c:pt idx="87">
                  <c:v>late</c:v>
                </c:pt>
                <c:pt idx="88">
                  <c:v>late</c:v>
                </c:pt>
                <c:pt idx="89">
                  <c:v>late</c:v>
                </c:pt>
                <c:pt idx="90">
                  <c:v>early</c:v>
                </c:pt>
                <c:pt idx="91">
                  <c:v>early</c:v>
                </c:pt>
                <c:pt idx="92">
                  <c:v>early</c:v>
                </c:pt>
                <c:pt idx="93">
                  <c:v>early</c:v>
                </c:pt>
                <c:pt idx="94">
                  <c:v>late</c:v>
                </c:pt>
                <c:pt idx="95">
                  <c:v>late</c:v>
                </c:pt>
                <c:pt idx="96">
                  <c:v>late</c:v>
                </c:pt>
                <c:pt idx="97">
                  <c:v>late</c:v>
                </c:pt>
                <c:pt idx="98">
                  <c:v>late</c:v>
                </c:pt>
                <c:pt idx="99">
                  <c:v>late</c:v>
                </c:pt>
                <c:pt idx="100">
                  <c:v>late</c:v>
                </c:pt>
                <c:pt idx="101">
                  <c:v>late</c:v>
                </c:pt>
                <c:pt idx="102">
                  <c:v>late</c:v>
                </c:pt>
                <c:pt idx="103">
                  <c:v>late</c:v>
                </c:pt>
                <c:pt idx="104">
                  <c:v>late</c:v>
                </c:pt>
                <c:pt idx="105">
                  <c:v>late</c:v>
                </c:pt>
                <c:pt idx="106">
                  <c:v>late</c:v>
                </c:pt>
                <c:pt idx="107">
                  <c:v>late</c:v>
                </c:pt>
                <c:pt idx="108">
                  <c:v>late</c:v>
                </c:pt>
                <c:pt idx="109">
                  <c:v>late</c:v>
                </c:pt>
                <c:pt idx="110">
                  <c:v>late</c:v>
                </c:pt>
                <c:pt idx="111">
                  <c:v>late</c:v>
                </c:pt>
                <c:pt idx="112">
                  <c:v>late</c:v>
                </c:pt>
                <c:pt idx="113">
                  <c:v>late</c:v>
                </c:pt>
                <c:pt idx="114">
                  <c:v>late</c:v>
                </c:pt>
                <c:pt idx="115">
                  <c:v>early</c:v>
                </c:pt>
                <c:pt idx="116">
                  <c:v>early</c:v>
                </c:pt>
                <c:pt idx="117">
                  <c:v>early</c:v>
                </c:pt>
                <c:pt idx="118">
                  <c:v>early</c:v>
                </c:pt>
                <c:pt idx="119">
                  <c:v>early</c:v>
                </c:pt>
                <c:pt idx="120">
                  <c:v>early</c:v>
                </c:pt>
                <c:pt idx="121">
                  <c:v>early</c:v>
                </c:pt>
                <c:pt idx="122">
                  <c:v>early</c:v>
                </c:pt>
                <c:pt idx="123">
                  <c:v>early</c:v>
                </c:pt>
                <c:pt idx="124">
                  <c:v>early</c:v>
                </c:pt>
                <c:pt idx="125">
                  <c:v>early</c:v>
                </c:pt>
                <c:pt idx="126">
                  <c:v>early</c:v>
                </c:pt>
                <c:pt idx="127">
                  <c:v>early</c:v>
                </c:pt>
                <c:pt idx="128">
                  <c:v>early</c:v>
                </c:pt>
                <c:pt idx="129">
                  <c:v>early</c:v>
                </c:pt>
                <c:pt idx="130">
                  <c:v>early</c:v>
                </c:pt>
                <c:pt idx="131">
                  <c:v>early</c:v>
                </c:pt>
                <c:pt idx="132">
                  <c:v>late</c:v>
                </c:pt>
                <c:pt idx="133">
                  <c:v>late</c:v>
                </c:pt>
                <c:pt idx="134">
                  <c:v>late</c:v>
                </c:pt>
                <c:pt idx="135">
                  <c:v>late</c:v>
                </c:pt>
                <c:pt idx="136">
                  <c:v>late</c:v>
                </c:pt>
                <c:pt idx="137">
                  <c:v>late</c:v>
                </c:pt>
                <c:pt idx="138">
                  <c:v>late</c:v>
                </c:pt>
                <c:pt idx="139">
                  <c:v>late</c:v>
                </c:pt>
                <c:pt idx="140">
                  <c:v>late</c:v>
                </c:pt>
                <c:pt idx="141">
                  <c:v>late</c:v>
                </c:pt>
                <c:pt idx="142">
                  <c:v>late</c:v>
                </c:pt>
                <c:pt idx="143">
                  <c:v>late</c:v>
                </c:pt>
                <c:pt idx="144">
                  <c:v>late</c:v>
                </c:pt>
                <c:pt idx="145">
                  <c:v>late</c:v>
                </c:pt>
                <c:pt idx="146">
                  <c:v>late</c:v>
                </c:pt>
                <c:pt idx="147">
                  <c:v>late</c:v>
                </c:pt>
                <c:pt idx="148">
                  <c:v>early</c:v>
                </c:pt>
                <c:pt idx="149">
                  <c:v>early</c:v>
                </c:pt>
                <c:pt idx="150">
                  <c:v>early</c:v>
                </c:pt>
                <c:pt idx="151">
                  <c:v>early</c:v>
                </c:pt>
                <c:pt idx="152">
                  <c:v>early</c:v>
                </c:pt>
                <c:pt idx="153">
                  <c:v>early</c:v>
                </c:pt>
                <c:pt idx="154">
                  <c:v>early</c:v>
                </c:pt>
                <c:pt idx="155">
                  <c:v>early</c:v>
                </c:pt>
                <c:pt idx="156">
                  <c:v>early</c:v>
                </c:pt>
                <c:pt idx="157">
                  <c:v>early</c:v>
                </c:pt>
                <c:pt idx="158">
                  <c:v>early</c:v>
                </c:pt>
                <c:pt idx="159">
                  <c:v>early</c:v>
                </c:pt>
                <c:pt idx="160">
                  <c:v>early</c:v>
                </c:pt>
                <c:pt idx="161">
                  <c:v>early</c:v>
                </c:pt>
                <c:pt idx="162">
                  <c:v>early</c:v>
                </c:pt>
                <c:pt idx="163">
                  <c:v>early</c:v>
                </c:pt>
                <c:pt idx="164">
                  <c:v>early</c:v>
                </c:pt>
                <c:pt idx="165">
                  <c:v>early</c:v>
                </c:pt>
                <c:pt idx="166">
                  <c:v>early</c:v>
                </c:pt>
                <c:pt idx="167">
                  <c:v>early</c:v>
                </c:pt>
                <c:pt idx="168">
                  <c:v>early</c:v>
                </c:pt>
                <c:pt idx="169">
                  <c:v>early</c:v>
                </c:pt>
                <c:pt idx="170">
                  <c:v>early</c:v>
                </c:pt>
                <c:pt idx="171">
                  <c:v>early</c:v>
                </c:pt>
                <c:pt idx="172">
                  <c:v>early</c:v>
                </c:pt>
                <c:pt idx="173">
                  <c:v>early</c:v>
                </c:pt>
                <c:pt idx="174">
                  <c:v>early</c:v>
                </c:pt>
                <c:pt idx="175">
                  <c:v>early</c:v>
                </c:pt>
                <c:pt idx="176">
                  <c:v>early</c:v>
                </c:pt>
                <c:pt idx="177">
                  <c:v>early</c:v>
                </c:pt>
                <c:pt idx="178">
                  <c:v>early</c:v>
                </c:pt>
                <c:pt idx="179">
                  <c:v>early</c:v>
                </c:pt>
                <c:pt idx="180">
                  <c:v>early</c:v>
                </c:pt>
                <c:pt idx="181">
                  <c:v>early</c:v>
                </c:pt>
                <c:pt idx="182">
                  <c:v>late</c:v>
                </c:pt>
                <c:pt idx="183">
                  <c:v>late</c:v>
                </c:pt>
                <c:pt idx="184">
                  <c:v>late</c:v>
                </c:pt>
                <c:pt idx="185">
                  <c:v>late</c:v>
                </c:pt>
                <c:pt idx="186">
                  <c:v>late</c:v>
                </c:pt>
                <c:pt idx="187">
                  <c:v>late</c:v>
                </c:pt>
                <c:pt idx="188">
                  <c:v>late</c:v>
                </c:pt>
                <c:pt idx="189">
                  <c:v>late</c:v>
                </c:pt>
                <c:pt idx="190">
                  <c:v>late</c:v>
                </c:pt>
                <c:pt idx="191">
                  <c:v>late</c:v>
                </c:pt>
                <c:pt idx="192">
                  <c:v>late</c:v>
                </c:pt>
                <c:pt idx="193">
                  <c:v>late</c:v>
                </c:pt>
                <c:pt idx="194">
                  <c:v>late</c:v>
                </c:pt>
                <c:pt idx="195">
                  <c:v>late</c:v>
                </c:pt>
                <c:pt idx="196">
                  <c:v>late</c:v>
                </c:pt>
                <c:pt idx="197">
                  <c:v>late</c:v>
                </c:pt>
                <c:pt idx="198">
                  <c:v>late</c:v>
                </c:pt>
                <c:pt idx="199">
                  <c:v>late</c:v>
                </c:pt>
                <c:pt idx="200">
                  <c:v>late</c:v>
                </c:pt>
                <c:pt idx="201">
                  <c:v>late</c:v>
                </c:pt>
                <c:pt idx="202">
                  <c:v>late</c:v>
                </c:pt>
                <c:pt idx="203">
                  <c:v>late</c:v>
                </c:pt>
                <c:pt idx="204">
                  <c:v>late</c:v>
                </c:pt>
                <c:pt idx="205">
                  <c:v>late</c:v>
                </c:pt>
                <c:pt idx="206">
                  <c:v>late</c:v>
                </c:pt>
                <c:pt idx="207">
                  <c:v>late</c:v>
                </c:pt>
                <c:pt idx="208">
                  <c:v>late</c:v>
                </c:pt>
                <c:pt idx="209">
                  <c:v>late</c:v>
                </c:pt>
                <c:pt idx="210">
                  <c:v>late</c:v>
                </c:pt>
                <c:pt idx="211">
                  <c:v>late</c:v>
                </c:pt>
                <c:pt idx="212">
                  <c:v>late</c:v>
                </c:pt>
                <c:pt idx="213">
                  <c:v>late</c:v>
                </c:pt>
                <c:pt idx="214">
                  <c:v>late</c:v>
                </c:pt>
                <c:pt idx="215">
                  <c:v>late</c:v>
                </c:pt>
                <c:pt idx="216">
                  <c:v>late</c:v>
                </c:pt>
                <c:pt idx="217">
                  <c:v>late</c:v>
                </c:pt>
                <c:pt idx="218">
                  <c:v>late</c:v>
                </c:pt>
                <c:pt idx="219">
                  <c:v>late</c:v>
                </c:pt>
                <c:pt idx="220">
                  <c:v>late</c:v>
                </c:pt>
                <c:pt idx="221">
                  <c:v>late</c:v>
                </c:pt>
                <c:pt idx="222">
                  <c:v>late</c:v>
                </c:pt>
                <c:pt idx="223">
                  <c:v>late</c:v>
                </c:pt>
                <c:pt idx="224">
                  <c:v>late</c:v>
                </c:pt>
                <c:pt idx="225">
                  <c:v>late</c:v>
                </c:pt>
                <c:pt idx="226">
                  <c:v>late</c:v>
                </c:pt>
                <c:pt idx="227">
                  <c:v>late</c:v>
                </c:pt>
                <c:pt idx="228">
                  <c:v>late</c:v>
                </c:pt>
                <c:pt idx="229">
                  <c:v>late</c:v>
                </c:pt>
                <c:pt idx="230">
                  <c:v>late</c:v>
                </c:pt>
                <c:pt idx="231">
                  <c:v>late</c:v>
                </c:pt>
                <c:pt idx="232">
                  <c:v>late</c:v>
                </c:pt>
                <c:pt idx="233">
                  <c:v>late</c:v>
                </c:pt>
                <c:pt idx="234">
                  <c:v>late</c:v>
                </c:pt>
                <c:pt idx="235">
                  <c:v>late</c:v>
                </c:pt>
                <c:pt idx="236">
                  <c:v>late</c:v>
                </c:pt>
                <c:pt idx="237">
                  <c:v>late</c:v>
                </c:pt>
                <c:pt idx="238">
                  <c:v>late</c:v>
                </c:pt>
                <c:pt idx="239">
                  <c:v>late</c:v>
                </c:pt>
                <c:pt idx="240">
                  <c:v>late</c:v>
                </c:pt>
              </c:strCache>
            </c:strRef>
          </c:cat>
          <c:val>
            <c:numRef>
              <c:f>Sheet1!$D$2:$D$242</c:f>
              <c:numCache>
                <c:formatCode>General</c:formatCode>
                <c:ptCount val="241"/>
                <c:pt idx="0">
                  <c:v>11.99873328</c:v>
                </c:pt>
                <c:pt idx="1">
                  <c:v>12.09656665</c:v>
                </c:pt>
                <c:pt idx="2">
                  <c:v>10.13427742</c:v>
                </c:pt>
                <c:pt idx="3">
                  <c:v>5.7545995220000004</c:v>
                </c:pt>
                <c:pt idx="4">
                  <c:v>5.2873062040000001</c:v>
                </c:pt>
                <c:pt idx="5">
                  <c:v>9.5741062479999997</c:v>
                </c:pt>
                <c:pt idx="6">
                  <c:v>11.191305699999999</c:v>
                </c:pt>
                <c:pt idx="7">
                  <c:v>9.4413358800000005</c:v>
                </c:pt>
                <c:pt idx="8">
                  <c:v>10.97115032</c:v>
                </c:pt>
                <c:pt idx="9">
                  <c:v>7.7423445859999998</c:v>
                </c:pt>
                <c:pt idx="10">
                  <c:v>11.50356021</c:v>
                </c:pt>
                <c:pt idx="11">
                  <c:v>11.41893282</c:v>
                </c:pt>
                <c:pt idx="12">
                  <c:v>8.3299059379999996</c:v>
                </c:pt>
                <c:pt idx="13">
                  <c:v>11.14788624</c:v>
                </c:pt>
                <c:pt idx="14">
                  <c:v>11.04963373</c:v>
                </c:pt>
                <c:pt idx="15">
                  <c:v>10.278764730000001</c:v>
                </c:pt>
                <c:pt idx="16">
                  <c:v>5.315456706</c:v>
                </c:pt>
                <c:pt idx="17">
                  <c:v>11.5565427</c:v>
                </c:pt>
                <c:pt idx="18">
                  <c:v>9.6389264959999998</c:v>
                </c:pt>
                <c:pt idx="19">
                  <c:v>9.0586594320000007</c:v>
                </c:pt>
                <c:pt idx="20">
                  <c:v>9.2414128519999998</c:v>
                </c:pt>
                <c:pt idx="21">
                  <c:v>7.1095627280000002</c:v>
                </c:pt>
                <c:pt idx="22">
                  <c:v>12.48149197</c:v>
                </c:pt>
                <c:pt idx="23">
                  <c:v>11.61118426</c:v>
                </c:pt>
                <c:pt idx="24">
                  <c:v>10.645449599999999</c:v>
                </c:pt>
                <c:pt idx="25">
                  <c:v>11.509520220000001</c:v>
                </c:pt>
                <c:pt idx="26">
                  <c:v>11.49715307</c:v>
                </c:pt>
                <c:pt idx="27">
                  <c:v>0</c:v>
                </c:pt>
                <c:pt idx="28">
                  <c:v>0</c:v>
                </c:pt>
                <c:pt idx="29">
                  <c:v>0</c:v>
                </c:pt>
                <c:pt idx="30">
                  <c:v>0</c:v>
                </c:pt>
                <c:pt idx="31">
                  <c:v>0</c:v>
                </c:pt>
                <c:pt idx="32">
                  <c:v>0</c:v>
                </c:pt>
                <c:pt idx="33">
                  <c:v>9.558829867</c:v>
                </c:pt>
                <c:pt idx="34">
                  <c:v>11.419728510000001</c:v>
                </c:pt>
                <c:pt idx="35">
                  <c:v>12.59500261</c:v>
                </c:pt>
                <c:pt idx="36">
                  <c:v>8.8265643209999993</c:v>
                </c:pt>
                <c:pt idx="37">
                  <c:v>9.2752559699999999</c:v>
                </c:pt>
                <c:pt idx="38">
                  <c:v>11.86805801</c:v>
                </c:pt>
                <c:pt idx="39">
                  <c:v>6.9712677320000003</c:v>
                </c:pt>
                <c:pt idx="40">
                  <c:v>9.092474245</c:v>
                </c:pt>
                <c:pt idx="41">
                  <c:v>8.9943366400000002</c:v>
                </c:pt>
                <c:pt idx="42">
                  <c:v>12.529868909999999</c:v>
                </c:pt>
                <c:pt idx="43">
                  <c:v>14.033336050000001</c:v>
                </c:pt>
                <c:pt idx="44">
                  <c:v>13.276352060000001</c:v>
                </c:pt>
                <c:pt idx="45">
                  <c:v>11.63699366</c:v>
                </c:pt>
                <c:pt idx="46">
                  <c:v>10.075975120000001</c:v>
                </c:pt>
                <c:pt idx="47">
                  <c:v>7.7950492029999996</c:v>
                </c:pt>
                <c:pt idx="48">
                  <c:v>8.8695645110000001</c:v>
                </c:pt>
                <c:pt idx="49">
                  <c:v>10.090433190000001</c:v>
                </c:pt>
                <c:pt idx="50">
                  <c:v>9.7654756549999995</c:v>
                </c:pt>
                <c:pt idx="51">
                  <c:v>11.228448350000001</c:v>
                </c:pt>
                <c:pt idx="52">
                  <c:v>12.10672969</c:v>
                </c:pt>
                <c:pt idx="53">
                  <c:v>12.946798920000001</c:v>
                </c:pt>
                <c:pt idx="54">
                  <c:v>9.8251244930000006</c:v>
                </c:pt>
                <c:pt idx="55">
                  <c:v>8.9613813580000006</c:v>
                </c:pt>
                <c:pt idx="56">
                  <c:v>13.85670767</c:v>
                </c:pt>
                <c:pt idx="57">
                  <c:v>12.60755625</c:v>
                </c:pt>
                <c:pt idx="58">
                  <c:v>9.2933112040000001</c:v>
                </c:pt>
                <c:pt idx="59">
                  <c:v>9.6009175689999999</c:v>
                </c:pt>
                <c:pt idx="60">
                  <c:v>12.579351559999999</c:v>
                </c:pt>
                <c:pt idx="61">
                  <c:v>13.5442982</c:v>
                </c:pt>
                <c:pt idx="62">
                  <c:v>11.628524669999999</c:v>
                </c:pt>
                <c:pt idx="63">
                  <c:v>10.9684515</c:v>
                </c:pt>
                <c:pt idx="64">
                  <c:v>9.906762252</c:v>
                </c:pt>
                <c:pt idx="65">
                  <c:v>13.149525580000001</c:v>
                </c:pt>
                <c:pt idx="66">
                  <c:v>10.30622556</c:v>
                </c:pt>
                <c:pt idx="67">
                  <c:v>8.7947638690000005</c:v>
                </c:pt>
                <c:pt idx="68">
                  <c:v>12.062914320000001</c:v>
                </c:pt>
                <c:pt idx="69">
                  <c:v>10.463341079999999</c:v>
                </c:pt>
                <c:pt idx="70">
                  <c:v>14.298528279999999</c:v>
                </c:pt>
                <c:pt idx="71">
                  <c:v>9.5730352609999994</c:v>
                </c:pt>
                <c:pt idx="72">
                  <c:v>12.783326990000001</c:v>
                </c:pt>
                <c:pt idx="73">
                  <c:v>12.246702170000001</c:v>
                </c:pt>
                <c:pt idx="74">
                  <c:v>9.8184804470000007</c:v>
                </c:pt>
                <c:pt idx="75">
                  <c:v>11.740371740000001</c:v>
                </c:pt>
                <c:pt idx="76">
                  <c:v>10.047336899999999</c:v>
                </c:pt>
                <c:pt idx="77">
                  <c:v>10.64002268</c:v>
                </c:pt>
                <c:pt idx="78">
                  <c:v>12.279840780000001</c:v>
                </c:pt>
                <c:pt idx="79">
                  <c:v>12.04419204</c:v>
                </c:pt>
                <c:pt idx="80">
                  <c:v>13.29778217</c:v>
                </c:pt>
                <c:pt idx="81">
                  <c:v>10.20815657</c:v>
                </c:pt>
                <c:pt idx="82">
                  <c:v>8.8188217630000008</c:v>
                </c:pt>
                <c:pt idx="83">
                  <c:v>13.81619759</c:v>
                </c:pt>
                <c:pt idx="84">
                  <c:v>11.579533830000001</c:v>
                </c:pt>
                <c:pt idx="85">
                  <c:v>12.546473130000001</c:v>
                </c:pt>
                <c:pt idx="86">
                  <c:v>13.59995793</c:v>
                </c:pt>
                <c:pt idx="87">
                  <c:v>12.89354855</c:v>
                </c:pt>
                <c:pt idx="88">
                  <c:v>10.875782429999999</c:v>
                </c:pt>
                <c:pt idx="89">
                  <c:v>13.53578914</c:v>
                </c:pt>
                <c:pt idx="90">
                  <c:v>9.0330645040000004</c:v>
                </c:pt>
                <c:pt idx="91">
                  <c:v>9.2452232379999995</c:v>
                </c:pt>
                <c:pt idx="92">
                  <c:v>9.2604894580000003</c:v>
                </c:pt>
                <c:pt idx="93">
                  <c:v>9.9070771519999994</c:v>
                </c:pt>
                <c:pt idx="94">
                  <c:v>8.521000634</c:v>
                </c:pt>
                <c:pt idx="95">
                  <c:v>8.4581842149999993</c:v>
                </c:pt>
                <c:pt idx="96">
                  <c:v>9.4746934409999994</c:v>
                </c:pt>
                <c:pt idx="97">
                  <c:v>9.8537901229999996</c:v>
                </c:pt>
                <c:pt idx="98">
                  <c:v>9.0151419330000007</c:v>
                </c:pt>
                <c:pt idx="99">
                  <c:v>9.5186147420000005</c:v>
                </c:pt>
                <c:pt idx="100">
                  <c:v>6.7153747399999997</c:v>
                </c:pt>
                <c:pt idx="101">
                  <c:v>7.3983567470000002</c:v>
                </c:pt>
                <c:pt idx="102">
                  <c:v>6.8419123949999996</c:v>
                </c:pt>
                <c:pt idx="103">
                  <c:v>9.1059359400000002</c:v>
                </c:pt>
                <c:pt idx="104">
                  <c:v>11.41001146</c:v>
                </c:pt>
                <c:pt idx="105">
                  <c:v>11.96716417</c:v>
                </c:pt>
                <c:pt idx="106">
                  <c:v>9.6308498020000002</c:v>
                </c:pt>
                <c:pt idx="107">
                  <c:v>10.02052555</c:v>
                </c:pt>
                <c:pt idx="108">
                  <c:v>7.7943884399999996</c:v>
                </c:pt>
                <c:pt idx="109">
                  <c:v>9.2745528559999997</c:v>
                </c:pt>
                <c:pt idx="110">
                  <c:v>7.6357183449999999</c:v>
                </c:pt>
                <c:pt idx="111">
                  <c:v>4.6151159770000003</c:v>
                </c:pt>
                <c:pt idx="112">
                  <c:v>11.245972699999999</c:v>
                </c:pt>
                <c:pt idx="113">
                  <c:v>3.6535841269999998</c:v>
                </c:pt>
                <c:pt idx="114">
                  <c:v>11.492176430000001</c:v>
                </c:pt>
                <c:pt idx="115">
                  <c:v>9.1778097340000002</c:v>
                </c:pt>
                <c:pt idx="116">
                  <c:v>7.6784977359999997</c:v>
                </c:pt>
                <c:pt idx="117">
                  <c:v>8.7513392959999994</c:v>
                </c:pt>
                <c:pt idx="118">
                  <c:v>8.2399293710000006</c:v>
                </c:pt>
                <c:pt idx="119">
                  <c:v>7.8421158889999996</c:v>
                </c:pt>
                <c:pt idx="120">
                  <c:v>9.320875354</c:v>
                </c:pt>
                <c:pt idx="121">
                  <c:v>9.5174813070000006</c:v>
                </c:pt>
                <c:pt idx="122">
                  <c:v>9.9499931939999993</c:v>
                </c:pt>
                <c:pt idx="123">
                  <c:v>9.7179215879999994</c:v>
                </c:pt>
                <c:pt idx="124">
                  <c:v>9.3960813759999997</c:v>
                </c:pt>
                <c:pt idx="125">
                  <c:v>9.9017408870000008</c:v>
                </c:pt>
                <c:pt idx="126">
                  <c:v>8.9861219460000008</c:v>
                </c:pt>
                <c:pt idx="127">
                  <c:v>9.4770085739999992</c:v>
                </c:pt>
                <c:pt idx="128">
                  <c:v>8.7636199809999997</c:v>
                </c:pt>
                <c:pt idx="129">
                  <c:v>10.03357658</c:v>
                </c:pt>
                <c:pt idx="130">
                  <c:v>8.0073399260000002</c:v>
                </c:pt>
                <c:pt idx="131">
                  <c:v>9.3717993340000003</c:v>
                </c:pt>
                <c:pt idx="132">
                  <c:v>10.24437818</c:v>
                </c:pt>
                <c:pt idx="133">
                  <c:v>7.324374079</c:v>
                </c:pt>
                <c:pt idx="134">
                  <c:v>9.0150677829999992</c:v>
                </c:pt>
                <c:pt idx="135">
                  <c:v>9.5703522779999997</c:v>
                </c:pt>
                <c:pt idx="136">
                  <c:v>9.6221092049999992</c:v>
                </c:pt>
                <c:pt idx="137">
                  <c:v>9.2542914399999994</c:v>
                </c:pt>
                <c:pt idx="138">
                  <c:v>10.18147076</c:v>
                </c:pt>
                <c:pt idx="139">
                  <c:v>11.470322899999999</c:v>
                </c:pt>
                <c:pt idx="140">
                  <c:v>10.304745670000001</c:v>
                </c:pt>
                <c:pt idx="141">
                  <c:v>9.1870411440000002</c:v>
                </c:pt>
                <c:pt idx="142">
                  <c:v>10.838005920000001</c:v>
                </c:pt>
                <c:pt idx="143">
                  <c:v>7.0548333789999997</c:v>
                </c:pt>
                <c:pt idx="144">
                  <c:v>12.92020327</c:v>
                </c:pt>
                <c:pt idx="145">
                  <c:v>9.9930027389999996</c:v>
                </c:pt>
                <c:pt idx="146">
                  <c:v>10.82369712</c:v>
                </c:pt>
                <c:pt idx="147">
                  <c:v>9.0384907709999993</c:v>
                </c:pt>
                <c:pt idx="148">
                  <c:v>8.7879346379999994</c:v>
                </c:pt>
                <c:pt idx="149">
                  <c:v>10.254375550000001</c:v>
                </c:pt>
                <c:pt idx="150">
                  <c:v>3.0057328980000002</c:v>
                </c:pt>
                <c:pt idx="151">
                  <c:v>13.422421290000001</c:v>
                </c:pt>
                <c:pt idx="152">
                  <c:v>8.7994767770000006</c:v>
                </c:pt>
                <c:pt idx="153">
                  <c:v>13.874650340000001</c:v>
                </c:pt>
                <c:pt idx="154">
                  <c:v>8.6742953909999994</c:v>
                </c:pt>
                <c:pt idx="155">
                  <c:v>8.7303543579999996</c:v>
                </c:pt>
                <c:pt idx="156">
                  <c:v>9.0835642389999993</c:v>
                </c:pt>
                <c:pt idx="157">
                  <c:v>12.383625990000001</c:v>
                </c:pt>
                <c:pt idx="158">
                  <c:v>8.5247452490000004</c:v>
                </c:pt>
                <c:pt idx="159">
                  <c:v>5.8660914980000003</c:v>
                </c:pt>
                <c:pt idx="160">
                  <c:v>11.50230284</c:v>
                </c:pt>
                <c:pt idx="161">
                  <c:v>10.405437040000001</c:v>
                </c:pt>
                <c:pt idx="162">
                  <c:v>10.121867590000001</c:v>
                </c:pt>
                <c:pt idx="163">
                  <c:v>8.7648517049999999</c:v>
                </c:pt>
                <c:pt idx="164">
                  <c:v>9.7256319449999999</c:v>
                </c:pt>
                <c:pt idx="165">
                  <c:v>8.5222880659999998</c:v>
                </c:pt>
                <c:pt idx="166">
                  <c:v>14.14588307</c:v>
                </c:pt>
                <c:pt idx="167">
                  <c:v>8.9349455259999999</c:v>
                </c:pt>
                <c:pt idx="168">
                  <c:v>11.89505561</c:v>
                </c:pt>
                <c:pt idx="169">
                  <c:v>7.5699177259999999</c:v>
                </c:pt>
                <c:pt idx="170">
                  <c:v>15.1767082</c:v>
                </c:pt>
                <c:pt idx="171">
                  <c:v>13.382433669999999</c:v>
                </c:pt>
                <c:pt idx="172">
                  <c:v>9.2357632029999994</c:v>
                </c:pt>
                <c:pt idx="173">
                  <c:v>14.314837259999999</c:v>
                </c:pt>
                <c:pt idx="174">
                  <c:v>8.9836593419999993</c:v>
                </c:pt>
                <c:pt idx="175">
                  <c:v>13.73097211</c:v>
                </c:pt>
                <c:pt idx="176">
                  <c:v>8.6599420560000002</c:v>
                </c:pt>
                <c:pt idx="177">
                  <c:v>9.8327566110000006</c:v>
                </c:pt>
                <c:pt idx="178">
                  <c:v>9.9776251029999994</c:v>
                </c:pt>
                <c:pt idx="179">
                  <c:v>9.3359428690000001</c:v>
                </c:pt>
                <c:pt idx="180">
                  <c:v>12.987317770000001</c:v>
                </c:pt>
                <c:pt idx="181">
                  <c:v>0</c:v>
                </c:pt>
                <c:pt idx="182">
                  <c:v>15.15021438</c:v>
                </c:pt>
                <c:pt idx="183">
                  <c:v>11.2064789</c:v>
                </c:pt>
                <c:pt idx="184">
                  <c:v>12.4402782</c:v>
                </c:pt>
                <c:pt idx="185">
                  <c:v>10.823246210000001</c:v>
                </c:pt>
                <c:pt idx="186">
                  <c:v>13.83920966</c:v>
                </c:pt>
                <c:pt idx="187">
                  <c:v>13.49463211</c:v>
                </c:pt>
                <c:pt idx="188">
                  <c:v>16.087255899999999</c:v>
                </c:pt>
                <c:pt idx="189">
                  <c:v>8.5814796829999995</c:v>
                </c:pt>
                <c:pt idx="190">
                  <c:v>11.66762662</c:v>
                </c:pt>
                <c:pt idx="191">
                  <c:v>13.951573939999999</c:v>
                </c:pt>
                <c:pt idx="192">
                  <c:v>12.05683786</c:v>
                </c:pt>
                <c:pt idx="193">
                  <c:v>10.6800382</c:v>
                </c:pt>
                <c:pt idx="194">
                  <c:v>9.1448827070000007</c:v>
                </c:pt>
                <c:pt idx="195">
                  <c:v>9.2675851429999998</c:v>
                </c:pt>
                <c:pt idx="196">
                  <c:v>11.01545707</c:v>
                </c:pt>
                <c:pt idx="197">
                  <c:v>7.9953558180000002</c:v>
                </c:pt>
                <c:pt idx="198">
                  <c:v>8.8651370939999996</c:v>
                </c:pt>
                <c:pt idx="199">
                  <c:v>9.6499371390000004</c:v>
                </c:pt>
                <c:pt idx="200">
                  <c:v>8.224094333</c:v>
                </c:pt>
                <c:pt idx="201">
                  <c:v>9.4934328420000007</c:v>
                </c:pt>
                <c:pt idx="202">
                  <c:v>8.2568802899999998</c:v>
                </c:pt>
                <c:pt idx="203">
                  <c:v>13.49369866</c:v>
                </c:pt>
                <c:pt idx="204">
                  <c:v>9.6881992550000007</c:v>
                </c:pt>
                <c:pt idx="205">
                  <c:v>8.994670352</c:v>
                </c:pt>
                <c:pt idx="206">
                  <c:v>10.693199890000001</c:v>
                </c:pt>
                <c:pt idx="207">
                  <c:v>8.7137384359999999</c:v>
                </c:pt>
                <c:pt idx="208">
                  <c:v>11.452228180000001</c:v>
                </c:pt>
                <c:pt idx="209">
                  <c:v>11.5651113</c:v>
                </c:pt>
                <c:pt idx="210">
                  <c:v>9.1383961320000004</c:v>
                </c:pt>
                <c:pt idx="211">
                  <c:v>8.8386195910000005</c:v>
                </c:pt>
                <c:pt idx="212">
                  <c:v>9.3409282499999993</c:v>
                </c:pt>
                <c:pt idx="213">
                  <c:v>9.7540076550000006</c:v>
                </c:pt>
                <c:pt idx="214">
                  <c:v>12.059088170000001</c:v>
                </c:pt>
                <c:pt idx="215">
                  <c:v>9.2657596410000007</c:v>
                </c:pt>
                <c:pt idx="216">
                  <c:v>13.055139499999999</c:v>
                </c:pt>
                <c:pt idx="217">
                  <c:v>11.97987575</c:v>
                </c:pt>
                <c:pt idx="218">
                  <c:v>10.76630201</c:v>
                </c:pt>
                <c:pt idx="219">
                  <c:v>9.3522181389999997</c:v>
                </c:pt>
                <c:pt idx="220">
                  <c:v>11.331466949999999</c:v>
                </c:pt>
                <c:pt idx="221">
                  <c:v>8.9663466290000002</c:v>
                </c:pt>
                <c:pt idx="222">
                  <c:v>8.8485732939999995</c:v>
                </c:pt>
                <c:pt idx="223">
                  <c:v>9.2245337559999996</c:v>
                </c:pt>
                <c:pt idx="224">
                  <c:v>8.7657777419999992</c:v>
                </c:pt>
                <c:pt idx="225">
                  <c:v>9.3253948900000001</c:v>
                </c:pt>
                <c:pt idx="226">
                  <c:v>8.8393793630000008</c:v>
                </c:pt>
                <c:pt idx="227">
                  <c:v>11.31452889</c:v>
                </c:pt>
                <c:pt idx="228">
                  <c:v>9.4367379079999996</c:v>
                </c:pt>
                <c:pt idx="229">
                  <c:v>9.6909964290000001</c:v>
                </c:pt>
                <c:pt idx="230">
                  <c:v>10.079952349999999</c:v>
                </c:pt>
                <c:pt idx="231">
                  <c:v>11.17803099</c:v>
                </c:pt>
                <c:pt idx="232">
                  <c:v>11.443634749999999</c:v>
                </c:pt>
                <c:pt idx="233">
                  <c:v>9.5549889750000006</c:v>
                </c:pt>
                <c:pt idx="234">
                  <c:v>8.9306590610000001</c:v>
                </c:pt>
                <c:pt idx="235">
                  <c:v>8.3854919599999995</c:v>
                </c:pt>
                <c:pt idx="236">
                  <c:v>9.0432355609999995</c:v>
                </c:pt>
                <c:pt idx="237">
                  <c:v>8.6321694400000002</c:v>
                </c:pt>
                <c:pt idx="238">
                  <c:v>8.5734262290000007</c:v>
                </c:pt>
                <c:pt idx="239">
                  <c:v>10.929428059999999</c:v>
                </c:pt>
                <c:pt idx="240">
                  <c:v>11.44340375</c:v>
                </c:pt>
              </c:numCache>
            </c:numRef>
          </c:val>
        </c:ser>
        <c:ser>
          <c:idx val="1"/>
          <c:order val="1"/>
          <c:tx>
            <c:strRef>
              <c:f>Sheet1!$E$1</c:f>
              <c:strCache>
                <c:ptCount val="1"/>
                <c:pt idx="0">
                  <c:v>HPAT15</c:v>
                </c:pt>
              </c:strCache>
            </c:strRef>
          </c:tx>
          <c:spPr>
            <a:solidFill>
              <a:srgbClr val="FF0000"/>
            </a:solidFill>
            <a:ln>
              <a:noFill/>
            </a:ln>
            <a:effectLst/>
          </c:spPr>
          <c:cat>
            <c:strRef>
              <c:f>Sheet1!$C$2:$C$242</c:f>
              <c:strCache>
                <c:ptCount val="241"/>
                <c:pt idx="0">
                  <c:v>early</c:v>
                </c:pt>
                <c:pt idx="1">
                  <c:v>early</c:v>
                </c:pt>
                <c:pt idx="2">
                  <c:v>early</c:v>
                </c:pt>
                <c:pt idx="3">
                  <c:v>early</c:v>
                </c:pt>
                <c:pt idx="4">
                  <c:v>early</c:v>
                </c:pt>
                <c:pt idx="5">
                  <c:v>early</c:v>
                </c:pt>
                <c:pt idx="6">
                  <c:v>early</c:v>
                </c:pt>
                <c:pt idx="7">
                  <c:v>early</c:v>
                </c:pt>
                <c:pt idx="8">
                  <c:v>early</c:v>
                </c:pt>
                <c:pt idx="9">
                  <c:v>early</c:v>
                </c:pt>
                <c:pt idx="10">
                  <c:v>early</c:v>
                </c:pt>
                <c:pt idx="11">
                  <c:v>early</c:v>
                </c:pt>
                <c:pt idx="12">
                  <c:v>early</c:v>
                </c:pt>
                <c:pt idx="13">
                  <c:v>early</c:v>
                </c:pt>
                <c:pt idx="14">
                  <c:v>early</c:v>
                </c:pt>
                <c:pt idx="15">
                  <c:v>early</c:v>
                </c:pt>
                <c:pt idx="16">
                  <c:v>early</c:v>
                </c:pt>
                <c:pt idx="17">
                  <c:v>early</c:v>
                </c:pt>
                <c:pt idx="18">
                  <c:v>early</c:v>
                </c:pt>
                <c:pt idx="19">
                  <c:v>early</c:v>
                </c:pt>
                <c:pt idx="20">
                  <c:v>early</c:v>
                </c:pt>
                <c:pt idx="21">
                  <c:v>early</c:v>
                </c:pt>
                <c:pt idx="22">
                  <c:v>early</c:v>
                </c:pt>
                <c:pt idx="23">
                  <c:v>early</c:v>
                </c:pt>
                <c:pt idx="24">
                  <c:v>early</c:v>
                </c:pt>
                <c:pt idx="25">
                  <c:v>early</c:v>
                </c:pt>
                <c:pt idx="26">
                  <c:v>early</c:v>
                </c:pt>
                <c:pt idx="27">
                  <c:v>early</c:v>
                </c:pt>
                <c:pt idx="28">
                  <c:v>early</c:v>
                </c:pt>
                <c:pt idx="29">
                  <c:v>early</c:v>
                </c:pt>
                <c:pt idx="30">
                  <c:v>early</c:v>
                </c:pt>
                <c:pt idx="31">
                  <c:v>early</c:v>
                </c:pt>
                <c:pt idx="32">
                  <c:v>early</c:v>
                </c:pt>
                <c:pt idx="33">
                  <c:v>late</c:v>
                </c:pt>
                <c:pt idx="34">
                  <c:v>late</c:v>
                </c:pt>
                <c:pt idx="35">
                  <c:v>late</c:v>
                </c:pt>
                <c:pt idx="36">
                  <c:v>late</c:v>
                </c:pt>
                <c:pt idx="37">
                  <c:v>late</c:v>
                </c:pt>
                <c:pt idx="38">
                  <c:v>late</c:v>
                </c:pt>
                <c:pt idx="39">
                  <c:v>late</c:v>
                </c:pt>
                <c:pt idx="40">
                  <c:v>late</c:v>
                </c:pt>
                <c:pt idx="41">
                  <c:v>late</c:v>
                </c:pt>
                <c:pt idx="42">
                  <c:v>late</c:v>
                </c:pt>
                <c:pt idx="43">
                  <c:v>late</c:v>
                </c:pt>
                <c:pt idx="44">
                  <c:v>late</c:v>
                </c:pt>
                <c:pt idx="45">
                  <c:v>late</c:v>
                </c:pt>
                <c:pt idx="46">
                  <c:v>late</c:v>
                </c:pt>
                <c:pt idx="47">
                  <c:v>late</c:v>
                </c:pt>
                <c:pt idx="48">
                  <c:v>late</c:v>
                </c:pt>
                <c:pt idx="49">
                  <c:v>late</c:v>
                </c:pt>
                <c:pt idx="50">
                  <c:v>late</c:v>
                </c:pt>
                <c:pt idx="51">
                  <c:v>late</c:v>
                </c:pt>
                <c:pt idx="52">
                  <c:v>late</c:v>
                </c:pt>
                <c:pt idx="53">
                  <c:v>late</c:v>
                </c:pt>
                <c:pt idx="54">
                  <c:v>late</c:v>
                </c:pt>
                <c:pt idx="55">
                  <c:v>late</c:v>
                </c:pt>
                <c:pt idx="56">
                  <c:v>late</c:v>
                </c:pt>
                <c:pt idx="57">
                  <c:v>late</c:v>
                </c:pt>
                <c:pt idx="58">
                  <c:v>late</c:v>
                </c:pt>
                <c:pt idx="59">
                  <c:v>late</c:v>
                </c:pt>
                <c:pt idx="60">
                  <c:v>late</c:v>
                </c:pt>
                <c:pt idx="61">
                  <c:v>late</c:v>
                </c:pt>
                <c:pt idx="62">
                  <c:v>late</c:v>
                </c:pt>
                <c:pt idx="63">
                  <c:v>late</c:v>
                </c:pt>
                <c:pt idx="64">
                  <c:v>late</c:v>
                </c:pt>
                <c:pt idx="65">
                  <c:v>late</c:v>
                </c:pt>
                <c:pt idx="66">
                  <c:v>late</c:v>
                </c:pt>
                <c:pt idx="67">
                  <c:v>late</c:v>
                </c:pt>
                <c:pt idx="68">
                  <c:v>late</c:v>
                </c:pt>
                <c:pt idx="69">
                  <c:v>late</c:v>
                </c:pt>
                <c:pt idx="70">
                  <c:v>late</c:v>
                </c:pt>
                <c:pt idx="71">
                  <c:v>late</c:v>
                </c:pt>
                <c:pt idx="72">
                  <c:v>late</c:v>
                </c:pt>
                <c:pt idx="73">
                  <c:v>late</c:v>
                </c:pt>
                <c:pt idx="74">
                  <c:v>late</c:v>
                </c:pt>
                <c:pt idx="75">
                  <c:v>late</c:v>
                </c:pt>
                <c:pt idx="76">
                  <c:v>late</c:v>
                </c:pt>
                <c:pt idx="77">
                  <c:v>late</c:v>
                </c:pt>
                <c:pt idx="78">
                  <c:v>late</c:v>
                </c:pt>
                <c:pt idx="79">
                  <c:v>late</c:v>
                </c:pt>
                <c:pt idx="80">
                  <c:v>late</c:v>
                </c:pt>
                <c:pt idx="81">
                  <c:v>late</c:v>
                </c:pt>
                <c:pt idx="82">
                  <c:v>late</c:v>
                </c:pt>
                <c:pt idx="83">
                  <c:v>late</c:v>
                </c:pt>
                <c:pt idx="84">
                  <c:v>late</c:v>
                </c:pt>
                <c:pt idx="85">
                  <c:v>late</c:v>
                </c:pt>
                <c:pt idx="86">
                  <c:v>late</c:v>
                </c:pt>
                <c:pt idx="87">
                  <c:v>late</c:v>
                </c:pt>
                <c:pt idx="88">
                  <c:v>late</c:v>
                </c:pt>
                <c:pt idx="89">
                  <c:v>late</c:v>
                </c:pt>
                <c:pt idx="90">
                  <c:v>early</c:v>
                </c:pt>
                <c:pt idx="91">
                  <c:v>early</c:v>
                </c:pt>
                <c:pt idx="92">
                  <c:v>early</c:v>
                </c:pt>
                <c:pt idx="93">
                  <c:v>early</c:v>
                </c:pt>
                <c:pt idx="94">
                  <c:v>late</c:v>
                </c:pt>
                <c:pt idx="95">
                  <c:v>late</c:v>
                </c:pt>
                <c:pt idx="96">
                  <c:v>late</c:v>
                </c:pt>
                <c:pt idx="97">
                  <c:v>late</c:v>
                </c:pt>
                <c:pt idx="98">
                  <c:v>late</c:v>
                </c:pt>
                <c:pt idx="99">
                  <c:v>late</c:v>
                </c:pt>
                <c:pt idx="100">
                  <c:v>late</c:v>
                </c:pt>
                <c:pt idx="101">
                  <c:v>late</c:v>
                </c:pt>
                <c:pt idx="102">
                  <c:v>late</c:v>
                </c:pt>
                <c:pt idx="103">
                  <c:v>late</c:v>
                </c:pt>
                <c:pt idx="104">
                  <c:v>late</c:v>
                </c:pt>
                <c:pt idx="105">
                  <c:v>late</c:v>
                </c:pt>
                <c:pt idx="106">
                  <c:v>late</c:v>
                </c:pt>
                <c:pt idx="107">
                  <c:v>late</c:v>
                </c:pt>
                <c:pt idx="108">
                  <c:v>late</c:v>
                </c:pt>
                <c:pt idx="109">
                  <c:v>late</c:v>
                </c:pt>
                <c:pt idx="110">
                  <c:v>late</c:v>
                </c:pt>
                <c:pt idx="111">
                  <c:v>late</c:v>
                </c:pt>
                <c:pt idx="112">
                  <c:v>late</c:v>
                </c:pt>
                <c:pt idx="113">
                  <c:v>late</c:v>
                </c:pt>
                <c:pt idx="114">
                  <c:v>late</c:v>
                </c:pt>
                <c:pt idx="115">
                  <c:v>early</c:v>
                </c:pt>
                <c:pt idx="116">
                  <c:v>early</c:v>
                </c:pt>
                <c:pt idx="117">
                  <c:v>early</c:v>
                </c:pt>
                <c:pt idx="118">
                  <c:v>early</c:v>
                </c:pt>
                <c:pt idx="119">
                  <c:v>early</c:v>
                </c:pt>
                <c:pt idx="120">
                  <c:v>early</c:v>
                </c:pt>
                <c:pt idx="121">
                  <c:v>early</c:v>
                </c:pt>
                <c:pt idx="122">
                  <c:v>early</c:v>
                </c:pt>
                <c:pt idx="123">
                  <c:v>early</c:v>
                </c:pt>
                <c:pt idx="124">
                  <c:v>early</c:v>
                </c:pt>
                <c:pt idx="125">
                  <c:v>early</c:v>
                </c:pt>
                <c:pt idx="126">
                  <c:v>early</c:v>
                </c:pt>
                <c:pt idx="127">
                  <c:v>early</c:v>
                </c:pt>
                <c:pt idx="128">
                  <c:v>early</c:v>
                </c:pt>
                <c:pt idx="129">
                  <c:v>early</c:v>
                </c:pt>
                <c:pt idx="130">
                  <c:v>early</c:v>
                </c:pt>
                <c:pt idx="131">
                  <c:v>early</c:v>
                </c:pt>
                <c:pt idx="132">
                  <c:v>late</c:v>
                </c:pt>
                <c:pt idx="133">
                  <c:v>late</c:v>
                </c:pt>
                <c:pt idx="134">
                  <c:v>late</c:v>
                </c:pt>
                <c:pt idx="135">
                  <c:v>late</c:v>
                </c:pt>
                <c:pt idx="136">
                  <c:v>late</c:v>
                </c:pt>
                <c:pt idx="137">
                  <c:v>late</c:v>
                </c:pt>
                <c:pt idx="138">
                  <c:v>late</c:v>
                </c:pt>
                <c:pt idx="139">
                  <c:v>late</c:v>
                </c:pt>
                <c:pt idx="140">
                  <c:v>late</c:v>
                </c:pt>
                <c:pt idx="141">
                  <c:v>late</c:v>
                </c:pt>
                <c:pt idx="142">
                  <c:v>late</c:v>
                </c:pt>
                <c:pt idx="143">
                  <c:v>late</c:v>
                </c:pt>
                <c:pt idx="144">
                  <c:v>late</c:v>
                </c:pt>
                <c:pt idx="145">
                  <c:v>late</c:v>
                </c:pt>
                <c:pt idx="146">
                  <c:v>late</c:v>
                </c:pt>
                <c:pt idx="147">
                  <c:v>late</c:v>
                </c:pt>
                <c:pt idx="148">
                  <c:v>early</c:v>
                </c:pt>
                <c:pt idx="149">
                  <c:v>early</c:v>
                </c:pt>
                <c:pt idx="150">
                  <c:v>early</c:v>
                </c:pt>
                <c:pt idx="151">
                  <c:v>early</c:v>
                </c:pt>
                <c:pt idx="152">
                  <c:v>early</c:v>
                </c:pt>
                <c:pt idx="153">
                  <c:v>early</c:v>
                </c:pt>
                <c:pt idx="154">
                  <c:v>early</c:v>
                </c:pt>
                <c:pt idx="155">
                  <c:v>early</c:v>
                </c:pt>
                <c:pt idx="156">
                  <c:v>early</c:v>
                </c:pt>
                <c:pt idx="157">
                  <c:v>early</c:v>
                </c:pt>
                <c:pt idx="158">
                  <c:v>early</c:v>
                </c:pt>
                <c:pt idx="159">
                  <c:v>early</c:v>
                </c:pt>
                <c:pt idx="160">
                  <c:v>early</c:v>
                </c:pt>
                <c:pt idx="161">
                  <c:v>early</c:v>
                </c:pt>
                <c:pt idx="162">
                  <c:v>early</c:v>
                </c:pt>
                <c:pt idx="163">
                  <c:v>early</c:v>
                </c:pt>
                <c:pt idx="164">
                  <c:v>early</c:v>
                </c:pt>
                <c:pt idx="165">
                  <c:v>early</c:v>
                </c:pt>
                <c:pt idx="166">
                  <c:v>early</c:v>
                </c:pt>
                <c:pt idx="167">
                  <c:v>early</c:v>
                </c:pt>
                <c:pt idx="168">
                  <c:v>early</c:v>
                </c:pt>
                <c:pt idx="169">
                  <c:v>early</c:v>
                </c:pt>
                <c:pt idx="170">
                  <c:v>early</c:v>
                </c:pt>
                <c:pt idx="171">
                  <c:v>early</c:v>
                </c:pt>
                <c:pt idx="172">
                  <c:v>early</c:v>
                </c:pt>
                <c:pt idx="173">
                  <c:v>early</c:v>
                </c:pt>
                <c:pt idx="174">
                  <c:v>early</c:v>
                </c:pt>
                <c:pt idx="175">
                  <c:v>early</c:v>
                </c:pt>
                <c:pt idx="176">
                  <c:v>early</c:v>
                </c:pt>
                <c:pt idx="177">
                  <c:v>early</c:v>
                </c:pt>
                <c:pt idx="178">
                  <c:v>early</c:v>
                </c:pt>
                <c:pt idx="179">
                  <c:v>early</c:v>
                </c:pt>
                <c:pt idx="180">
                  <c:v>early</c:v>
                </c:pt>
                <c:pt idx="181">
                  <c:v>early</c:v>
                </c:pt>
                <c:pt idx="182">
                  <c:v>late</c:v>
                </c:pt>
                <c:pt idx="183">
                  <c:v>late</c:v>
                </c:pt>
                <c:pt idx="184">
                  <c:v>late</c:v>
                </c:pt>
                <c:pt idx="185">
                  <c:v>late</c:v>
                </c:pt>
                <c:pt idx="186">
                  <c:v>late</c:v>
                </c:pt>
                <c:pt idx="187">
                  <c:v>late</c:v>
                </c:pt>
                <c:pt idx="188">
                  <c:v>late</c:v>
                </c:pt>
                <c:pt idx="189">
                  <c:v>late</c:v>
                </c:pt>
                <c:pt idx="190">
                  <c:v>late</c:v>
                </c:pt>
                <c:pt idx="191">
                  <c:v>late</c:v>
                </c:pt>
                <c:pt idx="192">
                  <c:v>late</c:v>
                </c:pt>
                <c:pt idx="193">
                  <c:v>late</c:v>
                </c:pt>
                <c:pt idx="194">
                  <c:v>late</c:v>
                </c:pt>
                <c:pt idx="195">
                  <c:v>late</c:v>
                </c:pt>
                <c:pt idx="196">
                  <c:v>late</c:v>
                </c:pt>
                <c:pt idx="197">
                  <c:v>late</c:v>
                </c:pt>
                <c:pt idx="198">
                  <c:v>late</c:v>
                </c:pt>
                <c:pt idx="199">
                  <c:v>late</c:v>
                </c:pt>
                <c:pt idx="200">
                  <c:v>late</c:v>
                </c:pt>
                <c:pt idx="201">
                  <c:v>late</c:v>
                </c:pt>
                <c:pt idx="202">
                  <c:v>late</c:v>
                </c:pt>
                <c:pt idx="203">
                  <c:v>late</c:v>
                </c:pt>
                <c:pt idx="204">
                  <c:v>late</c:v>
                </c:pt>
                <c:pt idx="205">
                  <c:v>late</c:v>
                </c:pt>
                <c:pt idx="206">
                  <c:v>late</c:v>
                </c:pt>
                <c:pt idx="207">
                  <c:v>late</c:v>
                </c:pt>
                <c:pt idx="208">
                  <c:v>late</c:v>
                </c:pt>
                <c:pt idx="209">
                  <c:v>late</c:v>
                </c:pt>
                <c:pt idx="210">
                  <c:v>late</c:v>
                </c:pt>
                <c:pt idx="211">
                  <c:v>late</c:v>
                </c:pt>
                <c:pt idx="212">
                  <c:v>late</c:v>
                </c:pt>
                <c:pt idx="213">
                  <c:v>late</c:v>
                </c:pt>
                <c:pt idx="214">
                  <c:v>late</c:v>
                </c:pt>
                <c:pt idx="215">
                  <c:v>late</c:v>
                </c:pt>
                <c:pt idx="216">
                  <c:v>late</c:v>
                </c:pt>
                <c:pt idx="217">
                  <c:v>late</c:v>
                </c:pt>
                <c:pt idx="218">
                  <c:v>late</c:v>
                </c:pt>
                <c:pt idx="219">
                  <c:v>late</c:v>
                </c:pt>
                <c:pt idx="220">
                  <c:v>late</c:v>
                </c:pt>
                <c:pt idx="221">
                  <c:v>late</c:v>
                </c:pt>
                <c:pt idx="222">
                  <c:v>late</c:v>
                </c:pt>
                <c:pt idx="223">
                  <c:v>late</c:v>
                </c:pt>
                <c:pt idx="224">
                  <c:v>late</c:v>
                </c:pt>
                <c:pt idx="225">
                  <c:v>late</c:v>
                </c:pt>
                <c:pt idx="226">
                  <c:v>late</c:v>
                </c:pt>
                <c:pt idx="227">
                  <c:v>late</c:v>
                </c:pt>
                <c:pt idx="228">
                  <c:v>late</c:v>
                </c:pt>
                <c:pt idx="229">
                  <c:v>late</c:v>
                </c:pt>
                <c:pt idx="230">
                  <c:v>late</c:v>
                </c:pt>
                <c:pt idx="231">
                  <c:v>late</c:v>
                </c:pt>
                <c:pt idx="232">
                  <c:v>late</c:v>
                </c:pt>
                <c:pt idx="233">
                  <c:v>late</c:v>
                </c:pt>
                <c:pt idx="234">
                  <c:v>late</c:v>
                </c:pt>
                <c:pt idx="235">
                  <c:v>late</c:v>
                </c:pt>
                <c:pt idx="236">
                  <c:v>late</c:v>
                </c:pt>
                <c:pt idx="237">
                  <c:v>late</c:v>
                </c:pt>
                <c:pt idx="238">
                  <c:v>late</c:v>
                </c:pt>
                <c:pt idx="239">
                  <c:v>late</c:v>
                </c:pt>
                <c:pt idx="240">
                  <c:v>late</c:v>
                </c:pt>
              </c:strCache>
            </c:strRef>
          </c:cat>
          <c:val>
            <c:numRef>
              <c:f>Sheet1!$E$2:$E$242</c:f>
              <c:numCache>
                <c:formatCode>General</c:formatCode>
                <c:ptCount val="241"/>
                <c:pt idx="0">
                  <c:v>6.9996444860000002</c:v>
                </c:pt>
                <c:pt idx="1">
                  <c:v>9.8138476430000008</c:v>
                </c:pt>
                <c:pt idx="2">
                  <c:v>2.3446043009999999</c:v>
                </c:pt>
                <c:pt idx="3">
                  <c:v>3.3524538100000001</c:v>
                </c:pt>
                <c:pt idx="4">
                  <c:v>4.0931578569999996</c:v>
                </c:pt>
                <c:pt idx="5">
                  <c:v>4.4251827239999999</c:v>
                </c:pt>
                <c:pt idx="6">
                  <c:v>8.6669600990000006</c:v>
                </c:pt>
                <c:pt idx="7">
                  <c:v>5.1696126250000001</c:v>
                </c:pt>
                <c:pt idx="8">
                  <c:v>4.320395435</c:v>
                </c:pt>
                <c:pt idx="9">
                  <c:v>3.5046871369999999</c:v>
                </c:pt>
                <c:pt idx="10">
                  <c:v>8.2352069970000006</c:v>
                </c:pt>
                <c:pt idx="11">
                  <c:v>6.9996444860000002</c:v>
                </c:pt>
                <c:pt idx="12">
                  <c:v>6.2256769739999998</c:v>
                </c:pt>
                <c:pt idx="13">
                  <c:v>3.6770208360000001</c:v>
                </c:pt>
                <c:pt idx="14">
                  <c:v>8.7807667550000001</c:v>
                </c:pt>
                <c:pt idx="15">
                  <c:v>7.7136675930000003</c:v>
                </c:pt>
                <c:pt idx="16">
                  <c:v>2.8077451180000002</c:v>
                </c:pt>
                <c:pt idx="17">
                  <c:v>6.9996444860000002</c:v>
                </c:pt>
                <c:pt idx="18">
                  <c:v>4.8747249200000002</c:v>
                </c:pt>
                <c:pt idx="19">
                  <c:v>6.6067635090000003</c:v>
                </c:pt>
                <c:pt idx="20">
                  <c:v>6.0686000870000001</c:v>
                </c:pt>
                <c:pt idx="21">
                  <c:v>3.3608375960000001</c:v>
                </c:pt>
                <c:pt idx="22">
                  <c:v>6.060982836</c:v>
                </c:pt>
                <c:pt idx="23">
                  <c:v>7.1275798229999996</c:v>
                </c:pt>
                <c:pt idx="24">
                  <c:v>6.9996444860000002</c:v>
                </c:pt>
                <c:pt idx="25">
                  <c:v>6.1313241569999999</c:v>
                </c:pt>
                <c:pt idx="26">
                  <c:v>6.8884942010000003</c:v>
                </c:pt>
                <c:pt idx="27">
                  <c:v>1.3207421239999999</c:v>
                </c:pt>
                <c:pt idx="28">
                  <c:v>5.3911759789999998</c:v>
                </c:pt>
                <c:pt idx="29">
                  <c:v>3.3331441979999998</c:v>
                </c:pt>
                <c:pt idx="30">
                  <c:v>3.5046871369999999</c:v>
                </c:pt>
                <c:pt idx="31">
                  <c:v>3.2649024780000002</c:v>
                </c:pt>
                <c:pt idx="32">
                  <c:v>3.771597479</c:v>
                </c:pt>
                <c:pt idx="33">
                  <c:v>2.9409640420000001</c:v>
                </c:pt>
                <c:pt idx="34">
                  <c:v>4.7284095920000002</c:v>
                </c:pt>
                <c:pt idx="35">
                  <c:v>9.4504517640000003</c:v>
                </c:pt>
                <c:pt idx="36">
                  <c:v>3.422435712</c:v>
                </c:pt>
                <c:pt idx="37">
                  <c:v>3.9183800799999999</c:v>
                </c:pt>
                <c:pt idx="38">
                  <c:v>8.2725597010000005</c:v>
                </c:pt>
                <c:pt idx="39">
                  <c:v>1.344515584</c:v>
                </c:pt>
                <c:pt idx="40">
                  <c:v>2.007855905</c:v>
                </c:pt>
                <c:pt idx="41">
                  <c:v>2.7393570770000002</c:v>
                </c:pt>
                <c:pt idx="42">
                  <c:v>6.9653623610000004</c:v>
                </c:pt>
                <c:pt idx="43">
                  <c:v>4.8005998590000001</c:v>
                </c:pt>
                <c:pt idx="44">
                  <c:v>7.0386809750000001</c:v>
                </c:pt>
                <c:pt idx="45">
                  <c:v>7.1907242340000002</c:v>
                </c:pt>
                <c:pt idx="46">
                  <c:v>5.0142994700000001</c:v>
                </c:pt>
                <c:pt idx="47">
                  <c:v>1.637225178</c:v>
                </c:pt>
                <c:pt idx="48">
                  <c:v>1.1192893690000001</c:v>
                </c:pt>
                <c:pt idx="49">
                  <c:v>2.193679317</c:v>
                </c:pt>
                <c:pt idx="50">
                  <c:v>1.7854284570000001</c:v>
                </c:pt>
                <c:pt idx="51">
                  <c:v>5.797896165</c:v>
                </c:pt>
                <c:pt idx="52">
                  <c:v>8.4933353139999994</c:v>
                </c:pt>
                <c:pt idx="53">
                  <c:v>7.9847093869999997</c:v>
                </c:pt>
                <c:pt idx="54">
                  <c:v>3.834658106</c:v>
                </c:pt>
                <c:pt idx="55">
                  <c:v>5.2005610610000002</c:v>
                </c:pt>
                <c:pt idx="56">
                  <c:v>10.75884697</c:v>
                </c:pt>
                <c:pt idx="57">
                  <c:v>7.5783694400000003</c:v>
                </c:pt>
                <c:pt idx="58">
                  <c:v>5.8549002149999998</c:v>
                </c:pt>
                <c:pt idx="59">
                  <c:v>5.0759789639999999</c:v>
                </c:pt>
                <c:pt idx="60">
                  <c:v>3.5754429669999999</c:v>
                </c:pt>
                <c:pt idx="61">
                  <c:v>7.7933786490000001</c:v>
                </c:pt>
                <c:pt idx="62">
                  <c:v>4.1727611180000004</c:v>
                </c:pt>
                <c:pt idx="63">
                  <c:v>6.2491337720000004</c:v>
                </c:pt>
                <c:pt idx="64">
                  <c:v>3.2050296409999999</c:v>
                </c:pt>
                <c:pt idx="65">
                  <c:v>7.7856595080000002</c:v>
                </c:pt>
                <c:pt idx="66">
                  <c:v>5.4374708829999996</c:v>
                </c:pt>
                <c:pt idx="67">
                  <c:v>3.1561638919999999</c:v>
                </c:pt>
                <c:pt idx="68">
                  <c:v>5.6336095909999999</c:v>
                </c:pt>
                <c:pt idx="69">
                  <c:v>4.2018126479999998</c:v>
                </c:pt>
                <c:pt idx="70">
                  <c:v>9.6656174139999997</c:v>
                </c:pt>
                <c:pt idx="71">
                  <c:v>4.325882086</c:v>
                </c:pt>
                <c:pt idx="72">
                  <c:v>0.51203456000000003</c:v>
                </c:pt>
                <c:pt idx="73">
                  <c:v>9.8031656989999991</c:v>
                </c:pt>
                <c:pt idx="74">
                  <c:v>3.7969780219999998</c:v>
                </c:pt>
                <c:pt idx="75">
                  <c:v>6.9996444860000002</c:v>
                </c:pt>
                <c:pt idx="76">
                  <c:v>6.0444262530000001</c:v>
                </c:pt>
                <c:pt idx="77">
                  <c:v>8.2257923890000004</c:v>
                </c:pt>
                <c:pt idx="78">
                  <c:v>7.0318262139999996</c:v>
                </c:pt>
                <c:pt idx="79">
                  <c:v>6.9996444860000002</c:v>
                </c:pt>
                <c:pt idx="80">
                  <c:v>10.436924769999999</c:v>
                </c:pt>
                <c:pt idx="81">
                  <c:v>7.7112409</c:v>
                </c:pt>
                <c:pt idx="82">
                  <c:v>2.9296597539999998</c:v>
                </c:pt>
                <c:pt idx="83">
                  <c:v>3.823960209</c:v>
                </c:pt>
                <c:pt idx="84">
                  <c:v>7.4497463310000001</c:v>
                </c:pt>
                <c:pt idx="85">
                  <c:v>9.2682531949999998</c:v>
                </c:pt>
                <c:pt idx="86">
                  <c:v>7.8066725119999996</c:v>
                </c:pt>
                <c:pt idx="87">
                  <c:v>9.3803932920000008</c:v>
                </c:pt>
                <c:pt idx="88">
                  <c:v>3.0497025290000002</c:v>
                </c:pt>
                <c:pt idx="89">
                  <c:v>10.959319280000001</c:v>
                </c:pt>
                <c:pt idx="90">
                  <c:v>0</c:v>
                </c:pt>
                <c:pt idx="91">
                  <c:v>0</c:v>
                </c:pt>
                <c:pt idx="92">
                  <c:v>0</c:v>
                </c:pt>
                <c:pt idx="93">
                  <c:v>0</c:v>
                </c:pt>
                <c:pt idx="94">
                  <c:v>0</c:v>
                </c:pt>
                <c:pt idx="95">
                  <c:v>0</c:v>
                </c:pt>
                <c:pt idx="96">
                  <c:v>0</c:v>
                </c:pt>
                <c:pt idx="97">
                  <c:v>0</c:v>
                </c:pt>
                <c:pt idx="98">
                  <c:v>0</c:v>
                </c:pt>
                <c:pt idx="99">
                  <c:v>0</c:v>
                </c:pt>
                <c:pt idx="100">
                  <c:v>0</c:v>
                </c:pt>
                <c:pt idx="101">
                  <c:v>0</c:v>
                </c:pt>
                <c:pt idx="102">
                  <c:v>0</c:v>
                </c:pt>
                <c:pt idx="103">
                  <c:v>0</c:v>
                </c:pt>
                <c:pt idx="104">
                  <c:v>0</c:v>
                </c:pt>
                <c:pt idx="105">
                  <c:v>0</c:v>
                </c:pt>
                <c:pt idx="106">
                  <c:v>0</c:v>
                </c:pt>
                <c:pt idx="107">
                  <c:v>0</c:v>
                </c:pt>
                <c:pt idx="108">
                  <c:v>-0.86913137900000004</c:v>
                </c:pt>
                <c:pt idx="109">
                  <c:v>0</c:v>
                </c:pt>
                <c:pt idx="110">
                  <c:v>0</c:v>
                </c:pt>
                <c:pt idx="111">
                  <c:v>0</c:v>
                </c:pt>
                <c:pt idx="112">
                  <c:v>0</c:v>
                </c:pt>
                <c:pt idx="113">
                  <c:v>0</c:v>
                </c:pt>
                <c:pt idx="114">
                  <c:v>0</c:v>
                </c:pt>
                <c:pt idx="115">
                  <c:v>3.1301193719999998</c:v>
                </c:pt>
                <c:pt idx="116">
                  <c:v>1.9104255539999999</c:v>
                </c:pt>
                <c:pt idx="117">
                  <c:v>3.4196427539999998</c:v>
                </c:pt>
                <c:pt idx="118">
                  <c:v>3.1990087890000001</c:v>
                </c:pt>
                <c:pt idx="119">
                  <c:v>3.0444510980000001</c:v>
                </c:pt>
                <c:pt idx="120">
                  <c:v>3.1218248640000001</c:v>
                </c:pt>
                <c:pt idx="121">
                  <c:v>3.989568765</c:v>
                </c:pt>
                <c:pt idx="122">
                  <c:v>3.4023239699999999</c:v>
                </c:pt>
                <c:pt idx="123">
                  <c:v>3.4652172430000001</c:v>
                </c:pt>
                <c:pt idx="124">
                  <c:v>3.4717854739999998</c:v>
                </c:pt>
                <c:pt idx="125">
                  <c:v>3.7239160170000001</c:v>
                </c:pt>
                <c:pt idx="126">
                  <c:v>3.9793282200000002</c:v>
                </c:pt>
                <c:pt idx="127">
                  <c:v>3.6103820990000002</c:v>
                </c:pt>
                <c:pt idx="128">
                  <c:v>4.2079145059999998</c:v>
                </c:pt>
                <c:pt idx="129">
                  <c:v>2.732681683</c:v>
                </c:pt>
                <c:pt idx="130">
                  <c:v>2.3699310539999998</c:v>
                </c:pt>
                <c:pt idx="131">
                  <c:v>5.1189041729999998</c:v>
                </c:pt>
                <c:pt idx="132">
                  <c:v>4.7393300529999998</c:v>
                </c:pt>
                <c:pt idx="133">
                  <c:v>2.9348525520000002</c:v>
                </c:pt>
                <c:pt idx="134">
                  <c:v>3.4990621439999998</c:v>
                </c:pt>
                <c:pt idx="135">
                  <c:v>4.9891736829999997</c:v>
                </c:pt>
                <c:pt idx="136">
                  <c:v>4.8624698879999997</c:v>
                </c:pt>
                <c:pt idx="137">
                  <c:v>3.1173144009999998</c:v>
                </c:pt>
                <c:pt idx="138">
                  <c:v>4.0041280349999999</c:v>
                </c:pt>
                <c:pt idx="139">
                  <c:v>3.4972473530000001</c:v>
                </c:pt>
                <c:pt idx="140">
                  <c:v>4.30859141</c:v>
                </c:pt>
                <c:pt idx="141">
                  <c:v>4.9621315020000001</c:v>
                </c:pt>
                <c:pt idx="142">
                  <c:v>4.0130129840000004</c:v>
                </c:pt>
                <c:pt idx="143">
                  <c:v>0.64840397100000002</c:v>
                </c:pt>
                <c:pt idx="144">
                  <c:v>5.4282189110000001</c:v>
                </c:pt>
                <c:pt idx="145">
                  <c:v>2.9194108820000002</c:v>
                </c:pt>
                <c:pt idx="146">
                  <c:v>7.3789653609999997</c:v>
                </c:pt>
                <c:pt idx="147">
                  <c:v>2.5867741120000001</c:v>
                </c:pt>
                <c:pt idx="148">
                  <c:v>0</c:v>
                </c:pt>
                <c:pt idx="149">
                  <c:v>0</c:v>
                </c:pt>
                <c:pt idx="150">
                  <c:v>0</c:v>
                </c:pt>
                <c:pt idx="151">
                  <c:v>0</c:v>
                </c:pt>
                <c:pt idx="152">
                  <c:v>0</c:v>
                </c:pt>
                <c:pt idx="153">
                  <c:v>0</c:v>
                </c:pt>
                <c:pt idx="154">
                  <c:v>0</c:v>
                </c:pt>
                <c:pt idx="155">
                  <c:v>0</c:v>
                </c:pt>
                <c:pt idx="156">
                  <c:v>0</c:v>
                </c:pt>
                <c:pt idx="157">
                  <c:v>0</c:v>
                </c:pt>
                <c:pt idx="158">
                  <c:v>0</c:v>
                </c:pt>
                <c:pt idx="159">
                  <c:v>0</c:v>
                </c:pt>
                <c:pt idx="160">
                  <c:v>0</c:v>
                </c:pt>
                <c:pt idx="161">
                  <c:v>0</c:v>
                </c:pt>
                <c:pt idx="162">
                  <c:v>0</c:v>
                </c:pt>
                <c:pt idx="163">
                  <c:v>0</c:v>
                </c:pt>
                <c:pt idx="164">
                  <c:v>0</c:v>
                </c:pt>
                <c:pt idx="165">
                  <c:v>0</c:v>
                </c:pt>
                <c:pt idx="166">
                  <c:v>0</c:v>
                </c:pt>
                <c:pt idx="167">
                  <c:v>0</c:v>
                </c:pt>
                <c:pt idx="168">
                  <c:v>0</c:v>
                </c:pt>
                <c:pt idx="169">
                  <c:v>0</c:v>
                </c:pt>
                <c:pt idx="170">
                  <c:v>0</c:v>
                </c:pt>
                <c:pt idx="171">
                  <c:v>0</c:v>
                </c:pt>
                <c:pt idx="172">
                  <c:v>0</c:v>
                </c:pt>
                <c:pt idx="173">
                  <c:v>0</c:v>
                </c:pt>
                <c:pt idx="174">
                  <c:v>0</c:v>
                </c:pt>
                <c:pt idx="175">
                  <c:v>0</c:v>
                </c:pt>
                <c:pt idx="176">
                  <c:v>0</c:v>
                </c:pt>
                <c:pt idx="177">
                  <c:v>0</c:v>
                </c:pt>
                <c:pt idx="178">
                  <c:v>0</c:v>
                </c:pt>
                <c:pt idx="179">
                  <c:v>0</c:v>
                </c:pt>
                <c:pt idx="180">
                  <c:v>0</c:v>
                </c:pt>
                <c:pt idx="181">
                  <c:v>0</c:v>
                </c:pt>
                <c:pt idx="182">
                  <c:v>0</c:v>
                </c:pt>
                <c:pt idx="183">
                  <c:v>0</c:v>
                </c:pt>
                <c:pt idx="184">
                  <c:v>0</c:v>
                </c:pt>
                <c:pt idx="185">
                  <c:v>0</c:v>
                </c:pt>
                <c:pt idx="186">
                  <c:v>0</c:v>
                </c:pt>
                <c:pt idx="187">
                  <c:v>0</c:v>
                </c:pt>
                <c:pt idx="188">
                  <c:v>0</c:v>
                </c:pt>
                <c:pt idx="189">
                  <c:v>0</c:v>
                </c:pt>
                <c:pt idx="190">
                  <c:v>0</c:v>
                </c:pt>
                <c:pt idx="191">
                  <c:v>0</c:v>
                </c:pt>
                <c:pt idx="192">
                  <c:v>0</c:v>
                </c:pt>
                <c:pt idx="193">
                  <c:v>0</c:v>
                </c:pt>
                <c:pt idx="194">
                  <c:v>0</c:v>
                </c:pt>
                <c:pt idx="195">
                  <c:v>0</c:v>
                </c:pt>
                <c:pt idx="196">
                  <c:v>0</c:v>
                </c:pt>
                <c:pt idx="197">
                  <c:v>0</c:v>
                </c:pt>
                <c:pt idx="198">
                  <c:v>0</c:v>
                </c:pt>
                <c:pt idx="199">
                  <c:v>0</c:v>
                </c:pt>
                <c:pt idx="200">
                  <c:v>0</c:v>
                </c:pt>
                <c:pt idx="201">
                  <c:v>0</c:v>
                </c:pt>
                <c:pt idx="202">
                  <c:v>0</c:v>
                </c:pt>
                <c:pt idx="203">
                  <c:v>0</c:v>
                </c:pt>
                <c:pt idx="204">
                  <c:v>0</c:v>
                </c:pt>
                <c:pt idx="205">
                  <c:v>0</c:v>
                </c:pt>
                <c:pt idx="206">
                  <c:v>0</c:v>
                </c:pt>
                <c:pt idx="207">
                  <c:v>0</c:v>
                </c:pt>
                <c:pt idx="208">
                  <c:v>0</c:v>
                </c:pt>
                <c:pt idx="209">
                  <c:v>0</c:v>
                </c:pt>
                <c:pt idx="210">
                  <c:v>0</c:v>
                </c:pt>
                <c:pt idx="211">
                  <c:v>0</c:v>
                </c:pt>
                <c:pt idx="212">
                  <c:v>0</c:v>
                </c:pt>
                <c:pt idx="213">
                  <c:v>0</c:v>
                </c:pt>
                <c:pt idx="214">
                  <c:v>0</c:v>
                </c:pt>
                <c:pt idx="215">
                  <c:v>0</c:v>
                </c:pt>
                <c:pt idx="216">
                  <c:v>0</c:v>
                </c:pt>
                <c:pt idx="217">
                  <c:v>0</c:v>
                </c:pt>
                <c:pt idx="218">
                  <c:v>0</c:v>
                </c:pt>
                <c:pt idx="219">
                  <c:v>0</c:v>
                </c:pt>
                <c:pt idx="220">
                  <c:v>0</c:v>
                </c:pt>
                <c:pt idx="221">
                  <c:v>0</c:v>
                </c:pt>
                <c:pt idx="222">
                  <c:v>0</c:v>
                </c:pt>
                <c:pt idx="223">
                  <c:v>0</c:v>
                </c:pt>
                <c:pt idx="224">
                  <c:v>0</c:v>
                </c:pt>
                <c:pt idx="225">
                  <c:v>0</c:v>
                </c:pt>
                <c:pt idx="226">
                  <c:v>0</c:v>
                </c:pt>
                <c:pt idx="227">
                  <c:v>0</c:v>
                </c:pt>
                <c:pt idx="228">
                  <c:v>0</c:v>
                </c:pt>
                <c:pt idx="229">
                  <c:v>0</c:v>
                </c:pt>
                <c:pt idx="230">
                  <c:v>0</c:v>
                </c:pt>
                <c:pt idx="231">
                  <c:v>0</c:v>
                </c:pt>
                <c:pt idx="232">
                  <c:v>0</c:v>
                </c:pt>
                <c:pt idx="233">
                  <c:v>0</c:v>
                </c:pt>
                <c:pt idx="234">
                  <c:v>0</c:v>
                </c:pt>
                <c:pt idx="235">
                  <c:v>0</c:v>
                </c:pt>
                <c:pt idx="236">
                  <c:v>0</c:v>
                </c:pt>
                <c:pt idx="237">
                  <c:v>0</c:v>
                </c:pt>
                <c:pt idx="238">
                  <c:v>0</c:v>
                </c:pt>
                <c:pt idx="239">
                  <c:v>0</c:v>
                </c:pt>
                <c:pt idx="240">
                  <c:v>0</c:v>
                </c:pt>
              </c:numCache>
            </c:numRef>
          </c:val>
        </c:ser>
        <c:dLbls>
          <c:showLegendKey val="0"/>
          <c:showVal val="0"/>
          <c:showCatName val="0"/>
          <c:showSerName val="0"/>
          <c:showPercent val="0"/>
          <c:showBubbleSize val="0"/>
        </c:dLbls>
        <c:axId val="12985136"/>
        <c:axId val="265273192"/>
      </c:areaChart>
      <c:barChart>
        <c:barDir val="col"/>
        <c:grouping val="clustered"/>
        <c:varyColors val="0"/>
        <c:ser>
          <c:idx val="2"/>
          <c:order val="2"/>
          <c:tx>
            <c:strRef>
              <c:f>Sheet1!$F$1</c:f>
              <c:strCache>
                <c:ptCount val="1"/>
                <c:pt idx="0">
                  <c:v>HPAT2</c:v>
                </c:pt>
              </c:strCache>
            </c:strRef>
          </c:tx>
          <c:spPr>
            <a:solidFill>
              <a:srgbClr val="FFFF00"/>
            </a:solidFill>
            <a:ln>
              <a:solidFill>
                <a:srgbClr val="FFFF00"/>
              </a:solidFill>
            </a:ln>
            <a:effectLst/>
          </c:spPr>
          <c:invertIfNegative val="0"/>
          <c:cat>
            <c:strRef>
              <c:f>Sheet1!$C$2:$C$242</c:f>
              <c:strCache>
                <c:ptCount val="241"/>
                <c:pt idx="0">
                  <c:v>early</c:v>
                </c:pt>
                <c:pt idx="1">
                  <c:v>early</c:v>
                </c:pt>
                <c:pt idx="2">
                  <c:v>early</c:v>
                </c:pt>
                <c:pt idx="3">
                  <c:v>early</c:v>
                </c:pt>
                <c:pt idx="4">
                  <c:v>early</c:v>
                </c:pt>
                <c:pt idx="5">
                  <c:v>early</c:v>
                </c:pt>
                <c:pt idx="6">
                  <c:v>early</c:v>
                </c:pt>
                <c:pt idx="7">
                  <c:v>early</c:v>
                </c:pt>
                <c:pt idx="8">
                  <c:v>early</c:v>
                </c:pt>
                <c:pt idx="9">
                  <c:v>early</c:v>
                </c:pt>
                <c:pt idx="10">
                  <c:v>early</c:v>
                </c:pt>
                <c:pt idx="11">
                  <c:v>early</c:v>
                </c:pt>
                <c:pt idx="12">
                  <c:v>early</c:v>
                </c:pt>
                <c:pt idx="13">
                  <c:v>early</c:v>
                </c:pt>
                <c:pt idx="14">
                  <c:v>early</c:v>
                </c:pt>
                <c:pt idx="15">
                  <c:v>early</c:v>
                </c:pt>
                <c:pt idx="16">
                  <c:v>early</c:v>
                </c:pt>
                <c:pt idx="17">
                  <c:v>early</c:v>
                </c:pt>
                <c:pt idx="18">
                  <c:v>early</c:v>
                </c:pt>
                <c:pt idx="19">
                  <c:v>early</c:v>
                </c:pt>
                <c:pt idx="20">
                  <c:v>early</c:v>
                </c:pt>
                <c:pt idx="21">
                  <c:v>early</c:v>
                </c:pt>
                <c:pt idx="22">
                  <c:v>early</c:v>
                </c:pt>
                <c:pt idx="23">
                  <c:v>early</c:v>
                </c:pt>
                <c:pt idx="24">
                  <c:v>early</c:v>
                </c:pt>
                <c:pt idx="25">
                  <c:v>early</c:v>
                </c:pt>
                <c:pt idx="26">
                  <c:v>early</c:v>
                </c:pt>
                <c:pt idx="27">
                  <c:v>early</c:v>
                </c:pt>
                <c:pt idx="28">
                  <c:v>early</c:v>
                </c:pt>
                <c:pt idx="29">
                  <c:v>early</c:v>
                </c:pt>
                <c:pt idx="30">
                  <c:v>early</c:v>
                </c:pt>
                <c:pt idx="31">
                  <c:v>early</c:v>
                </c:pt>
                <c:pt idx="32">
                  <c:v>early</c:v>
                </c:pt>
                <c:pt idx="33">
                  <c:v>late</c:v>
                </c:pt>
                <c:pt idx="34">
                  <c:v>late</c:v>
                </c:pt>
                <c:pt idx="35">
                  <c:v>late</c:v>
                </c:pt>
                <c:pt idx="36">
                  <c:v>late</c:v>
                </c:pt>
                <c:pt idx="37">
                  <c:v>late</c:v>
                </c:pt>
                <c:pt idx="38">
                  <c:v>late</c:v>
                </c:pt>
                <c:pt idx="39">
                  <c:v>late</c:v>
                </c:pt>
                <c:pt idx="40">
                  <c:v>late</c:v>
                </c:pt>
                <c:pt idx="41">
                  <c:v>late</c:v>
                </c:pt>
                <c:pt idx="42">
                  <c:v>late</c:v>
                </c:pt>
                <c:pt idx="43">
                  <c:v>late</c:v>
                </c:pt>
                <c:pt idx="44">
                  <c:v>late</c:v>
                </c:pt>
                <c:pt idx="45">
                  <c:v>late</c:v>
                </c:pt>
                <c:pt idx="46">
                  <c:v>late</c:v>
                </c:pt>
                <c:pt idx="47">
                  <c:v>late</c:v>
                </c:pt>
                <c:pt idx="48">
                  <c:v>late</c:v>
                </c:pt>
                <c:pt idx="49">
                  <c:v>late</c:v>
                </c:pt>
                <c:pt idx="50">
                  <c:v>late</c:v>
                </c:pt>
                <c:pt idx="51">
                  <c:v>late</c:v>
                </c:pt>
                <c:pt idx="52">
                  <c:v>late</c:v>
                </c:pt>
                <c:pt idx="53">
                  <c:v>late</c:v>
                </c:pt>
                <c:pt idx="54">
                  <c:v>late</c:v>
                </c:pt>
                <c:pt idx="55">
                  <c:v>late</c:v>
                </c:pt>
                <c:pt idx="56">
                  <c:v>late</c:v>
                </c:pt>
                <c:pt idx="57">
                  <c:v>late</c:v>
                </c:pt>
                <c:pt idx="58">
                  <c:v>late</c:v>
                </c:pt>
                <c:pt idx="59">
                  <c:v>late</c:v>
                </c:pt>
                <c:pt idx="60">
                  <c:v>late</c:v>
                </c:pt>
                <c:pt idx="61">
                  <c:v>late</c:v>
                </c:pt>
                <c:pt idx="62">
                  <c:v>late</c:v>
                </c:pt>
                <c:pt idx="63">
                  <c:v>late</c:v>
                </c:pt>
                <c:pt idx="64">
                  <c:v>late</c:v>
                </c:pt>
                <c:pt idx="65">
                  <c:v>late</c:v>
                </c:pt>
                <c:pt idx="66">
                  <c:v>late</c:v>
                </c:pt>
                <c:pt idx="67">
                  <c:v>late</c:v>
                </c:pt>
                <c:pt idx="68">
                  <c:v>late</c:v>
                </c:pt>
                <c:pt idx="69">
                  <c:v>late</c:v>
                </c:pt>
                <c:pt idx="70">
                  <c:v>late</c:v>
                </c:pt>
                <c:pt idx="71">
                  <c:v>late</c:v>
                </c:pt>
                <c:pt idx="72">
                  <c:v>late</c:v>
                </c:pt>
                <c:pt idx="73">
                  <c:v>late</c:v>
                </c:pt>
                <c:pt idx="74">
                  <c:v>late</c:v>
                </c:pt>
                <c:pt idx="75">
                  <c:v>late</c:v>
                </c:pt>
                <c:pt idx="76">
                  <c:v>late</c:v>
                </c:pt>
                <c:pt idx="77">
                  <c:v>late</c:v>
                </c:pt>
                <c:pt idx="78">
                  <c:v>late</c:v>
                </c:pt>
                <c:pt idx="79">
                  <c:v>late</c:v>
                </c:pt>
                <c:pt idx="80">
                  <c:v>late</c:v>
                </c:pt>
                <c:pt idx="81">
                  <c:v>late</c:v>
                </c:pt>
                <c:pt idx="82">
                  <c:v>late</c:v>
                </c:pt>
                <c:pt idx="83">
                  <c:v>late</c:v>
                </c:pt>
                <c:pt idx="84">
                  <c:v>late</c:v>
                </c:pt>
                <c:pt idx="85">
                  <c:v>late</c:v>
                </c:pt>
                <c:pt idx="86">
                  <c:v>late</c:v>
                </c:pt>
                <c:pt idx="87">
                  <c:v>late</c:v>
                </c:pt>
                <c:pt idx="88">
                  <c:v>late</c:v>
                </c:pt>
                <c:pt idx="89">
                  <c:v>late</c:v>
                </c:pt>
                <c:pt idx="90">
                  <c:v>early</c:v>
                </c:pt>
                <c:pt idx="91">
                  <c:v>early</c:v>
                </c:pt>
                <c:pt idx="92">
                  <c:v>early</c:v>
                </c:pt>
                <c:pt idx="93">
                  <c:v>early</c:v>
                </c:pt>
                <c:pt idx="94">
                  <c:v>late</c:v>
                </c:pt>
                <c:pt idx="95">
                  <c:v>late</c:v>
                </c:pt>
                <c:pt idx="96">
                  <c:v>late</c:v>
                </c:pt>
                <c:pt idx="97">
                  <c:v>late</c:v>
                </c:pt>
                <c:pt idx="98">
                  <c:v>late</c:v>
                </c:pt>
                <c:pt idx="99">
                  <c:v>late</c:v>
                </c:pt>
                <c:pt idx="100">
                  <c:v>late</c:v>
                </c:pt>
                <c:pt idx="101">
                  <c:v>late</c:v>
                </c:pt>
                <c:pt idx="102">
                  <c:v>late</c:v>
                </c:pt>
                <c:pt idx="103">
                  <c:v>late</c:v>
                </c:pt>
                <c:pt idx="104">
                  <c:v>late</c:v>
                </c:pt>
                <c:pt idx="105">
                  <c:v>late</c:v>
                </c:pt>
                <c:pt idx="106">
                  <c:v>late</c:v>
                </c:pt>
                <c:pt idx="107">
                  <c:v>late</c:v>
                </c:pt>
                <c:pt idx="108">
                  <c:v>late</c:v>
                </c:pt>
                <c:pt idx="109">
                  <c:v>late</c:v>
                </c:pt>
                <c:pt idx="110">
                  <c:v>late</c:v>
                </c:pt>
                <c:pt idx="111">
                  <c:v>late</c:v>
                </c:pt>
                <c:pt idx="112">
                  <c:v>late</c:v>
                </c:pt>
                <c:pt idx="113">
                  <c:v>late</c:v>
                </c:pt>
                <c:pt idx="114">
                  <c:v>late</c:v>
                </c:pt>
                <c:pt idx="115">
                  <c:v>early</c:v>
                </c:pt>
                <c:pt idx="116">
                  <c:v>early</c:v>
                </c:pt>
                <c:pt idx="117">
                  <c:v>early</c:v>
                </c:pt>
                <c:pt idx="118">
                  <c:v>early</c:v>
                </c:pt>
                <c:pt idx="119">
                  <c:v>early</c:v>
                </c:pt>
                <c:pt idx="120">
                  <c:v>early</c:v>
                </c:pt>
                <c:pt idx="121">
                  <c:v>early</c:v>
                </c:pt>
                <c:pt idx="122">
                  <c:v>early</c:v>
                </c:pt>
                <c:pt idx="123">
                  <c:v>early</c:v>
                </c:pt>
                <c:pt idx="124">
                  <c:v>early</c:v>
                </c:pt>
                <c:pt idx="125">
                  <c:v>early</c:v>
                </c:pt>
                <c:pt idx="126">
                  <c:v>early</c:v>
                </c:pt>
                <c:pt idx="127">
                  <c:v>early</c:v>
                </c:pt>
                <c:pt idx="128">
                  <c:v>early</c:v>
                </c:pt>
                <c:pt idx="129">
                  <c:v>early</c:v>
                </c:pt>
                <c:pt idx="130">
                  <c:v>early</c:v>
                </c:pt>
                <c:pt idx="131">
                  <c:v>early</c:v>
                </c:pt>
                <c:pt idx="132">
                  <c:v>late</c:v>
                </c:pt>
                <c:pt idx="133">
                  <c:v>late</c:v>
                </c:pt>
                <c:pt idx="134">
                  <c:v>late</c:v>
                </c:pt>
                <c:pt idx="135">
                  <c:v>late</c:v>
                </c:pt>
                <c:pt idx="136">
                  <c:v>late</c:v>
                </c:pt>
                <c:pt idx="137">
                  <c:v>late</c:v>
                </c:pt>
                <c:pt idx="138">
                  <c:v>late</c:v>
                </c:pt>
                <c:pt idx="139">
                  <c:v>late</c:v>
                </c:pt>
                <c:pt idx="140">
                  <c:v>late</c:v>
                </c:pt>
                <c:pt idx="141">
                  <c:v>late</c:v>
                </c:pt>
                <c:pt idx="142">
                  <c:v>late</c:v>
                </c:pt>
                <c:pt idx="143">
                  <c:v>late</c:v>
                </c:pt>
                <c:pt idx="144">
                  <c:v>late</c:v>
                </c:pt>
                <c:pt idx="145">
                  <c:v>late</c:v>
                </c:pt>
                <c:pt idx="146">
                  <c:v>late</c:v>
                </c:pt>
                <c:pt idx="147">
                  <c:v>late</c:v>
                </c:pt>
                <c:pt idx="148">
                  <c:v>early</c:v>
                </c:pt>
                <c:pt idx="149">
                  <c:v>early</c:v>
                </c:pt>
                <c:pt idx="150">
                  <c:v>early</c:v>
                </c:pt>
                <c:pt idx="151">
                  <c:v>early</c:v>
                </c:pt>
                <c:pt idx="152">
                  <c:v>early</c:v>
                </c:pt>
                <c:pt idx="153">
                  <c:v>early</c:v>
                </c:pt>
                <c:pt idx="154">
                  <c:v>early</c:v>
                </c:pt>
                <c:pt idx="155">
                  <c:v>early</c:v>
                </c:pt>
                <c:pt idx="156">
                  <c:v>early</c:v>
                </c:pt>
                <c:pt idx="157">
                  <c:v>early</c:v>
                </c:pt>
                <c:pt idx="158">
                  <c:v>early</c:v>
                </c:pt>
                <c:pt idx="159">
                  <c:v>early</c:v>
                </c:pt>
                <c:pt idx="160">
                  <c:v>early</c:v>
                </c:pt>
                <c:pt idx="161">
                  <c:v>early</c:v>
                </c:pt>
                <c:pt idx="162">
                  <c:v>early</c:v>
                </c:pt>
                <c:pt idx="163">
                  <c:v>early</c:v>
                </c:pt>
                <c:pt idx="164">
                  <c:v>early</c:v>
                </c:pt>
                <c:pt idx="165">
                  <c:v>early</c:v>
                </c:pt>
                <c:pt idx="166">
                  <c:v>early</c:v>
                </c:pt>
                <c:pt idx="167">
                  <c:v>early</c:v>
                </c:pt>
                <c:pt idx="168">
                  <c:v>early</c:v>
                </c:pt>
                <c:pt idx="169">
                  <c:v>early</c:v>
                </c:pt>
                <c:pt idx="170">
                  <c:v>early</c:v>
                </c:pt>
                <c:pt idx="171">
                  <c:v>early</c:v>
                </c:pt>
                <c:pt idx="172">
                  <c:v>early</c:v>
                </c:pt>
                <c:pt idx="173">
                  <c:v>early</c:v>
                </c:pt>
                <c:pt idx="174">
                  <c:v>early</c:v>
                </c:pt>
                <c:pt idx="175">
                  <c:v>early</c:v>
                </c:pt>
                <c:pt idx="176">
                  <c:v>early</c:v>
                </c:pt>
                <c:pt idx="177">
                  <c:v>early</c:v>
                </c:pt>
                <c:pt idx="178">
                  <c:v>early</c:v>
                </c:pt>
                <c:pt idx="179">
                  <c:v>early</c:v>
                </c:pt>
                <c:pt idx="180">
                  <c:v>early</c:v>
                </c:pt>
                <c:pt idx="181">
                  <c:v>early</c:v>
                </c:pt>
                <c:pt idx="182">
                  <c:v>late</c:v>
                </c:pt>
                <c:pt idx="183">
                  <c:v>late</c:v>
                </c:pt>
                <c:pt idx="184">
                  <c:v>late</c:v>
                </c:pt>
                <c:pt idx="185">
                  <c:v>late</c:v>
                </c:pt>
                <c:pt idx="186">
                  <c:v>late</c:v>
                </c:pt>
                <c:pt idx="187">
                  <c:v>late</c:v>
                </c:pt>
                <c:pt idx="188">
                  <c:v>late</c:v>
                </c:pt>
                <c:pt idx="189">
                  <c:v>late</c:v>
                </c:pt>
                <c:pt idx="190">
                  <c:v>late</c:v>
                </c:pt>
                <c:pt idx="191">
                  <c:v>late</c:v>
                </c:pt>
                <c:pt idx="192">
                  <c:v>late</c:v>
                </c:pt>
                <c:pt idx="193">
                  <c:v>late</c:v>
                </c:pt>
                <c:pt idx="194">
                  <c:v>late</c:v>
                </c:pt>
                <c:pt idx="195">
                  <c:v>late</c:v>
                </c:pt>
                <c:pt idx="196">
                  <c:v>late</c:v>
                </c:pt>
                <c:pt idx="197">
                  <c:v>late</c:v>
                </c:pt>
                <c:pt idx="198">
                  <c:v>late</c:v>
                </c:pt>
                <c:pt idx="199">
                  <c:v>late</c:v>
                </c:pt>
                <c:pt idx="200">
                  <c:v>late</c:v>
                </c:pt>
                <c:pt idx="201">
                  <c:v>late</c:v>
                </c:pt>
                <c:pt idx="202">
                  <c:v>late</c:v>
                </c:pt>
                <c:pt idx="203">
                  <c:v>late</c:v>
                </c:pt>
                <c:pt idx="204">
                  <c:v>late</c:v>
                </c:pt>
                <c:pt idx="205">
                  <c:v>late</c:v>
                </c:pt>
                <c:pt idx="206">
                  <c:v>late</c:v>
                </c:pt>
                <c:pt idx="207">
                  <c:v>late</c:v>
                </c:pt>
                <c:pt idx="208">
                  <c:v>late</c:v>
                </c:pt>
                <c:pt idx="209">
                  <c:v>late</c:v>
                </c:pt>
                <c:pt idx="210">
                  <c:v>late</c:v>
                </c:pt>
                <c:pt idx="211">
                  <c:v>late</c:v>
                </c:pt>
                <c:pt idx="212">
                  <c:v>late</c:v>
                </c:pt>
                <c:pt idx="213">
                  <c:v>late</c:v>
                </c:pt>
                <c:pt idx="214">
                  <c:v>late</c:v>
                </c:pt>
                <c:pt idx="215">
                  <c:v>late</c:v>
                </c:pt>
                <c:pt idx="216">
                  <c:v>late</c:v>
                </c:pt>
                <c:pt idx="217">
                  <c:v>late</c:v>
                </c:pt>
                <c:pt idx="218">
                  <c:v>late</c:v>
                </c:pt>
                <c:pt idx="219">
                  <c:v>late</c:v>
                </c:pt>
                <c:pt idx="220">
                  <c:v>late</c:v>
                </c:pt>
                <c:pt idx="221">
                  <c:v>late</c:v>
                </c:pt>
                <c:pt idx="222">
                  <c:v>late</c:v>
                </c:pt>
                <c:pt idx="223">
                  <c:v>late</c:v>
                </c:pt>
                <c:pt idx="224">
                  <c:v>late</c:v>
                </c:pt>
                <c:pt idx="225">
                  <c:v>late</c:v>
                </c:pt>
                <c:pt idx="226">
                  <c:v>late</c:v>
                </c:pt>
                <c:pt idx="227">
                  <c:v>late</c:v>
                </c:pt>
                <c:pt idx="228">
                  <c:v>late</c:v>
                </c:pt>
                <c:pt idx="229">
                  <c:v>late</c:v>
                </c:pt>
                <c:pt idx="230">
                  <c:v>late</c:v>
                </c:pt>
                <c:pt idx="231">
                  <c:v>late</c:v>
                </c:pt>
                <c:pt idx="232">
                  <c:v>late</c:v>
                </c:pt>
                <c:pt idx="233">
                  <c:v>late</c:v>
                </c:pt>
                <c:pt idx="234">
                  <c:v>late</c:v>
                </c:pt>
                <c:pt idx="235">
                  <c:v>late</c:v>
                </c:pt>
                <c:pt idx="236">
                  <c:v>late</c:v>
                </c:pt>
                <c:pt idx="237">
                  <c:v>late</c:v>
                </c:pt>
                <c:pt idx="238">
                  <c:v>late</c:v>
                </c:pt>
                <c:pt idx="239">
                  <c:v>late</c:v>
                </c:pt>
                <c:pt idx="240">
                  <c:v>late</c:v>
                </c:pt>
              </c:strCache>
            </c:strRef>
          </c:cat>
          <c:val>
            <c:numRef>
              <c:f>Sheet1!$F$2:$F$242</c:f>
              <c:numCache>
                <c:formatCode>General</c:formatCode>
                <c:ptCount val="241"/>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1.3723255510000001</c:v>
                </c:pt>
                <c:pt idx="46">
                  <c:v>0</c:v>
                </c:pt>
                <c:pt idx="47">
                  <c:v>0</c:v>
                </c:pt>
                <c:pt idx="48">
                  <c:v>0</c:v>
                </c:pt>
                <c:pt idx="49">
                  <c:v>0</c:v>
                </c:pt>
                <c:pt idx="50">
                  <c:v>0</c:v>
                </c:pt>
                <c:pt idx="51">
                  <c:v>0</c:v>
                </c:pt>
                <c:pt idx="52">
                  <c:v>0</c:v>
                </c:pt>
                <c:pt idx="53">
                  <c:v>0</c:v>
                </c:pt>
                <c:pt idx="54">
                  <c:v>0</c:v>
                </c:pt>
                <c:pt idx="55">
                  <c:v>0</c:v>
                </c:pt>
                <c:pt idx="56">
                  <c:v>0</c:v>
                </c:pt>
                <c:pt idx="57">
                  <c:v>0</c:v>
                </c:pt>
                <c:pt idx="58">
                  <c:v>0</c:v>
                </c:pt>
                <c:pt idx="59">
                  <c:v>0</c:v>
                </c:pt>
                <c:pt idx="60">
                  <c:v>0</c:v>
                </c:pt>
                <c:pt idx="61">
                  <c:v>0</c:v>
                </c:pt>
                <c:pt idx="62">
                  <c:v>0</c:v>
                </c:pt>
                <c:pt idx="63">
                  <c:v>0</c:v>
                </c:pt>
                <c:pt idx="64">
                  <c:v>0</c:v>
                </c:pt>
                <c:pt idx="65">
                  <c:v>0</c:v>
                </c:pt>
                <c:pt idx="66">
                  <c:v>0</c:v>
                </c:pt>
                <c:pt idx="67">
                  <c:v>0</c:v>
                </c:pt>
                <c:pt idx="68">
                  <c:v>0</c:v>
                </c:pt>
                <c:pt idx="69">
                  <c:v>0</c:v>
                </c:pt>
                <c:pt idx="70">
                  <c:v>0</c:v>
                </c:pt>
                <c:pt idx="71">
                  <c:v>0</c:v>
                </c:pt>
                <c:pt idx="72">
                  <c:v>0</c:v>
                </c:pt>
                <c:pt idx="73">
                  <c:v>0</c:v>
                </c:pt>
                <c:pt idx="74">
                  <c:v>0</c:v>
                </c:pt>
                <c:pt idx="75">
                  <c:v>0</c:v>
                </c:pt>
                <c:pt idx="76">
                  <c:v>-1.1610149030000001</c:v>
                </c:pt>
                <c:pt idx="77">
                  <c:v>0</c:v>
                </c:pt>
                <c:pt idx="78">
                  <c:v>0</c:v>
                </c:pt>
                <c:pt idx="79">
                  <c:v>0</c:v>
                </c:pt>
                <c:pt idx="80">
                  <c:v>0</c:v>
                </c:pt>
                <c:pt idx="81">
                  <c:v>0</c:v>
                </c:pt>
                <c:pt idx="82">
                  <c:v>0</c:v>
                </c:pt>
                <c:pt idx="83">
                  <c:v>0</c:v>
                </c:pt>
                <c:pt idx="84">
                  <c:v>0</c:v>
                </c:pt>
                <c:pt idx="85">
                  <c:v>0</c:v>
                </c:pt>
                <c:pt idx="86">
                  <c:v>0</c:v>
                </c:pt>
                <c:pt idx="87">
                  <c:v>0</c:v>
                </c:pt>
                <c:pt idx="88">
                  <c:v>0</c:v>
                </c:pt>
                <c:pt idx="89">
                  <c:v>0</c:v>
                </c:pt>
                <c:pt idx="90">
                  <c:v>2.6345949480000002</c:v>
                </c:pt>
                <c:pt idx="91">
                  <c:v>3.8854420589999998</c:v>
                </c:pt>
                <c:pt idx="92">
                  <c:v>2.7315017930000001</c:v>
                </c:pt>
                <c:pt idx="93">
                  <c:v>2.3242828819999999</c:v>
                </c:pt>
                <c:pt idx="94">
                  <c:v>2.9067377109999999</c:v>
                </c:pt>
                <c:pt idx="95">
                  <c:v>3.9820590359999999</c:v>
                </c:pt>
                <c:pt idx="96">
                  <c:v>3.8919508340000002</c:v>
                </c:pt>
                <c:pt idx="97">
                  <c:v>1.4720603720000001</c:v>
                </c:pt>
                <c:pt idx="98">
                  <c:v>4.5112534630000001</c:v>
                </c:pt>
                <c:pt idx="99">
                  <c:v>3.40292233</c:v>
                </c:pt>
                <c:pt idx="100">
                  <c:v>0.16710702899999999</c:v>
                </c:pt>
                <c:pt idx="101">
                  <c:v>6.285010357</c:v>
                </c:pt>
                <c:pt idx="102">
                  <c:v>5.1780957729999999</c:v>
                </c:pt>
                <c:pt idx="103">
                  <c:v>2.0436174380000001</c:v>
                </c:pt>
                <c:pt idx="104">
                  <c:v>0.59341937499999997</c:v>
                </c:pt>
                <c:pt idx="105">
                  <c:v>1.1165801120000001</c:v>
                </c:pt>
                <c:pt idx="106">
                  <c:v>4.284310208</c:v>
                </c:pt>
                <c:pt idx="107">
                  <c:v>3.7254184549999998</c:v>
                </c:pt>
                <c:pt idx="108">
                  <c:v>6.0012152060000004</c:v>
                </c:pt>
                <c:pt idx="109">
                  <c:v>4.2274467480000002</c:v>
                </c:pt>
                <c:pt idx="110">
                  <c:v>6.1486140059999999</c:v>
                </c:pt>
                <c:pt idx="111">
                  <c:v>2.7522529800000002</c:v>
                </c:pt>
                <c:pt idx="112">
                  <c:v>3.6425518499999998</c:v>
                </c:pt>
                <c:pt idx="113">
                  <c:v>2.9256091679999998</c:v>
                </c:pt>
                <c:pt idx="114">
                  <c:v>1.35850542</c:v>
                </c:pt>
                <c:pt idx="115">
                  <c:v>3.1291214090000001</c:v>
                </c:pt>
                <c:pt idx="116">
                  <c:v>2.9579760070000001</c:v>
                </c:pt>
                <c:pt idx="117">
                  <c:v>3.3553319880000001</c:v>
                </c:pt>
                <c:pt idx="118">
                  <c:v>3.1683249409999998</c:v>
                </c:pt>
                <c:pt idx="119">
                  <c:v>3.3848362289999998</c:v>
                </c:pt>
                <c:pt idx="120">
                  <c:v>2.975747455</c:v>
                </c:pt>
                <c:pt idx="121">
                  <c:v>3.2924091230000001</c:v>
                </c:pt>
                <c:pt idx="122">
                  <c:v>2.576126822</c:v>
                </c:pt>
                <c:pt idx="123">
                  <c:v>3.3191049480000001</c:v>
                </c:pt>
                <c:pt idx="124">
                  <c:v>3.7752593409999999</c:v>
                </c:pt>
                <c:pt idx="125">
                  <c:v>3.743173927</c:v>
                </c:pt>
                <c:pt idx="126">
                  <c:v>3.7723614130000001</c:v>
                </c:pt>
                <c:pt idx="127">
                  <c:v>3.1713706820000001</c:v>
                </c:pt>
                <c:pt idx="128">
                  <c:v>3.3325664829999999</c:v>
                </c:pt>
                <c:pt idx="129">
                  <c:v>2.2870465790000001</c:v>
                </c:pt>
                <c:pt idx="130">
                  <c:v>2.9842021249999999</c:v>
                </c:pt>
                <c:pt idx="131">
                  <c:v>2.6969314440000001</c:v>
                </c:pt>
                <c:pt idx="132">
                  <c:v>4.102886678</c:v>
                </c:pt>
                <c:pt idx="133">
                  <c:v>6.890472033</c:v>
                </c:pt>
                <c:pt idx="134">
                  <c:v>3.7027362670000001</c:v>
                </c:pt>
                <c:pt idx="135">
                  <c:v>3.4532414239999998</c:v>
                </c:pt>
                <c:pt idx="136">
                  <c:v>3.3628207259999998</c:v>
                </c:pt>
                <c:pt idx="137">
                  <c:v>3.805301144</c:v>
                </c:pt>
                <c:pt idx="138">
                  <c:v>4.320395435</c:v>
                </c:pt>
                <c:pt idx="139">
                  <c:v>6.9937410770000001</c:v>
                </c:pt>
                <c:pt idx="140">
                  <c:v>4.5029680809999997</c:v>
                </c:pt>
                <c:pt idx="141">
                  <c:v>3.0504610699999999</c:v>
                </c:pt>
                <c:pt idx="142">
                  <c:v>4.320395435</c:v>
                </c:pt>
                <c:pt idx="143">
                  <c:v>7.2810172900000003</c:v>
                </c:pt>
                <c:pt idx="144">
                  <c:v>2.7446986619999998</c:v>
                </c:pt>
                <c:pt idx="145">
                  <c:v>3.890562912</c:v>
                </c:pt>
                <c:pt idx="146">
                  <c:v>5.729183087</c:v>
                </c:pt>
                <c:pt idx="147">
                  <c:v>3.022672268</c:v>
                </c:pt>
                <c:pt idx="148">
                  <c:v>0</c:v>
                </c:pt>
                <c:pt idx="149">
                  <c:v>0</c:v>
                </c:pt>
                <c:pt idx="150">
                  <c:v>0</c:v>
                </c:pt>
                <c:pt idx="151">
                  <c:v>0</c:v>
                </c:pt>
                <c:pt idx="152">
                  <c:v>0</c:v>
                </c:pt>
                <c:pt idx="153">
                  <c:v>0</c:v>
                </c:pt>
                <c:pt idx="154">
                  <c:v>0</c:v>
                </c:pt>
                <c:pt idx="155">
                  <c:v>0</c:v>
                </c:pt>
                <c:pt idx="156">
                  <c:v>0</c:v>
                </c:pt>
                <c:pt idx="157">
                  <c:v>0</c:v>
                </c:pt>
                <c:pt idx="158">
                  <c:v>0</c:v>
                </c:pt>
                <c:pt idx="159">
                  <c:v>0</c:v>
                </c:pt>
                <c:pt idx="160">
                  <c:v>0</c:v>
                </c:pt>
                <c:pt idx="161">
                  <c:v>0</c:v>
                </c:pt>
                <c:pt idx="162">
                  <c:v>0</c:v>
                </c:pt>
                <c:pt idx="163">
                  <c:v>0</c:v>
                </c:pt>
                <c:pt idx="164">
                  <c:v>0</c:v>
                </c:pt>
                <c:pt idx="165">
                  <c:v>0</c:v>
                </c:pt>
                <c:pt idx="166">
                  <c:v>0</c:v>
                </c:pt>
                <c:pt idx="167">
                  <c:v>0</c:v>
                </c:pt>
                <c:pt idx="168">
                  <c:v>0</c:v>
                </c:pt>
                <c:pt idx="169">
                  <c:v>0</c:v>
                </c:pt>
                <c:pt idx="170">
                  <c:v>0</c:v>
                </c:pt>
                <c:pt idx="171">
                  <c:v>0</c:v>
                </c:pt>
                <c:pt idx="172">
                  <c:v>0</c:v>
                </c:pt>
                <c:pt idx="173">
                  <c:v>0</c:v>
                </c:pt>
                <c:pt idx="174">
                  <c:v>0</c:v>
                </c:pt>
                <c:pt idx="175">
                  <c:v>0</c:v>
                </c:pt>
                <c:pt idx="176">
                  <c:v>0</c:v>
                </c:pt>
                <c:pt idx="177">
                  <c:v>0</c:v>
                </c:pt>
                <c:pt idx="178">
                  <c:v>0</c:v>
                </c:pt>
                <c:pt idx="179">
                  <c:v>0</c:v>
                </c:pt>
                <c:pt idx="180">
                  <c:v>0</c:v>
                </c:pt>
                <c:pt idx="181">
                  <c:v>0</c:v>
                </c:pt>
                <c:pt idx="182">
                  <c:v>0</c:v>
                </c:pt>
                <c:pt idx="183">
                  <c:v>0</c:v>
                </c:pt>
                <c:pt idx="184">
                  <c:v>0</c:v>
                </c:pt>
                <c:pt idx="185">
                  <c:v>0</c:v>
                </c:pt>
                <c:pt idx="186">
                  <c:v>0</c:v>
                </c:pt>
                <c:pt idx="187">
                  <c:v>0</c:v>
                </c:pt>
                <c:pt idx="188">
                  <c:v>0</c:v>
                </c:pt>
                <c:pt idx="189">
                  <c:v>0</c:v>
                </c:pt>
                <c:pt idx="190">
                  <c:v>0</c:v>
                </c:pt>
                <c:pt idx="191">
                  <c:v>0</c:v>
                </c:pt>
                <c:pt idx="192">
                  <c:v>0</c:v>
                </c:pt>
                <c:pt idx="193">
                  <c:v>0</c:v>
                </c:pt>
                <c:pt idx="194">
                  <c:v>0</c:v>
                </c:pt>
                <c:pt idx="195">
                  <c:v>0</c:v>
                </c:pt>
                <c:pt idx="196">
                  <c:v>0</c:v>
                </c:pt>
                <c:pt idx="197">
                  <c:v>0</c:v>
                </c:pt>
                <c:pt idx="198">
                  <c:v>0</c:v>
                </c:pt>
                <c:pt idx="199">
                  <c:v>0</c:v>
                </c:pt>
                <c:pt idx="200">
                  <c:v>0</c:v>
                </c:pt>
                <c:pt idx="201">
                  <c:v>0</c:v>
                </c:pt>
                <c:pt idx="202">
                  <c:v>0</c:v>
                </c:pt>
                <c:pt idx="203">
                  <c:v>0</c:v>
                </c:pt>
                <c:pt idx="204">
                  <c:v>0</c:v>
                </c:pt>
                <c:pt idx="205">
                  <c:v>0</c:v>
                </c:pt>
                <c:pt idx="206">
                  <c:v>0</c:v>
                </c:pt>
                <c:pt idx="207">
                  <c:v>0</c:v>
                </c:pt>
                <c:pt idx="208">
                  <c:v>0</c:v>
                </c:pt>
                <c:pt idx="209">
                  <c:v>0</c:v>
                </c:pt>
                <c:pt idx="210">
                  <c:v>0</c:v>
                </c:pt>
                <c:pt idx="211">
                  <c:v>0</c:v>
                </c:pt>
                <c:pt idx="212">
                  <c:v>0</c:v>
                </c:pt>
                <c:pt idx="213">
                  <c:v>0</c:v>
                </c:pt>
                <c:pt idx="214">
                  <c:v>0</c:v>
                </c:pt>
                <c:pt idx="215">
                  <c:v>0</c:v>
                </c:pt>
                <c:pt idx="216">
                  <c:v>0</c:v>
                </c:pt>
                <c:pt idx="217">
                  <c:v>0</c:v>
                </c:pt>
                <c:pt idx="218">
                  <c:v>0</c:v>
                </c:pt>
                <c:pt idx="219">
                  <c:v>0</c:v>
                </c:pt>
                <c:pt idx="220">
                  <c:v>0</c:v>
                </c:pt>
                <c:pt idx="221">
                  <c:v>0</c:v>
                </c:pt>
                <c:pt idx="222">
                  <c:v>0</c:v>
                </c:pt>
                <c:pt idx="223">
                  <c:v>0</c:v>
                </c:pt>
                <c:pt idx="224">
                  <c:v>0</c:v>
                </c:pt>
                <c:pt idx="225">
                  <c:v>0</c:v>
                </c:pt>
                <c:pt idx="226">
                  <c:v>0</c:v>
                </c:pt>
                <c:pt idx="227">
                  <c:v>0</c:v>
                </c:pt>
                <c:pt idx="228">
                  <c:v>0</c:v>
                </c:pt>
                <c:pt idx="229">
                  <c:v>0</c:v>
                </c:pt>
                <c:pt idx="230">
                  <c:v>0</c:v>
                </c:pt>
                <c:pt idx="231">
                  <c:v>0</c:v>
                </c:pt>
                <c:pt idx="232">
                  <c:v>0</c:v>
                </c:pt>
                <c:pt idx="233">
                  <c:v>0</c:v>
                </c:pt>
                <c:pt idx="234">
                  <c:v>0</c:v>
                </c:pt>
                <c:pt idx="235">
                  <c:v>0</c:v>
                </c:pt>
                <c:pt idx="236">
                  <c:v>0</c:v>
                </c:pt>
                <c:pt idx="237">
                  <c:v>0</c:v>
                </c:pt>
                <c:pt idx="238">
                  <c:v>0</c:v>
                </c:pt>
                <c:pt idx="239">
                  <c:v>0</c:v>
                </c:pt>
                <c:pt idx="240">
                  <c:v>0</c:v>
                </c:pt>
              </c:numCache>
            </c:numRef>
          </c:val>
        </c:ser>
        <c:ser>
          <c:idx val="3"/>
          <c:order val="3"/>
          <c:tx>
            <c:strRef>
              <c:f>Sheet1!$G$1</c:f>
              <c:strCache>
                <c:ptCount val="1"/>
                <c:pt idx="0">
                  <c:v>TERT</c:v>
                </c:pt>
              </c:strCache>
            </c:strRef>
          </c:tx>
          <c:spPr>
            <a:solidFill>
              <a:schemeClr val="tx1"/>
            </a:solidFill>
            <a:ln w="25400">
              <a:solidFill>
                <a:schemeClr val="tx1"/>
              </a:solidFill>
            </a:ln>
            <a:effectLst/>
          </c:spPr>
          <c:invertIfNegative val="0"/>
          <c:cat>
            <c:strRef>
              <c:f>Sheet1!$C$2:$C$242</c:f>
              <c:strCache>
                <c:ptCount val="241"/>
                <c:pt idx="0">
                  <c:v>early</c:v>
                </c:pt>
                <c:pt idx="1">
                  <c:v>early</c:v>
                </c:pt>
                <c:pt idx="2">
                  <c:v>early</c:v>
                </c:pt>
                <c:pt idx="3">
                  <c:v>early</c:v>
                </c:pt>
                <c:pt idx="4">
                  <c:v>early</c:v>
                </c:pt>
                <c:pt idx="5">
                  <c:v>early</c:v>
                </c:pt>
                <c:pt idx="6">
                  <c:v>early</c:v>
                </c:pt>
                <c:pt idx="7">
                  <c:v>early</c:v>
                </c:pt>
                <c:pt idx="8">
                  <c:v>early</c:v>
                </c:pt>
                <c:pt idx="9">
                  <c:v>early</c:v>
                </c:pt>
                <c:pt idx="10">
                  <c:v>early</c:v>
                </c:pt>
                <c:pt idx="11">
                  <c:v>early</c:v>
                </c:pt>
                <c:pt idx="12">
                  <c:v>early</c:v>
                </c:pt>
                <c:pt idx="13">
                  <c:v>early</c:v>
                </c:pt>
                <c:pt idx="14">
                  <c:v>early</c:v>
                </c:pt>
                <c:pt idx="15">
                  <c:v>early</c:v>
                </c:pt>
                <c:pt idx="16">
                  <c:v>early</c:v>
                </c:pt>
                <c:pt idx="17">
                  <c:v>early</c:v>
                </c:pt>
                <c:pt idx="18">
                  <c:v>early</c:v>
                </c:pt>
                <c:pt idx="19">
                  <c:v>early</c:v>
                </c:pt>
                <c:pt idx="20">
                  <c:v>early</c:v>
                </c:pt>
                <c:pt idx="21">
                  <c:v>early</c:v>
                </c:pt>
                <c:pt idx="22">
                  <c:v>early</c:v>
                </c:pt>
                <c:pt idx="23">
                  <c:v>early</c:v>
                </c:pt>
                <c:pt idx="24">
                  <c:v>early</c:v>
                </c:pt>
                <c:pt idx="25">
                  <c:v>early</c:v>
                </c:pt>
                <c:pt idx="26">
                  <c:v>early</c:v>
                </c:pt>
                <c:pt idx="27">
                  <c:v>early</c:v>
                </c:pt>
                <c:pt idx="28">
                  <c:v>early</c:v>
                </c:pt>
                <c:pt idx="29">
                  <c:v>early</c:v>
                </c:pt>
                <c:pt idx="30">
                  <c:v>early</c:v>
                </c:pt>
                <c:pt idx="31">
                  <c:v>early</c:v>
                </c:pt>
                <c:pt idx="32">
                  <c:v>early</c:v>
                </c:pt>
                <c:pt idx="33">
                  <c:v>late</c:v>
                </c:pt>
                <c:pt idx="34">
                  <c:v>late</c:v>
                </c:pt>
                <c:pt idx="35">
                  <c:v>late</c:v>
                </c:pt>
                <c:pt idx="36">
                  <c:v>late</c:v>
                </c:pt>
                <c:pt idx="37">
                  <c:v>late</c:v>
                </c:pt>
                <c:pt idx="38">
                  <c:v>late</c:v>
                </c:pt>
                <c:pt idx="39">
                  <c:v>late</c:v>
                </c:pt>
                <c:pt idx="40">
                  <c:v>late</c:v>
                </c:pt>
                <c:pt idx="41">
                  <c:v>late</c:v>
                </c:pt>
                <c:pt idx="42">
                  <c:v>late</c:v>
                </c:pt>
                <c:pt idx="43">
                  <c:v>late</c:v>
                </c:pt>
                <c:pt idx="44">
                  <c:v>late</c:v>
                </c:pt>
                <c:pt idx="45">
                  <c:v>late</c:v>
                </c:pt>
                <c:pt idx="46">
                  <c:v>late</c:v>
                </c:pt>
                <c:pt idx="47">
                  <c:v>late</c:v>
                </c:pt>
                <c:pt idx="48">
                  <c:v>late</c:v>
                </c:pt>
                <c:pt idx="49">
                  <c:v>late</c:v>
                </c:pt>
                <c:pt idx="50">
                  <c:v>late</c:v>
                </c:pt>
                <c:pt idx="51">
                  <c:v>late</c:v>
                </c:pt>
                <c:pt idx="52">
                  <c:v>late</c:v>
                </c:pt>
                <c:pt idx="53">
                  <c:v>late</c:v>
                </c:pt>
                <c:pt idx="54">
                  <c:v>late</c:v>
                </c:pt>
                <c:pt idx="55">
                  <c:v>late</c:v>
                </c:pt>
                <c:pt idx="56">
                  <c:v>late</c:v>
                </c:pt>
                <c:pt idx="57">
                  <c:v>late</c:v>
                </c:pt>
                <c:pt idx="58">
                  <c:v>late</c:v>
                </c:pt>
                <c:pt idx="59">
                  <c:v>late</c:v>
                </c:pt>
                <c:pt idx="60">
                  <c:v>late</c:v>
                </c:pt>
                <c:pt idx="61">
                  <c:v>late</c:v>
                </c:pt>
                <c:pt idx="62">
                  <c:v>late</c:v>
                </c:pt>
                <c:pt idx="63">
                  <c:v>late</c:v>
                </c:pt>
                <c:pt idx="64">
                  <c:v>late</c:v>
                </c:pt>
                <c:pt idx="65">
                  <c:v>late</c:v>
                </c:pt>
                <c:pt idx="66">
                  <c:v>late</c:v>
                </c:pt>
                <c:pt idx="67">
                  <c:v>late</c:v>
                </c:pt>
                <c:pt idx="68">
                  <c:v>late</c:v>
                </c:pt>
                <c:pt idx="69">
                  <c:v>late</c:v>
                </c:pt>
                <c:pt idx="70">
                  <c:v>late</c:v>
                </c:pt>
                <c:pt idx="71">
                  <c:v>late</c:v>
                </c:pt>
                <c:pt idx="72">
                  <c:v>late</c:v>
                </c:pt>
                <c:pt idx="73">
                  <c:v>late</c:v>
                </c:pt>
                <c:pt idx="74">
                  <c:v>late</c:v>
                </c:pt>
                <c:pt idx="75">
                  <c:v>late</c:v>
                </c:pt>
                <c:pt idx="76">
                  <c:v>late</c:v>
                </c:pt>
                <c:pt idx="77">
                  <c:v>late</c:v>
                </c:pt>
                <c:pt idx="78">
                  <c:v>late</c:v>
                </c:pt>
                <c:pt idx="79">
                  <c:v>late</c:v>
                </c:pt>
                <c:pt idx="80">
                  <c:v>late</c:v>
                </c:pt>
                <c:pt idx="81">
                  <c:v>late</c:v>
                </c:pt>
                <c:pt idx="82">
                  <c:v>late</c:v>
                </c:pt>
                <c:pt idx="83">
                  <c:v>late</c:v>
                </c:pt>
                <c:pt idx="84">
                  <c:v>late</c:v>
                </c:pt>
                <c:pt idx="85">
                  <c:v>late</c:v>
                </c:pt>
                <c:pt idx="86">
                  <c:v>late</c:v>
                </c:pt>
                <c:pt idx="87">
                  <c:v>late</c:v>
                </c:pt>
                <c:pt idx="88">
                  <c:v>late</c:v>
                </c:pt>
                <c:pt idx="89">
                  <c:v>late</c:v>
                </c:pt>
                <c:pt idx="90">
                  <c:v>early</c:v>
                </c:pt>
                <c:pt idx="91">
                  <c:v>early</c:v>
                </c:pt>
                <c:pt idx="92">
                  <c:v>early</c:v>
                </c:pt>
                <c:pt idx="93">
                  <c:v>early</c:v>
                </c:pt>
                <c:pt idx="94">
                  <c:v>late</c:v>
                </c:pt>
                <c:pt idx="95">
                  <c:v>late</c:v>
                </c:pt>
                <c:pt idx="96">
                  <c:v>late</c:v>
                </c:pt>
                <c:pt idx="97">
                  <c:v>late</c:v>
                </c:pt>
                <c:pt idx="98">
                  <c:v>late</c:v>
                </c:pt>
                <c:pt idx="99">
                  <c:v>late</c:v>
                </c:pt>
                <c:pt idx="100">
                  <c:v>late</c:v>
                </c:pt>
                <c:pt idx="101">
                  <c:v>late</c:v>
                </c:pt>
                <c:pt idx="102">
                  <c:v>late</c:v>
                </c:pt>
                <c:pt idx="103">
                  <c:v>late</c:v>
                </c:pt>
                <c:pt idx="104">
                  <c:v>late</c:v>
                </c:pt>
                <c:pt idx="105">
                  <c:v>late</c:v>
                </c:pt>
                <c:pt idx="106">
                  <c:v>late</c:v>
                </c:pt>
                <c:pt idx="107">
                  <c:v>late</c:v>
                </c:pt>
                <c:pt idx="108">
                  <c:v>late</c:v>
                </c:pt>
                <c:pt idx="109">
                  <c:v>late</c:v>
                </c:pt>
                <c:pt idx="110">
                  <c:v>late</c:v>
                </c:pt>
                <c:pt idx="111">
                  <c:v>late</c:v>
                </c:pt>
                <c:pt idx="112">
                  <c:v>late</c:v>
                </c:pt>
                <c:pt idx="113">
                  <c:v>late</c:v>
                </c:pt>
                <c:pt idx="114">
                  <c:v>late</c:v>
                </c:pt>
                <c:pt idx="115">
                  <c:v>early</c:v>
                </c:pt>
                <c:pt idx="116">
                  <c:v>early</c:v>
                </c:pt>
                <c:pt idx="117">
                  <c:v>early</c:v>
                </c:pt>
                <c:pt idx="118">
                  <c:v>early</c:v>
                </c:pt>
                <c:pt idx="119">
                  <c:v>early</c:v>
                </c:pt>
                <c:pt idx="120">
                  <c:v>early</c:v>
                </c:pt>
                <c:pt idx="121">
                  <c:v>early</c:v>
                </c:pt>
                <c:pt idx="122">
                  <c:v>early</c:v>
                </c:pt>
                <c:pt idx="123">
                  <c:v>early</c:v>
                </c:pt>
                <c:pt idx="124">
                  <c:v>early</c:v>
                </c:pt>
                <c:pt idx="125">
                  <c:v>early</c:v>
                </c:pt>
                <c:pt idx="126">
                  <c:v>early</c:v>
                </c:pt>
                <c:pt idx="127">
                  <c:v>early</c:v>
                </c:pt>
                <c:pt idx="128">
                  <c:v>early</c:v>
                </c:pt>
                <c:pt idx="129">
                  <c:v>early</c:v>
                </c:pt>
                <c:pt idx="130">
                  <c:v>early</c:v>
                </c:pt>
                <c:pt idx="131">
                  <c:v>early</c:v>
                </c:pt>
                <c:pt idx="132">
                  <c:v>late</c:v>
                </c:pt>
                <c:pt idx="133">
                  <c:v>late</c:v>
                </c:pt>
                <c:pt idx="134">
                  <c:v>late</c:v>
                </c:pt>
                <c:pt idx="135">
                  <c:v>late</c:v>
                </c:pt>
                <c:pt idx="136">
                  <c:v>late</c:v>
                </c:pt>
                <c:pt idx="137">
                  <c:v>late</c:v>
                </c:pt>
                <c:pt idx="138">
                  <c:v>late</c:v>
                </c:pt>
                <c:pt idx="139">
                  <c:v>late</c:v>
                </c:pt>
                <c:pt idx="140">
                  <c:v>late</c:v>
                </c:pt>
                <c:pt idx="141">
                  <c:v>late</c:v>
                </c:pt>
                <c:pt idx="142">
                  <c:v>late</c:v>
                </c:pt>
                <c:pt idx="143">
                  <c:v>late</c:v>
                </c:pt>
                <c:pt idx="144">
                  <c:v>late</c:v>
                </c:pt>
                <c:pt idx="145">
                  <c:v>late</c:v>
                </c:pt>
                <c:pt idx="146">
                  <c:v>late</c:v>
                </c:pt>
                <c:pt idx="147">
                  <c:v>late</c:v>
                </c:pt>
                <c:pt idx="148">
                  <c:v>early</c:v>
                </c:pt>
                <c:pt idx="149">
                  <c:v>early</c:v>
                </c:pt>
                <c:pt idx="150">
                  <c:v>early</c:v>
                </c:pt>
                <c:pt idx="151">
                  <c:v>early</c:v>
                </c:pt>
                <c:pt idx="152">
                  <c:v>early</c:v>
                </c:pt>
                <c:pt idx="153">
                  <c:v>early</c:v>
                </c:pt>
                <c:pt idx="154">
                  <c:v>early</c:v>
                </c:pt>
                <c:pt idx="155">
                  <c:v>early</c:v>
                </c:pt>
                <c:pt idx="156">
                  <c:v>early</c:v>
                </c:pt>
                <c:pt idx="157">
                  <c:v>early</c:v>
                </c:pt>
                <c:pt idx="158">
                  <c:v>early</c:v>
                </c:pt>
                <c:pt idx="159">
                  <c:v>early</c:v>
                </c:pt>
                <c:pt idx="160">
                  <c:v>early</c:v>
                </c:pt>
                <c:pt idx="161">
                  <c:v>early</c:v>
                </c:pt>
                <c:pt idx="162">
                  <c:v>early</c:v>
                </c:pt>
                <c:pt idx="163">
                  <c:v>early</c:v>
                </c:pt>
                <c:pt idx="164">
                  <c:v>early</c:v>
                </c:pt>
                <c:pt idx="165">
                  <c:v>early</c:v>
                </c:pt>
                <c:pt idx="166">
                  <c:v>early</c:v>
                </c:pt>
                <c:pt idx="167">
                  <c:v>early</c:v>
                </c:pt>
                <c:pt idx="168">
                  <c:v>early</c:v>
                </c:pt>
                <c:pt idx="169">
                  <c:v>early</c:v>
                </c:pt>
                <c:pt idx="170">
                  <c:v>early</c:v>
                </c:pt>
                <c:pt idx="171">
                  <c:v>early</c:v>
                </c:pt>
                <c:pt idx="172">
                  <c:v>early</c:v>
                </c:pt>
                <c:pt idx="173">
                  <c:v>early</c:v>
                </c:pt>
                <c:pt idx="174">
                  <c:v>early</c:v>
                </c:pt>
                <c:pt idx="175">
                  <c:v>early</c:v>
                </c:pt>
                <c:pt idx="176">
                  <c:v>early</c:v>
                </c:pt>
                <c:pt idx="177">
                  <c:v>early</c:v>
                </c:pt>
                <c:pt idx="178">
                  <c:v>early</c:v>
                </c:pt>
                <c:pt idx="179">
                  <c:v>early</c:v>
                </c:pt>
                <c:pt idx="180">
                  <c:v>early</c:v>
                </c:pt>
                <c:pt idx="181">
                  <c:v>early</c:v>
                </c:pt>
                <c:pt idx="182">
                  <c:v>late</c:v>
                </c:pt>
                <c:pt idx="183">
                  <c:v>late</c:v>
                </c:pt>
                <c:pt idx="184">
                  <c:v>late</c:v>
                </c:pt>
                <c:pt idx="185">
                  <c:v>late</c:v>
                </c:pt>
                <c:pt idx="186">
                  <c:v>late</c:v>
                </c:pt>
                <c:pt idx="187">
                  <c:v>late</c:v>
                </c:pt>
                <c:pt idx="188">
                  <c:v>late</c:v>
                </c:pt>
                <c:pt idx="189">
                  <c:v>late</c:v>
                </c:pt>
                <c:pt idx="190">
                  <c:v>late</c:v>
                </c:pt>
                <c:pt idx="191">
                  <c:v>late</c:v>
                </c:pt>
                <c:pt idx="192">
                  <c:v>late</c:v>
                </c:pt>
                <c:pt idx="193">
                  <c:v>late</c:v>
                </c:pt>
                <c:pt idx="194">
                  <c:v>late</c:v>
                </c:pt>
                <c:pt idx="195">
                  <c:v>late</c:v>
                </c:pt>
                <c:pt idx="196">
                  <c:v>late</c:v>
                </c:pt>
                <c:pt idx="197">
                  <c:v>late</c:v>
                </c:pt>
                <c:pt idx="198">
                  <c:v>late</c:v>
                </c:pt>
                <c:pt idx="199">
                  <c:v>late</c:v>
                </c:pt>
                <c:pt idx="200">
                  <c:v>late</c:v>
                </c:pt>
                <c:pt idx="201">
                  <c:v>late</c:v>
                </c:pt>
                <c:pt idx="202">
                  <c:v>late</c:v>
                </c:pt>
                <c:pt idx="203">
                  <c:v>late</c:v>
                </c:pt>
                <c:pt idx="204">
                  <c:v>late</c:v>
                </c:pt>
                <c:pt idx="205">
                  <c:v>late</c:v>
                </c:pt>
                <c:pt idx="206">
                  <c:v>late</c:v>
                </c:pt>
                <c:pt idx="207">
                  <c:v>late</c:v>
                </c:pt>
                <c:pt idx="208">
                  <c:v>late</c:v>
                </c:pt>
                <c:pt idx="209">
                  <c:v>late</c:v>
                </c:pt>
                <c:pt idx="210">
                  <c:v>late</c:v>
                </c:pt>
                <c:pt idx="211">
                  <c:v>late</c:v>
                </c:pt>
                <c:pt idx="212">
                  <c:v>late</c:v>
                </c:pt>
                <c:pt idx="213">
                  <c:v>late</c:v>
                </c:pt>
                <c:pt idx="214">
                  <c:v>late</c:v>
                </c:pt>
                <c:pt idx="215">
                  <c:v>late</c:v>
                </c:pt>
                <c:pt idx="216">
                  <c:v>late</c:v>
                </c:pt>
                <c:pt idx="217">
                  <c:v>late</c:v>
                </c:pt>
                <c:pt idx="218">
                  <c:v>late</c:v>
                </c:pt>
                <c:pt idx="219">
                  <c:v>late</c:v>
                </c:pt>
                <c:pt idx="220">
                  <c:v>late</c:v>
                </c:pt>
                <c:pt idx="221">
                  <c:v>late</c:v>
                </c:pt>
                <c:pt idx="222">
                  <c:v>late</c:v>
                </c:pt>
                <c:pt idx="223">
                  <c:v>late</c:v>
                </c:pt>
                <c:pt idx="224">
                  <c:v>late</c:v>
                </c:pt>
                <c:pt idx="225">
                  <c:v>late</c:v>
                </c:pt>
                <c:pt idx="226">
                  <c:v>late</c:v>
                </c:pt>
                <c:pt idx="227">
                  <c:v>late</c:v>
                </c:pt>
                <c:pt idx="228">
                  <c:v>late</c:v>
                </c:pt>
                <c:pt idx="229">
                  <c:v>late</c:v>
                </c:pt>
                <c:pt idx="230">
                  <c:v>late</c:v>
                </c:pt>
                <c:pt idx="231">
                  <c:v>late</c:v>
                </c:pt>
                <c:pt idx="232">
                  <c:v>late</c:v>
                </c:pt>
                <c:pt idx="233">
                  <c:v>late</c:v>
                </c:pt>
                <c:pt idx="234">
                  <c:v>late</c:v>
                </c:pt>
                <c:pt idx="235">
                  <c:v>late</c:v>
                </c:pt>
                <c:pt idx="236">
                  <c:v>late</c:v>
                </c:pt>
                <c:pt idx="237">
                  <c:v>late</c:v>
                </c:pt>
                <c:pt idx="238">
                  <c:v>late</c:v>
                </c:pt>
                <c:pt idx="239">
                  <c:v>late</c:v>
                </c:pt>
                <c:pt idx="240">
                  <c:v>late</c:v>
                </c:pt>
              </c:strCache>
            </c:strRef>
          </c:cat>
          <c:val>
            <c:numRef>
              <c:f>Sheet1!$G$2:$G$242</c:f>
              <c:numCache>
                <c:formatCode>General</c:formatCode>
                <c:ptCount val="241"/>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2.7740794580000001</c:v>
                </c:pt>
                <c:pt idx="45">
                  <c:v>0</c:v>
                </c:pt>
                <c:pt idx="46">
                  <c:v>0</c:v>
                </c:pt>
                <c:pt idx="47">
                  <c:v>0</c:v>
                </c:pt>
                <c:pt idx="48">
                  <c:v>0</c:v>
                </c:pt>
                <c:pt idx="49">
                  <c:v>0</c:v>
                </c:pt>
                <c:pt idx="50">
                  <c:v>0</c:v>
                </c:pt>
                <c:pt idx="51">
                  <c:v>0</c:v>
                </c:pt>
                <c:pt idx="52">
                  <c:v>0</c:v>
                </c:pt>
                <c:pt idx="53">
                  <c:v>3.615163184</c:v>
                </c:pt>
                <c:pt idx="54">
                  <c:v>0</c:v>
                </c:pt>
                <c:pt idx="55">
                  <c:v>0</c:v>
                </c:pt>
                <c:pt idx="56">
                  <c:v>0</c:v>
                </c:pt>
                <c:pt idx="57">
                  <c:v>0</c:v>
                </c:pt>
                <c:pt idx="58">
                  <c:v>0</c:v>
                </c:pt>
                <c:pt idx="59">
                  <c:v>0</c:v>
                </c:pt>
                <c:pt idx="60">
                  <c:v>0</c:v>
                </c:pt>
                <c:pt idx="61">
                  <c:v>0</c:v>
                </c:pt>
                <c:pt idx="62">
                  <c:v>0</c:v>
                </c:pt>
                <c:pt idx="63">
                  <c:v>0</c:v>
                </c:pt>
                <c:pt idx="64">
                  <c:v>0</c:v>
                </c:pt>
                <c:pt idx="65">
                  <c:v>0</c:v>
                </c:pt>
                <c:pt idx="66">
                  <c:v>0</c:v>
                </c:pt>
                <c:pt idx="67">
                  <c:v>0</c:v>
                </c:pt>
                <c:pt idx="68">
                  <c:v>0</c:v>
                </c:pt>
                <c:pt idx="69">
                  <c:v>0</c:v>
                </c:pt>
                <c:pt idx="70">
                  <c:v>0</c:v>
                </c:pt>
                <c:pt idx="71">
                  <c:v>0</c:v>
                </c:pt>
                <c:pt idx="72">
                  <c:v>0</c:v>
                </c:pt>
                <c:pt idx="73">
                  <c:v>0</c:v>
                </c:pt>
                <c:pt idx="74">
                  <c:v>0</c:v>
                </c:pt>
                <c:pt idx="75">
                  <c:v>0</c:v>
                </c:pt>
                <c:pt idx="76">
                  <c:v>0</c:v>
                </c:pt>
                <c:pt idx="77">
                  <c:v>0</c:v>
                </c:pt>
                <c:pt idx="78">
                  <c:v>0</c:v>
                </c:pt>
                <c:pt idx="79">
                  <c:v>0</c:v>
                </c:pt>
                <c:pt idx="80">
                  <c:v>0</c:v>
                </c:pt>
                <c:pt idx="81">
                  <c:v>0</c:v>
                </c:pt>
                <c:pt idx="82">
                  <c:v>0</c:v>
                </c:pt>
                <c:pt idx="83">
                  <c:v>0</c:v>
                </c:pt>
                <c:pt idx="84">
                  <c:v>0</c:v>
                </c:pt>
                <c:pt idx="85">
                  <c:v>0</c:v>
                </c:pt>
                <c:pt idx="86">
                  <c:v>0</c:v>
                </c:pt>
                <c:pt idx="87">
                  <c:v>0</c:v>
                </c:pt>
                <c:pt idx="88">
                  <c:v>0</c:v>
                </c:pt>
                <c:pt idx="89">
                  <c:v>0</c:v>
                </c:pt>
                <c:pt idx="90">
                  <c:v>0</c:v>
                </c:pt>
                <c:pt idx="91">
                  <c:v>0</c:v>
                </c:pt>
                <c:pt idx="92">
                  <c:v>0</c:v>
                </c:pt>
                <c:pt idx="93">
                  <c:v>0</c:v>
                </c:pt>
                <c:pt idx="94">
                  <c:v>0</c:v>
                </c:pt>
                <c:pt idx="95">
                  <c:v>0</c:v>
                </c:pt>
                <c:pt idx="96">
                  <c:v>0</c:v>
                </c:pt>
                <c:pt idx="97">
                  <c:v>0</c:v>
                </c:pt>
                <c:pt idx="98">
                  <c:v>3.0788330309999998</c:v>
                </c:pt>
                <c:pt idx="99">
                  <c:v>0</c:v>
                </c:pt>
                <c:pt idx="100">
                  <c:v>0</c:v>
                </c:pt>
                <c:pt idx="101">
                  <c:v>0</c:v>
                </c:pt>
                <c:pt idx="102">
                  <c:v>0</c:v>
                </c:pt>
                <c:pt idx="103">
                  <c:v>0</c:v>
                </c:pt>
                <c:pt idx="104">
                  <c:v>0</c:v>
                </c:pt>
                <c:pt idx="105">
                  <c:v>0</c:v>
                </c:pt>
                <c:pt idx="106">
                  <c:v>3.1617325379999999</c:v>
                </c:pt>
                <c:pt idx="107">
                  <c:v>4.6943070420000002</c:v>
                </c:pt>
                <c:pt idx="108">
                  <c:v>0</c:v>
                </c:pt>
                <c:pt idx="109">
                  <c:v>3.230161941</c:v>
                </c:pt>
                <c:pt idx="110">
                  <c:v>0</c:v>
                </c:pt>
                <c:pt idx="111">
                  <c:v>0</c:v>
                </c:pt>
                <c:pt idx="112">
                  <c:v>3.6203400970000001</c:v>
                </c:pt>
                <c:pt idx="113">
                  <c:v>-0.58722451600000003</c:v>
                </c:pt>
                <c:pt idx="114">
                  <c:v>3.714439424</c:v>
                </c:pt>
                <c:pt idx="115">
                  <c:v>2.1132289999999999E-3</c:v>
                </c:pt>
                <c:pt idx="116">
                  <c:v>0</c:v>
                </c:pt>
                <c:pt idx="117">
                  <c:v>0</c:v>
                </c:pt>
                <c:pt idx="118">
                  <c:v>0</c:v>
                </c:pt>
                <c:pt idx="119">
                  <c:v>0</c:v>
                </c:pt>
                <c:pt idx="120">
                  <c:v>0</c:v>
                </c:pt>
                <c:pt idx="121">
                  <c:v>0</c:v>
                </c:pt>
                <c:pt idx="122">
                  <c:v>0</c:v>
                </c:pt>
                <c:pt idx="123">
                  <c:v>-0.266871417</c:v>
                </c:pt>
                <c:pt idx="124">
                  <c:v>0</c:v>
                </c:pt>
                <c:pt idx="125">
                  <c:v>-0.89831046299999995</c:v>
                </c:pt>
                <c:pt idx="126">
                  <c:v>-0.408617338</c:v>
                </c:pt>
                <c:pt idx="127">
                  <c:v>-0.332551286</c:v>
                </c:pt>
                <c:pt idx="128">
                  <c:v>0.431120958</c:v>
                </c:pt>
                <c:pt idx="129">
                  <c:v>0</c:v>
                </c:pt>
                <c:pt idx="130">
                  <c:v>0</c:v>
                </c:pt>
                <c:pt idx="131">
                  <c:v>0</c:v>
                </c:pt>
                <c:pt idx="132">
                  <c:v>5.6639242740000002</c:v>
                </c:pt>
                <c:pt idx="133">
                  <c:v>0</c:v>
                </c:pt>
                <c:pt idx="134">
                  <c:v>0</c:v>
                </c:pt>
                <c:pt idx="135">
                  <c:v>0.38849435100000002</c:v>
                </c:pt>
                <c:pt idx="136">
                  <c:v>1.180875766</c:v>
                </c:pt>
                <c:pt idx="137">
                  <c:v>3.5515142380000002</c:v>
                </c:pt>
                <c:pt idx="138">
                  <c:v>5.621816945</c:v>
                </c:pt>
                <c:pt idx="139">
                  <c:v>0</c:v>
                </c:pt>
                <c:pt idx="140">
                  <c:v>5.8164793750000001</c:v>
                </c:pt>
                <c:pt idx="141">
                  <c:v>1.0940649579999999</c:v>
                </c:pt>
                <c:pt idx="142">
                  <c:v>5.5221391420000003</c:v>
                </c:pt>
                <c:pt idx="143">
                  <c:v>0</c:v>
                </c:pt>
                <c:pt idx="144">
                  <c:v>0</c:v>
                </c:pt>
                <c:pt idx="145">
                  <c:v>3.2030382030000002</c:v>
                </c:pt>
                <c:pt idx="146">
                  <c:v>0</c:v>
                </c:pt>
                <c:pt idx="147">
                  <c:v>0</c:v>
                </c:pt>
                <c:pt idx="148">
                  <c:v>0</c:v>
                </c:pt>
                <c:pt idx="149">
                  <c:v>0</c:v>
                </c:pt>
                <c:pt idx="150">
                  <c:v>0</c:v>
                </c:pt>
                <c:pt idx="151">
                  <c:v>0</c:v>
                </c:pt>
                <c:pt idx="152">
                  <c:v>0</c:v>
                </c:pt>
                <c:pt idx="153">
                  <c:v>0</c:v>
                </c:pt>
                <c:pt idx="154">
                  <c:v>0</c:v>
                </c:pt>
                <c:pt idx="155">
                  <c:v>0</c:v>
                </c:pt>
                <c:pt idx="156">
                  <c:v>0</c:v>
                </c:pt>
                <c:pt idx="157">
                  <c:v>0</c:v>
                </c:pt>
                <c:pt idx="158">
                  <c:v>0</c:v>
                </c:pt>
                <c:pt idx="159">
                  <c:v>0</c:v>
                </c:pt>
                <c:pt idx="160">
                  <c:v>0</c:v>
                </c:pt>
                <c:pt idx="161">
                  <c:v>0</c:v>
                </c:pt>
                <c:pt idx="162">
                  <c:v>0</c:v>
                </c:pt>
                <c:pt idx="163">
                  <c:v>0</c:v>
                </c:pt>
                <c:pt idx="164">
                  <c:v>0</c:v>
                </c:pt>
                <c:pt idx="165">
                  <c:v>0</c:v>
                </c:pt>
                <c:pt idx="166">
                  <c:v>0</c:v>
                </c:pt>
                <c:pt idx="167">
                  <c:v>0</c:v>
                </c:pt>
                <c:pt idx="168">
                  <c:v>0</c:v>
                </c:pt>
                <c:pt idx="169">
                  <c:v>0</c:v>
                </c:pt>
                <c:pt idx="170">
                  <c:v>0</c:v>
                </c:pt>
                <c:pt idx="171">
                  <c:v>0</c:v>
                </c:pt>
                <c:pt idx="172">
                  <c:v>0</c:v>
                </c:pt>
                <c:pt idx="173">
                  <c:v>0</c:v>
                </c:pt>
                <c:pt idx="174">
                  <c:v>0</c:v>
                </c:pt>
                <c:pt idx="175">
                  <c:v>0</c:v>
                </c:pt>
                <c:pt idx="176">
                  <c:v>0</c:v>
                </c:pt>
                <c:pt idx="177">
                  <c:v>0</c:v>
                </c:pt>
                <c:pt idx="178">
                  <c:v>0</c:v>
                </c:pt>
                <c:pt idx="179">
                  <c:v>0</c:v>
                </c:pt>
                <c:pt idx="180">
                  <c:v>0</c:v>
                </c:pt>
                <c:pt idx="181">
                  <c:v>0</c:v>
                </c:pt>
                <c:pt idx="182">
                  <c:v>0</c:v>
                </c:pt>
                <c:pt idx="183">
                  <c:v>0</c:v>
                </c:pt>
                <c:pt idx="184">
                  <c:v>0</c:v>
                </c:pt>
                <c:pt idx="185">
                  <c:v>0</c:v>
                </c:pt>
                <c:pt idx="186">
                  <c:v>0</c:v>
                </c:pt>
                <c:pt idx="187">
                  <c:v>0</c:v>
                </c:pt>
                <c:pt idx="188">
                  <c:v>0</c:v>
                </c:pt>
                <c:pt idx="189">
                  <c:v>0</c:v>
                </c:pt>
                <c:pt idx="190">
                  <c:v>0</c:v>
                </c:pt>
                <c:pt idx="191">
                  <c:v>0</c:v>
                </c:pt>
                <c:pt idx="192">
                  <c:v>0</c:v>
                </c:pt>
                <c:pt idx="193">
                  <c:v>0</c:v>
                </c:pt>
                <c:pt idx="194">
                  <c:v>0</c:v>
                </c:pt>
                <c:pt idx="195">
                  <c:v>0</c:v>
                </c:pt>
                <c:pt idx="196">
                  <c:v>0</c:v>
                </c:pt>
                <c:pt idx="197">
                  <c:v>0</c:v>
                </c:pt>
                <c:pt idx="198">
                  <c:v>0</c:v>
                </c:pt>
                <c:pt idx="199">
                  <c:v>0</c:v>
                </c:pt>
                <c:pt idx="200">
                  <c:v>0</c:v>
                </c:pt>
                <c:pt idx="201">
                  <c:v>0</c:v>
                </c:pt>
                <c:pt idx="202">
                  <c:v>0</c:v>
                </c:pt>
                <c:pt idx="203">
                  <c:v>0</c:v>
                </c:pt>
                <c:pt idx="204">
                  <c:v>0</c:v>
                </c:pt>
                <c:pt idx="205">
                  <c:v>0</c:v>
                </c:pt>
                <c:pt idx="206">
                  <c:v>0</c:v>
                </c:pt>
                <c:pt idx="207">
                  <c:v>0</c:v>
                </c:pt>
                <c:pt idx="208">
                  <c:v>0</c:v>
                </c:pt>
                <c:pt idx="209">
                  <c:v>0</c:v>
                </c:pt>
                <c:pt idx="210">
                  <c:v>0</c:v>
                </c:pt>
                <c:pt idx="211">
                  <c:v>0</c:v>
                </c:pt>
                <c:pt idx="212">
                  <c:v>0</c:v>
                </c:pt>
                <c:pt idx="213">
                  <c:v>0</c:v>
                </c:pt>
                <c:pt idx="214">
                  <c:v>0</c:v>
                </c:pt>
                <c:pt idx="215">
                  <c:v>0</c:v>
                </c:pt>
                <c:pt idx="216">
                  <c:v>0</c:v>
                </c:pt>
                <c:pt idx="217">
                  <c:v>0</c:v>
                </c:pt>
                <c:pt idx="218">
                  <c:v>0</c:v>
                </c:pt>
                <c:pt idx="219">
                  <c:v>0</c:v>
                </c:pt>
                <c:pt idx="220">
                  <c:v>0</c:v>
                </c:pt>
                <c:pt idx="221">
                  <c:v>0</c:v>
                </c:pt>
                <c:pt idx="222">
                  <c:v>0</c:v>
                </c:pt>
                <c:pt idx="223">
                  <c:v>0</c:v>
                </c:pt>
                <c:pt idx="224">
                  <c:v>0</c:v>
                </c:pt>
                <c:pt idx="225">
                  <c:v>0</c:v>
                </c:pt>
                <c:pt idx="226">
                  <c:v>0</c:v>
                </c:pt>
                <c:pt idx="227">
                  <c:v>0</c:v>
                </c:pt>
                <c:pt idx="228">
                  <c:v>0</c:v>
                </c:pt>
                <c:pt idx="229">
                  <c:v>0</c:v>
                </c:pt>
                <c:pt idx="230">
                  <c:v>0</c:v>
                </c:pt>
                <c:pt idx="231">
                  <c:v>0</c:v>
                </c:pt>
                <c:pt idx="232">
                  <c:v>0</c:v>
                </c:pt>
                <c:pt idx="233">
                  <c:v>0</c:v>
                </c:pt>
                <c:pt idx="234">
                  <c:v>0</c:v>
                </c:pt>
                <c:pt idx="235">
                  <c:v>0</c:v>
                </c:pt>
                <c:pt idx="236">
                  <c:v>0</c:v>
                </c:pt>
                <c:pt idx="237">
                  <c:v>0</c:v>
                </c:pt>
                <c:pt idx="238">
                  <c:v>0</c:v>
                </c:pt>
                <c:pt idx="239">
                  <c:v>0</c:v>
                </c:pt>
                <c:pt idx="240">
                  <c:v>0</c:v>
                </c:pt>
              </c:numCache>
            </c:numRef>
          </c:val>
        </c:ser>
        <c:dLbls>
          <c:showLegendKey val="0"/>
          <c:showVal val="0"/>
          <c:showCatName val="0"/>
          <c:showSerName val="0"/>
          <c:showPercent val="0"/>
          <c:showBubbleSize val="0"/>
        </c:dLbls>
        <c:gapWidth val="150"/>
        <c:axId val="12985136"/>
        <c:axId val="265273192"/>
      </c:barChart>
      <c:catAx>
        <c:axId val="12985136"/>
        <c:scaling>
          <c:orientation val="minMax"/>
        </c:scaling>
        <c:delete val="0"/>
        <c:axPos val="b"/>
        <c:title>
          <c:tx>
            <c:rich>
              <a:bodyPr rot="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BLASTOCYST</a:t>
                </a:r>
                <a:r>
                  <a:rPr lang="en-US" sz="1800" b="1" baseline="0">
                    <a:solidFill>
                      <a:sysClr val="windowText" lastClr="000000"/>
                    </a:solidFill>
                  </a:rPr>
                  <a:t> STAGE</a:t>
                </a:r>
                <a:endParaRPr lang="en-US" sz="1800" b="1">
                  <a:solidFill>
                    <a:sysClr val="windowText" lastClr="000000"/>
                  </a:solidFill>
                </a:endParaRPr>
              </a:p>
            </c:rich>
          </c:tx>
          <c:layout/>
          <c:overlay val="0"/>
          <c:spPr>
            <a:noFill/>
            <a:ln>
              <a:noFill/>
            </a:ln>
            <a:effectLst/>
          </c:spPr>
          <c:txPr>
            <a:bodyPr rot="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crossAx val="265273192"/>
        <c:crosses val="autoZero"/>
        <c:auto val="1"/>
        <c:lblAlgn val="ctr"/>
        <c:lblOffset val="100"/>
        <c:tickLblSkip val="1"/>
        <c:noMultiLvlLbl val="0"/>
      </c:catAx>
      <c:valAx>
        <c:axId val="265273192"/>
        <c:scaling>
          <c:orientation val="minMax"/>
          <c:max val="25"/>
          <c:min val="-1"/>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r>
                  <a:rPr lang="en-US" sz="1600" b="1">
                    <a:solidFill>
                      <a:sysClr val="windowText" lastClr="000000"/>
                    </a:solidFill>
                  </a:rPr>
                  <a:t>RELATIVE</a:t>
                </a:r>
                <a:r>
                  <a:rPr lang="en-US" sz="1600" b="1" baseline="0">
                    <a:solidFill>
                      <a:sysClr val="windowText" lastClr="000000"/>
                    </a:solidFill>
                  </a:rPr>
                  <a:t> EXPRESSION</a:t>
                </a:r>
                <a:endParaRPr lang="en-US" sz="1600" b="1">
                  <a:solidFill>
                    <a:sysClr val="windowText" lastClr="000000"/>
                  </a:solidFill>
                </a:endParaRPr>
              </a:p>
            </c:rich>
          </c:tx>
          <c:layout>
            <c:manualLayout>
              <c:xMode val="edge"/>
              <c:yMode val="edge"/>
              <c:x val="8.795180333515085E-3"/>
              <c:y val="0.3653838142439868"/>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12985136"/>
        <c:crosses val="autoZero"/>
        <c:crossBetween val="between"/>
      </c:valAx>
      <c:spPr>
        <a:noFill/>
        <a:ln>
          <a:noFill/>
        </a:ln>
        <a:effectLst/>
      </c:spPr>
    </c:plotArea>
    <c:legend>
      <c:legendPos val="t"/>
      <c:layout/>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400" b="1" i="0" u="none" strike="noStrike" kern="1200" spc="0" baseline="0">
                <a:solidFill>
                  <a:sysClr val="windowText" lastClr="000000"/>
                </a:solidFill>
                <a:latin typeface="+mn-lt"/>
                <a:ea typeface="+mn-ea"/>
                <a:cs typeface="+mn-cs"/>
              </a:defRPr>
            </a:pPr>
            <a:r>
              <a:rPr lang="en-US" sz="2400" b="1">
                <a:solidFill>
                  <a:sysClr val="windowText" lastClr="000000"/>
                </a:solidFill>
              </a:rPr>
              <a:t>TERT-positive</a:t>
            </a:r>
            <a:r>
              <a:rPr lang="en-US" sz="2400" b="1" baseline="0">
                <a:solidFill>
                  <a:sysClr val="windowText" lastClr="000000"/>
                </a:solidFill>
              </a:rPr>
              <a:t> cells in blastocysts of human embryos</a:t>
            </a:r>
            <a:endParaRPr lang="en-US" sz="2400" b="1">
              <a:solidFill>
                <a:sysClr val="windowText" lastClr="000000"/>
              </a:solidFill>
            </a:endParaRPr>
          </a:p>
        </c:rich>
      </c:tx>
      <c:overlay val="0"/>
      <c:spPr>
        <a:noFill/>
        <a:ln>
          <a:noFill/>
        </a:ln>
        <a:effectLst/>
      </c:spPr>
      <c:txPr>
        <a:bodyPr rot="0" spcFirstLastPara="1" vertOverflow="ellipsis" vert="horz" wrap="square" anchor="ctr" anchorCtr="1"/>
        <a:lstStyle/>
        <a:p>
          <a:pPr>
            <a:defRPr sz="2400" b="1" i="0" u="none" strike="noStrike" kern="1200" spc="0" baseline="0">
              <a:solidFill>
                <a:sysClr val="windowText" lastClr="000000"/>
              </a:solidFill>
              <a:latin typeface="+mn-lt"/>
              <a:ea typeface="+mn-ea"/>
              <a:cs typeface="+mn-cs"/>
            </a:defRPr>
          </a:pPr>
          <a:endParaRPr lang="en-US"/>
        </a:p>
      </c:txPr>
    </c:title>
    <c:autoTitleDeleted val="0"/>
    <c:plotArea>
      <c:layout/>
      <c:areaChart>
        <c:grouping val="stacked"/>
        <c:varyColors val="0"/>
        <c:ser>
          <c:idx val="1"/>
          <c:order val="1"/>
          <c:tx>
            <c:strRef>
              <c:f>Sheet2!$A$27</c:f>
              <c:strCache>
                <c:ptCount val="1"/>
                <c:pt idx="0">
                  <c:v>Late Blastocysts</c:v>
                </c:pt>
              </c:strCache>
            </c:strRef>
          </c:tx>
          <c:spPr>
            <a:solidFill>
              <a:srgbClr val="FF0000"/>
            </a:solidFill>
            <a:ln>
              <a:noFill/>
            </a:ln>
            <a:effectLst/>
          </c:spPr>
          <c:dLbls>
            <c:dLbl>
              <c:idx val="0"/>
              <c:tx>
                <c:rich>
                  <a:bodyPr/>
                  <a:lstStyle/>
                  <a:p>
                    <a:fld id="{8042DB3B-8D07-4E5A-9432-D212F73A8C4F}" type="VALUE">
                      <a:rPr lang="en-US" smtClean="0"/>
                      <a:pPr/>
                      <a:t>[VALUE]</a:t>
                    </a:fld>
                    <a:r>
                      <a:rPr lang="en-US" smtClean="0"/>
                      <a:t>%</a:t>
                    </a:r>
                  </a:p>
                </c:rich>
              </c:tx>
              <c:showLegendKey val="0"/>
              <c:showVal val="1"/>
              <c:showCatName val="0"/>
              <c:showSerName val="0"/>
              <c:showPercent val="0"/>
              <c:showBubbleSize val="0"/>
              <c:extLst>
                <c:ext xmlns:c15="http://schemas.microsoft.com/office/drawing/2012/chart" uri="{CE6537A1-D6FC-4f65-9D91-7224C49458BB}">
                  <c15:dlblFieldTable/>
                  <c15:showDataLabelsRange val="0"/>
                </c:ext>
              </c:extLst>
            </c:dLbl>
            <c:spPr>
              <a:solidFill>
                <a:srgbClr val="FF0000"/>
              </a:solidFill>
              <a:ln w="12700">
                <a:solidFill>
                  <a:schemeClr val="tx1"/>
                </a:solidFill>
              </a:ln>
              <a:effectLst/>
            </c:spPr>
            <c:txPr>
              <a:bodyPr rot="0" spcFirstLastPara="1" vertOverflow="ellipsis" vert="horz" wrap="square" lIns="38100" tIns="19050" rIns="38100" bIns="19050" anchor="ctr" anchorCtr="1">
                <a:spAutoFit/>
              </a:bodyPr>
              <a:lstStyle/>
              <a:p>
                <a:pPr>
                  <a:defRPr sz="2400" b="1" i="0" u="none" strike="noStrike" kern="1200" baseline="0">
                    <a:solidFill>
                      <a:sysClr val="windowText" lastClr="000000"/>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2!$B$25:$C$25</c:f>
              <c:strCache>
                <c:ptCount val="2"/>
                <c:pt idx="0">
                  <c:v>Percent of TERT-positive cells</c:v>
                </c:pt>
                <c:pt idx="1">
                  <c:v>Number of TERT-positive cells</c:v>
                </c:pt>
              </c:strCache>
            </c:strRef>
          </c:cat>
          <c:val>
            <c:numRef>
              <c:f>Sheet2!$B$27:$C$27</c:f>
              <c:numCache>
                <c:formatCode>General</c:formatCode>
                <c:ptCount val="2"/>
                <c:pt idx="0" formatCode="0">
                  <c:v>11.111111111111111</c:v>
                </c:pt>
                <c:pt idx="1">
                  <c:v>17</c:v>
                </c:pt>
              </c:numCache>
            </c:numRef>
          </c:val>
        </c:ser>
        <c:dLbls>
          <c:showLegendKey val="0"/>
          <c:showVal val="1"/>
          <c:showCatName val="0"/>
          <c:showSerName val="0"/>
          <c:showPercent val="0"/>
          <c:showBubbleSize val="0"/>
        </c:dLbls>
        <c:axId val="297509304"/>
        <c:axId val="297512832"/>
      </c:areaChart>
      <c:barChart>
        <c:barDir val="col"/>
        <c:grouping val="clustered"/>
        <c:varyColors val="0"/>
        <c:ser>
          <c:idx val="0"/>
          <c:order val="0"/>
          <c:tx>
            <c:strRef>
              <c:f>Sheet2!$A$26</c:f>
              <c:strCache>
                <c:ptCount val="1"/>
                <c:pt idx="0">
                  <c:v>Early Blastocysts</c:v>
                </c:pt>
              </c:strCache>
            </c:strRef>
          </c:tx>
          <c:spPr>
            <a:solidFill>
              <a:schemeClr val="accent1"/>
            </a:solidFill>
            <a:ln>
              <a:noFill/>
            </a:ln>
            <a:effectLst/>
          </c:spPr>
          <c:invertIfNegative val="0"/>
          <c:dLbls>
            <c:dLbl>
              <c:idx val="0"/>
              <c:tx>
                <c:rich>
                  <a:bodyPr/>
                  <a:lstStyle/>
                  <a:p>
                    <a:fld id="{AEC3F0F2-ED66-4506-A0CC-CE7C17BD89BA}" type="VALUE">
                      <a:rPr lang="en-US" smtClean="0"/>
                      <a:pPr/>
                      <a:t>[VALUE]</a:t>
                    </a:fld>
                    <a:r>
                      <a:rPr lang="en-US" smtClean="0"/>
                      <a:t>%</a:t>
                    </a:r>
                  </a:p>
                </c:rich>
              </c:tx>
              <c:dLblPos val="inEnd"/>
              <c:showLegendKey val="0"/>
              <c:showVal val="1"/>
              <c:showCatName val="0"/>
              <c:showSerName val="0"/>
              <c:showPercent val="0"/>
              <c:showBubbleSize val="0"/>
              <c:extLst>
                <c:ext xmlns:c15="http://schemas.microsoft.com/office/drawing/2012/chart" uri="{CE6537A1-D6FC-4f65-9D91-7224C49458BB}">
                  <c15:dlblFieldTable/>
                  <c15:showDataLabelsRange val="0"/>
                </c:ext>
              </c:extLst>
            </c:dLbl>
            <c:spPr>
              <a:solidFill>
                <a:srgbClr val="00B0F0"/>
              </a:solidFill>
              <a:ln w="12700">
                <a:solidFill>
                  <a:schemeClr val="tx1"/>
                </a:solidFill>
              </a:ln>
              <a:effectLst/>
            </c:spPr>
            <c:txPr>
              <a:bodyPr rot="0" spcFirstLastPara="1" vertOverflow="ellipsis" vert="horz" wrap="square" lIns="38100" tIns="19050" rIns="38100" bIns="19050" anchor="ctr" anchorCtr="1">
                <a:spAutoFit/>
              </a:bodyPr>
              <a:lstStyle/>
              <a:p>
                <a:pPr>
                  <a:defRPr sz="2400" b="1" i="0" u="none" strike="noStrike" kern="1200" baseline="0">
                    <a:solidFill>
                      <a:sysClr val="windowText" lastClr="000000"/>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2!$B$25:$C$25</c:f>
              <c:strCache>
                <c:ptCount val="2"/>
                <c:pt idx="0">
                  <c:v>Percent of TERT-positive cells</c:v>
                </c:pt>
                <c:pt idx="1">
                  <c:v>Number of TERT-positive cells</c:v>
                </c:pt>
              </c:strCache>
            </c:strRef>
          </c:cat>
          <c:val>
            <c:numRef>
              <c:f>Sheet2!$B$26:$C$26</c:f>
              <c:numCache>
                <c:formatCode>General</c:formatCode>
                <c:ptCount val="2"/>
                <c:pt idx="0" formatCode="0">
                  <c:v>1.1363636363636365</c:v>
                </c:pt>
                <c:pt idx="1">
                  <c:v>1</c:v>
                </c:pt>
              </c:numCache>
            </c:numRef>
          </c:val>
        </c:ser>
        <c:dLbls>
          <c:showLegendKey val="0"/>
          <c:showVal val="1"/>
          <c:showCatName val="0"/>
          <c:showSerName val="0"/>
          <c:showPercent val="0"/>
          <c:showBubbleSize val="0"/>
        </c:dLbls>
        <c:gapWidth val="150"/>
        <c:overlap val="-25"/>
        <c:axId val="297509304"/>
        <c:axId val="297512832"/>
      </c:barChart>
      <c:catAx>
        <c:axId val="29750930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2000" b="1" i="0" u="none" strike="noStrike" kern="1200" baseline="0">
                <a:solidFill>
                  <a:schemeClr val="tx1"/>
                </a:solidFill>
                <a:latin typeface="+mn-lt"/>
                <a:ea typeface="+mn-ea"/>
                <a:cs typeface="+mn-cs"/>
              </a:defRPr>
            </a:pPr>
            <a:endParaRPr lang="en-US"/>
          </a:p>
        </c:txPr>
        <c:crossAx val="297512832"/>
        <c:crosses val="autoZero"/>
        <c:auto val="1"/>
        <c:lblAlgn val="ctr"/>
        <c:lblOffset val="100"/>
        <c:noMultiLvlLbl val="0"/>
      </c:catAx>
      <c:valAx>
        <c:axId val="297512832"/>
        <c:scaling>
          <c:orientation val="minMax"/>
        </c:scaling>
        <c:delete val="1"/>
        <c:axPos val="l"/>
        <c:numFmt formatCode="0" sourceLinked="1"/>
        <c:majorTickMark val="none"/>
        <c:minorTickMark val="none"/>
        <c:tickLblPos val="nextTo"/>
        <c:crossAx val="297509304"/>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2000" b="1" i="0" u="none" strike="noStrike" kern="1200" baseline="0">
              <a:solidFill>
                <a:sysClr val="windowText" lastClr="000000"/>
              </a:solidFill>
              <a:latin typeface="+mn-lt"/>
              <a:ea typeface="+mn-ea"/>
              <a:cs typeface="+mn-cs"/>
            </a:defRPr>
          </a:pPr>
          <a:endParaRPr lang="en-US"/>
        </a:p>
      </c:txPr>
    </c:legend>
    <c:plotVisOnly val="1"/>
    <c:dispBlanksAs val="gap"/>
    <c:showDLblsOverMax val="0"/>
  </c:chart>
  <c:spPr>
    <a:solidFill>
      <a:srgbClr val="FFFF00"/>
    </a:solidFill>
    <a:ln>
      <a:noFill/>
    </a:ln>
    <a:effectLst/>
  </c:spPr>
  <c:txPr>
    <a:bodyPr/>
    <a:lstStyle/>
    <a:p>
      <a:pPr>
        <a:defRPr/>
      </a:pPr>
      <a:endParaRPr lang="en-US"/>
    </a:p>
  </c:txPr>
  <c:externalData r:id="rId3">
    <c:autoUpdate val="0"/>
  </c:externalData>
  <c:userShapes r:id="rId4"/>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spc="0" baseline="0">
                <a:solidFill>
                  <a:schemeClr val="tx1"/>
                </a:solidFill>
                <a:latin typeface="+mn-lt"/>
                <a:ea typeface="+mn-ea"/>
                <a:cs typeface="+mn-cs"/>
              </a:defRPr>
            </a:pPr>
            <a:r>
              <a:rPr lang="en-US" dirty="0"/>
              <a:t>Cell identity GES of </a:t>
            </a:r>
            <a:r>
              <a:rPr lang="en-US" dirty="0" smtClean="0"/>
              <a:t>TERT-positive</a:t>
            </a:r>
            <a:r>
              <a:rPr lang="en-US" baseline="0" dirty="0" smtClean="0"/>
              <a:t> ground-state</a:t>
            </a:r>
            <a:r>
              <a:rPr lang="en-US" dirty="0" smtClean="0"/>
              <a:t> </a:t>
            </a:r>
            <a:r>
              <a:rPr lang="en-US" dirty="0"/>
              <a:t>precursor cells</a:t>
            </a:r>
          </a:p>
        </c:rich>
      </c:tx>
      <c:layout>
        <c:manualLayout>
          <c:xMode val="edge"/>
          <c:yMode val="edge"/>
          <c:x val="0.15927102036557478"/>
          <c:y val="0"/>
        </c:manualLayout>
      </c:layout>
      <c:overlay val="0"/>
      <c:spPr>
        <a:noFill/>
        <a:ln>
          <a:noFill/>
        </a:ln>
        <a:effectLst/>
      </c:spPr>
      <c:txPr>
        <a:bodyPr rot="0" spcFirstLastPara="1" vertOverflow="ellipsis" vert="horz" wrap="square" anchor="ctr" anchorCtr="1"/>
        <a:lstStyle/>
        <a:p>
          <a:pPr>
            <a:defRPr sz="1800" b="1" i="0" u="none" strike="noStrike" kern="1200" spc="0" baseline="0">
              <a:solidFill>
                <a:schemeClr val="tx1"/>
              </a:solidFill>
              <a:latin typeface="+mn-lt"/>
              <a:ea typeface="+mn-ea"/>
              <a:cs typeface="+mn-cs"/>
            </a:defRPr>
          </a:pPr>
          <a:endParaRPr lang="en-US"/>
        </a:p>
      </c:txPr>
    </c:title>
    <c:autoTitleDeleted val="0"/>
    <c:plotArea>
      <c:layout/>
      <c:radarChart>
        <c:radarStyle val="marker"/>
        <c:varyColors val="0"/>
        <c:ser>
          <c:idx val="0"/>
          <c:order val="0"/>
          <c:tx>
            <c:strRef>
              <c:f>Sheet2!$CU$1:$CU$2</c:f>
              <c:strCache>
                <c:ptCount val="2"/>
                <c:pt idx="0">
                  <c:v>Cell identity GES of TERT-positive multilineage precursor cells</c:v>
                </c:pt>
              </c:strCache>
            </c:strRef>
          </c:tx>
          <c:spPr>
            <a:ln w="50800" cap="rnd">
              <a:solidFill>
                <a:schemeClr val="accent1"/>
              </a:solidFill>
              <a:round/>
            </a:ln>
            <a:effectLst/>
          </c:spPr>
          <c:marker>
            <c:symbol val="none"/>
          </c:marker>
          <c:cat>
            <c:strRef>
              <c:f>Sheet2!$CT$3:$CT$62</c:f>
              <c:strCache>
                <c:ptCount val="60"/>
                <c:pt idx="0">
                  <c:v>GATA4</c:v>
                </c:pt>
                <c:pt idx="1">
                  <c:v>GRB7</c:v>
                </c:pt>
                <c:pt idx="2">
                  <c:v>HPAT7</c:v>
                </c:pt>
                <c:pt idx="3">
                  <c:v>HPAT9</c:v>
                </c:pt>
                <c:pt idx="4">
                  <c:v>HPAT20</c:v>
                </c:pt>
                <c:pt idx="5">
                  <c:v>HPAT4</c:v>
                </c:pt>
                <c:pt idx="6">
                  <c:v>HPAT6</c:v>
                </c:pt>
                <c:pt idx="7">
                  <c:v>HPAT17</c:v>
                </c:pt>
                <c:pt idx="8">
                  <c:v>HPAT14</c:v>
                </c:pt>
                <c:pt idx="9">
                  <c:v>LINC_ROR</c:v>
                </c:pt>
                <c:pt idx="10">
                  <c:v>SOX7</c:v>
                </c:pt>
                <c:pt idx="11">
                  <c:v>SOX17</c:v>
                </c:pt>
                <c:pt idx="12">
                  <c:v>PDGFRa</c:v>
                </c:pt>
                <c:pt idx="13">
                  <c:v>TET1</c:v>
                </c:pt>
                <c:pt idx="14">
                  <c:v>RAS</c:v>
                </c:pt>
                <c:pt idx="15">
                  <c:v>BMP4</c:v>
                </c:pt>
                <c:pt idx="16">
                  <c:v>LATS2</c:v>
                </c:pt>
                <c:pt idx="17">
                  <c:v>HPAT15</c:v>
                </c:pt>
                <c:pt idx="18">
                  <c:v>POU5F1</c:v>
                </c:pt>
                <c:pt idx="19">
                  <c:v>LMNB1</c:v>
                </c:pt>
                <c:pt idx="20">
                  <c:v>CD9</c:v>
                </c:pt>
                <c:pt idx="21">
                  <c:v>LEFTY2</c:v>
                </c:pt>
                <c:pt idx="22">
                  <c:v>LIN28A</c:v>
                </c:pt>
                <c:pt idx="23">
                  <c:v>TDGF1</c:v>
                </c:pt>
                <c:pt idx="24">
                  <c:v>FN1</c:v>
                </c:pt>
                <c:pt idx="25">
                  <c:v>HPAT5</c:v>
                </c:pt>
                <c:pt idx="26">
                  <c:v>EpCAM</c:v>
                </c:pt>
                <c:pt idx="27">
                  <c:v>TEAD4</c:v>
                </c:pt>
                <c:pt idx="28">
                  <c:v>BPTF</c:v>
                </c:pt>
                <c:pt idx="29">
                  <c:v>P300</c:v>
                </c:pt>
                <c:pt idx="30">
                  <c:v>MCRS1</c:v>
                </c:pt>
                <c:pt idx="31">
                  <c:v>HP1</c:v>
                </c:pt>
                <c:pt idx="32">
                  <c:v>TAF1</c:v>
                </c:pt>
                <c:pt idx="33">
                  <c:v>MAPK1</c:v>
                </c:pt>
                <c:pt idx="34">
                  <c:v>YAP</c:v>
                </c:pt>
                <c:pt idx="35">
                  <c:v>CDX2</c:v>
                </c:pt>
                <c:pt idx="36">
                  <c:v>TROP2</c:v>
                </c:pt>
                <c:pt idx="37">
                  <c:v>CXCR4</c:v>
                </c:pt>
                <c:pt idx="38">
                  <c:v>DNMT1</c:v>
                </c:pt>
                <c:pt idx="39">
                  <c:v>GLP</c:v>
                </c:pt>
                <c:pt idx="40">
                  <c:v>G9A</c:v>
                </c:pt>
                <c:pt idx="41">
                  <c:v>EZH2</c:v>
                </c:pt>
                <c:pt idx="42">
                  <c:v>JARID2</c:v>
                </c:pt>
                <c:pt idx="43">
                  <c:v>KDM3B</c:v>
                </c:pt>
                <c:pt idx="44">
                  <c:v>TET2</c:v>
                </c:pt>
                <c:pt idx="45">
                  <c:v>HPAT2</c:v>
                </c:pt>
                <c:pt idx="46">
                  <c:v>DNMT3B</c:v>
                </c:pt>
                <c:pt idx="47">
                  <c:v>SOX2</c:v>
                </c:pt>
                <c:pt idx="48">
                  <c:v>TFCP2L1</c:v>
                </c:pt>
                <c:pt idx="49">
                  <c:v>LAMC1</c:v>
                </c:pt>
                <c:pt idx="50">
                  <c:v>EED</c:v>
                </c:pt>
                <c:pt idx="51">
                  <c:v>MBD3</c:v>
                </c:pt>
                <c:pt idx="52">
                  <c:v>BRG1</c:v>
                </c:pt>
                <c:pt idx="53">
                  <c:v>WDR5</c:v>
                </c:pt>
                <c:pt idx="54">
                  <c:v>E_CADHERIN</c:v>
                </c:pt>
                <c:pt idx="55">
                  <c:v>PRDM14</c:v>
                </c:pt>
                <c:pt idx="56">
                  <c:v>MLL2</c:v>
                </c:pt>
                <c:pt idx="57">
                  <c:v>HPAT21</c:v>
                </c:pt>
                <c:pt idx="58">
                  <c:v>TERT</c:v>
                </c:pt>
                <c:pt idx="59">
                  <c:v>KLF5</c:v>
                </c:pt>
              </c:strCache>
            </c:strRef>
          </c:cat>
          <c:val>
            <c:numRef>
              <c:f>Sheet2!$CU$3:$CU$62</c:f>
              <c:numCache>
                <c:formatCode>0</c:formatCode>
                <c:ptCount val="60"/>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66.666666666666657</c:v>
                </c:pt>
                <c:pt idx="18">
                  <c:v>66.666666666666657</c:v>
                </c:pt>
                <c:pt idx="19">
                  <c:v>66.666666666666657</c:v>
                </c:pt>
                <c:pt idx="20">
                  <c:v>72.222222222222214</c:v>
                </c:pt>
                <c:pt idx="21">
                  <c:v>72.222222222222214</c:v>
                </c:pt>
                <c:pt idx="22">
                  <c:v>77.777777777777786</c:v>
                </c:pt>
                <c:pt idx="23">
                  <c:v>77.777777777777786</c:v>
                </c:pt>
                <c:pt idx="24">
                  <c:v>77.777777777777786</c:v>
                </c:pt>
                <c:pt idx="25">
                  <c:v>77.777777777777786</c:v>
                </c:pt>
                <c:pt idx="26">
                  <c:v>77.777777777777786</c:v>
                </c:pt>
                <c:pt idx="27">
                  <c:v>77.777777777777786</c:v>
                </c:pt>
                <c:pt idx="28">
                  <c:v>77.777777777777786</c:v>
                </c:pt>
                <c:pt idx="29">
                  <c:v>77.777777777777786</c:v>
                </c:pt>
                <c:pt idx="30">
                  <c:v>77.777777777777786</c:v>
                </c:pt>
                <c:pt idx="31">
                  <c:v>77.777777777777786</c:v>
                </c:pt>
                <c:pt idx="32">
                  <c:v>77.777777777777786</c:v>
                </c:pt>
                <c:pt idx="33">
                  <c:v>77.777777777777786</c:v>
                </c:pt>
                <c:pt idx="34">
                  <c:v>77.777777777777786</c:v>
                </c:pt>
                <c:pt idx="35">
                  <c:v>83.333333333333343</c:v>
                </c:pt>
                <c:pt idx="36">
                  <c:v>83.333333333333343</c:v>
                </c:pt>
                <c:pt idx="37">
                  <c:v>83.333333333333343</c:v>
                </c:pt>
                <c:pt idx="38">
                  <c:v>83.333333333333343</c:v>
                </c:pt>
                <c:pt idx="39">
                  <c:v>83.333333333333343</c:v>
                </c:pt>
                <c:pt idx="40">
                  <c:v>83.333333333333343</c:v>
                </c:pt>
                <c:pt idx="41">
                  <c:v>83.333333333333343</c:v>
                </c:pt>
                <c:pt idx="42">
                  <c:v>83.333333333333343</c:v>
                </c:pt>
                <c:pt idx="43">
                  <c:v>83.333333333333343</c:v>
                </c:pt>
                <c:pt idx="44">
                  <c:v>83.333333333333343</c:v>
                </c:pt>
                <c:pt idx="45">
                  <c:v>88.888888888888886</c:v>
                </c:pt>
                <c:pt idx="46">
                  <c:v>88.888888888888886</c:v>
                </c:pt>
                <c:pt idx="47">
                  <c:v>88.888888888888886</c:v>
                </c:pt>
                <c:pt idx="48">
                  <c:v>88.888888888888886</c:v>
                </c:pt>
                <c:pt idx="49">
                  <c:v>88.888888888888886</c:v>
                </c:pt>
                <c:pt idx="50">
                  <c:v>88.888888888888886</c:v>
                </c:pt>
                <c:pt idx="51">
                  <c:v>88.888888888888886</c:v>
                </c:pt>
                <c:pt idx="52">
                  <c:v>88.888888888888886</c:v>
                </c:pt>
                <c:pt idx="53">
                  <c:v>88.888888888888886</c:v>
                </c:pt>
                <c:pt idx="54">
                  <c:v>88.888888888888886</c:v>
                </c:pt>
                <c:pt idx="55">
                  <c:v>88.888888888888886</c:v>
                </c:pt>
                <c:pt idx="56">
                  <c:v>94.444444444444443</c:v>
                </c:pt>
                <c:pt idx="57">
                  <c:v>100</c:v>
                </c:pt>
                <c:pt idx="58">
                  <c:v>100</c:v>
                </c:pt>
                <c:pt idx="59">
                  <c:v>100</c:v>
                </c:pt>
              </c:numCache>
            </c:numRef>
          </c:val>
        </c:ser>
        <c:dLbls>
          <c:showLegendKey val="0"/>
          <c:showVal val="0"/>
          <c:showCatName val="0"/>
          <c:showSerName val="0"/>
          <c:showPercent val="0"/>
          <c:showBubbleSize val="0"/>
        </c:dLbls>
        <c:axId val="297514400"/>
        <c:axId val="297511264"/>
      </c:radarChart>
      <c:catAx>
        <c:axId val="2975144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297511264"/>
        <c:crosses val="autoZero"/>
        <c:auto val="1"/>
        <c:lblAlgn val="ctr"/>
        <c:lblOffset val="100"/>
        <c:noMultiLvlLbl val="0"/>
      </c:catAx>
      <c:valAx>
        <c:axId val="297511264"/>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29751440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spc="0" baseline="0">
                <a:solidFill>
                  <a:schemeClr val="tx1"/>
                </a:solidFill>
                <a:latin typeface="+mn-lt"/>
                <a:ea typeface="+mn-ea"/>
                <a:cs typeface="+mn-cs"/>
              </a:defRPr>
            </a:pPr>
            <a:r>
              <a:rPr lang="en-US" dirty="0">
                <a:solidFill>
                  <a:schemeClr val="tx1"/>
                </a:solidFill>
              </a:rPr>
              <a:t>Cell identity GES of TERT-positive </a:t>
            </a:r>
            <a:r>
              <a:rPr lang="en-US" dirty="0" smtClean="0">
                <a:solidFill>
                  <a:schemeClr val="tx1"/>
                </a:solidFill>
              </a:rPr>
              <a:t>ground-state </a:t>
            </a:r>
            <a:r>
              <a:rPr lang="en-US" dirty="0">
                <a:solidFill>
                  <a:schemeClr val="tx1"/>
                </a:solidFill>
              </a:rPr>
              <a:t>precursor cells</a:t>
            </a:r>
          </a:p>
        </c:rich>
      </c:tx>
      <c:overlay val="0"/>
      <c:spPr>
        <a:noFill/>
        <a:ln>
          <a:noFill/>
        </a:ln>
        <a:effectLst/>
      </c:spPr>
      <c:txPr>
        <a:bodyPr rot="0" spcFirstLastPara="1" vertOverflow="ellipsis" vert="horz" wrap="square" anchor="ctr" anchorCtr="1"/>
        <a:lstStyle/>
        <a:p>
          <a:pPr>
            <a:defRPr sz="1800" b="1" i="0" u="none" strike="noStrike" kern="1200" spc="0" baseline="0">
              <a:solidFill>
                <a:schemeClr val="tx1"/>
              </a:solidFill>
              <a:latin typeface="+mn-lt"/>
              <a:ea typeface="+mn-ea"/>
              <a:cs typeface="+mn-cs"/>
            </a:defRPr>
          </a:pPr>
          <a:endParaRPr lang="en-US"/>
        </a:p>
      </c:txPr>
    </c:title>
    <c:autoTitleDeleted val="0"/>
    <c:plotArea>
      <c:layout/>
      <c:barChart>
        <c:barDir val="bar"/>
        <c:grouping val="clustered"/>
        <c:varyColors val="0"/>
        <c:ser>
          <c:idx val="0"/>
          <c:order val="0"/>
          <c:tx>
            <c:strRef>
              <c:f>Sheet2!$CY$1:$CY$2</c:f>
              <c:strCache>
                <c:ptCount val="2"/>
                <c:pt idx="0">
                  <c:v>Cell identity GES of TERT-positive multilineage precursor cells</c:v>
                </c:pt>
              </c:strCache>
            </c:strRef>
          </c:tx>
          <c:spPr>
            <a:solidFill>
              <a:schemeClr val="accent1"/>
            </a:solidFill>
            <a:ln>
              <a:noFill/>
            </a:ln>
            <a:effectLst/>
          </c:spPr>
          <c:invertIfNegative val="0"/>
          <c:cat>
            <c:strRef>
              <c:f>Sheet2!$CX$3:$CX$26</c:f>
              <c:strCache>
                <c:ptCount val="24"/>
                <c:pt idx="0">
                  <c:v>HPAT1</c:v>
                </c:pt>
                <c:pt idx="1">
                  <c:v>REST</c:v>
                </c:pt>
                <c:pt idx="2">
                  <c:v>GATA6</c:v>
                </c:pt>
                <c:pt idx="3">
                  <c:v>THAP11</c:v>
                </c:pt>
                <c:pt idx="4">
                  <c:v>MAPK3</c:v>
                </c:pt>
                <c:pt idx="5">
                  <c:v>SALL4</c:v>
                </c:pt>
                <c:pt idx="6">
                  <c:v>GDF3</c:v>
                </c:pt>
                <c:pt idx="7">
                  <c:v>HPAT8</c:v>
                </c:pt>
                <c:pt idx="8">
                  <c:v>HPAT23</c:v>
                </c:pt>
                <c:pt idx="9">
                  <c:v>EOMES</c:v>
                </c:pt>
                <c:pt idx="10">
                  <c:v>ID2</c:v>
                </c:pt>
                <c:pt idx="11">
                  <c:v>NANOG</c:v>
                </c:pt>
                <c:pt idx="12">
                  <c:v>UTF1</c:v>
                </c:pt>
                <c:pt idx="13">
                  <c:v>DPPA3</c:v>
                </c:pt>
                <c:pt idx="14">
                  <c:v>FGFR2</c:v>
                </c:pt>
                <c:pt idx="15">
                  <c:v>GRB2</c:v>
                </c:pt>
                <c:pt idx="16">
                  <c:v>CBX7</c:v>
                </c:pt>
                <c:pt idx="17">
                  <c:v>ZFP42</c:v>
                </c:pt>
                <c:pt idx="18">
                  <c:v>KRT7</c:v>
                </c:pt>
                <c:pt idx="19">
                  <c:v>SNF2H</c:v>
                </c:pt>
                <c:pt idx="20">
                  <c:v>CDKN2A</c:v>
                </c:pt>
                <c:pt idx="21">
                  <c:v>HPAT3</c:v>
                </c:pt>
                <c:pt idx="22">
                  <c:v>TET3</c:v>
                </c:pt>
                <c:pt idx="23">
                  <c:v>WNT1</c:v>
                </c:pt>
              </c:strCache>
            </c:strRef>
          </c:cat>
          <c:val>
            <c:numRef>
              <c:f>Sheet2!$CY$3:$CY$26</c:f>
              <c:numCache>
                <c:formatCode>0</c:formatCode>
                <c:ptCount val="24"/>
                <c:pt idx="0">
                  <c:v>5.5555555555555554</c:v>
                </c:pt>
                <c:pt idx="1">
                  <c:v>5.5555555555555554</c:v>
                </c:pt>
                <c:pt idx="2">
                  <c:v>5.5555555555555554</c:v>
                </c:pt>
                <c:pt idx="3">
                  <c:v>5.5555555555555554</c:v>
                </c:pt>
                <c:pt idx="4">
                  <c:v>16.666666666666664</c:v>
                </c:pt>
                <c:pt idx="5">
                  <c:v>22.222222222222221</c:v>
                </c:pt>
                <c:pt idx="6">
                  <c:v>22.222222222222221</c:v>
                </c:pt>
                <c:pt idx="7">
                  <c:v>22.222222222222221</c:v>
                </c:pt>
                <c:pt idx="8">
                  <c:v>22.222222222222221</c:v>
                </c:pt>
                <c:pt idx="9">
                  <c:v>22.222222222222221</c:v>
                </c:pt>
                <c:pt idx="10">
                  <c:v>22.222222222222221</c:v>
                </c:pt>
                <c:pt idx="11">
                  <c:v>27.777777777777779</c:v>
                </c:pt>
                <c:pt idx="12">
                  <c:v>27.777777777777779</c:v>
                </c:pt>
                <c:pt idx="13">
                  <c:v>27.777777777777779</c:v>
                </c:pt>
                <c:pt idx="14">
                  <c:v>27.777777777777779</c:v>
                </c:pt>
                <c:pt idx="15">
                  <c:v>27.777777777777779</c:v>
                </c:pt>
                <c:pt idx="16">
                  <c:v>27.777777777777779</c:v>
                </c:pt>
                <c:pt idx="17">
                  <c:v>33.333333333333329</c:v>
                </c:pt>
                <c:pt idx="18">
                  <c:v>38.888888888888893</c:v>
                </c:pt>
                <c:pt idx="19">
                  <c:v>50</c:v>
                </c:pt>
                <c:pt idx="20">
                  <c:v>50</c:v>
                </c:pt>
                <c:pt idx="21">
                  <c:v>55.555555555555557</c:v>
                </c:pt>
                <c:pt idx="22">
                  <c:v>55.555555555555557</c:v>
                </c:pt>
                <c:pt idx="23">
                  <c:v>55.555555555555557</c:v>
                </c:pt>
              </c:numCache>
            </c:numRef>
          </c:val>
        </c:ser>
        <c:dLbls>
          <c:showLegendKey val="0"/>
          <c:showVal val="0"/>
          <c:showCatName val="0"/>
          <c:showSerName val="0"/>
          <c:showPercent val="0"/>
          <c:showBubbleSize val="0"/>
        </c:dLbls>
        <c:gapWidth val="150"/>
        <c:axId val="314296968"/>
        <c:axId val="314301280"/>
      </c:barChart>
      <c:catAx>
        <c:axId val="314296968"/>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mn-lt"/>
                <a:ea typeface="+mn-ea"/>
                <a:cs typeface="+mn-cs"/>
              </a:defRPr>
            </a:pPr>
            <a:endParaRPr lang="en-US"/>
          </a:p>
        </c:txPr>
        <c:crossAx val="314301280"/>
        <c:crosses val="autoZero"/>
        <c:auto val="1"/>
        <c:lblAlgn val="ctr"/>
        <c:lblOffset val="100"/>
        <c:noMultiLvlLbl val="0"/>
      </c:catAx>
      <c:valAx>
        <c:axId val="314301280"/>
        <c:scaling>
          <c:orientation val="minMax"/>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Percent</a:t>
                </a:r>
                <a:r>
                  <a:rPr lang="en-US" sz="1800" b="1" baseline="0">
                    <a:solidFill>
                      <a:sysClr val="windowText" lastClr="000000"/>
                    </a:solidFill>
                  </a:rPr>
                  <a:t> of positive cells</a:t>
                </a:r>
                <a:endParaRPr lang="en-US" sz="1800" b="1">
                  <a:solidFill>
                    <a:sysClr val="windowText" lastClr="000000"/>
                  </a:solidFill>
                </a:endParaRPr>
              </a:p>
            </c:rich>
          </c:tx>
          <c:overlay val="0"/>
          <c:spPr>
            <a:noFill/>
            <a:ln>
              <a:noFill/>
            </a:ln>
            <a:effectLst/>
          </c:spPr>
          <c:txPr>
            <a:bodyPr rot="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mn-lt"/>
                <a:ea typeface="+mn-ea"/>
                <a:cs typeface="+mn-cs"/>
              </a:defRPr>
            </a:pPr>
            <a:endParaRPr lang="en-US"/>
          </a:p>
        </c:txPr>
        <c:crossAx val="31429696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2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31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40512</cdr:x>
      <cdr:y>0.21369</cdr:y>
    </cdr:from>
    <cdr:to>
      <cdr:x>0.57078</cdr:x>
      <cdr:y>0.28631</cdr:y>
    </cdr:to>
    <cdr:sp macro="" textlink="">
      <cdr:nvSpPr>
        <cdr:cNvPr id="2" name="TextBox 1"/>
        <cdr:cNvSpPr txBox="1"/>
      </cdr:nvSpPr>
      <cdr:spPr>
        <a:xfrm xmlns:a="http://schemas.openxmlformats.org/drawingml/2006/main">
          <a:off x="3509896" y="1343938"/>
          <a:ext cx="1435275" cy="456678"/>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sz="2400" b="1"/>
            <a:t>p = 0.0039</a:t>
          </a:r>
        </a:p>
      </cdr:txBody>
    </cdr:sp>
  </cdr:relSizeAnchor>
</c:userShapes>
</file>

<file path=ppt/notesMasters/_rels/notesMaster1.xml.rels><?xml version = '1.0' encoding = 'UTF-8' standalone = 'yes'?>
<Relationships xmlns="http://schemas.openxmlformats.org/package/2006/relationships">
   <Relationship Id="rId1" Type="http://schemas.openxmlformats.org/officeDocument/2006/relationships/theme" Target="../theme/theme2.xml"/>
</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BA0860-CD0F-4111-A88D-97823E48FAA2}" type="datetimeFigureOut">
              <a:rPr lang="en-US" smtClean="0"/>
              <a:t>5/31/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26E606-3D27-4AB1-8873-A0DD79BBB60F}" type="slidenum">
              <a:rPr lang="en-US" smtClean="0"/>
              <a:t>‹#›</a:t>
            </a:fld>
            <a:endParaRPr lang="en-US"/>
          </a:p>
        </p:txBody>
      </p:sp>
    </p:spTree>
    <p:extLst>
      <p:ext uri="{BB962C8B-B14F-4D97-AF65-F5344CB8AC3E}">
        <p14:creationId xmlns:p14="http://schemas.microsoft.com/office/powerpoint/2010/main" val="18211197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 = '1.0' encoding = 'UTF-8' standalone = 'yes'?>
<Relationships xmlns="http://schemas.openxmlformats.org/package/2006/relationships">
   <Relationship Id="rId1" Type="http://schemas.openxmlformats.org/officeDocument/2006/relationships/notesMaster" Target="../notesMasters/notesMaster1.xml"/>
   <Relationship Id="rId2" Type="http://schemas.openxmlformats.org/officeDocument/2006/relationships/slide" Target="../slides/slide4.xml"/>
</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tars, 8 </a:t>
            </a:r>
            <a:r>
              <a:rPr lang="en-US" dirty="0" err="1" smtClean="0"/>
              <a:t>lncRNAs</a:t>
            </a:r>
            <a:r>
              <a:rPr lang="en-US" dirty="0" smtClean="0"/>
              <a:t> expressed in TERT (+) ground-state precursor cells; pluripotency regulators, inducers, and markers; Right brace, 8 </a:t>
            </a:r>
            <a:r>
              <a:rPr lang="en-US" dirty="0" err="1" smtClean="0"/>
              <a:t>lncRNAs</a:t>
            </a:r>
            <a:r>
              <a:rPr lang="en-US" dirty="0" smtClean="0"/>
              <a:t> repressed</a:t>
            </a:r>
            <a:r>
              <a:rPr lang="en-US" baseline="0" dirty="0" smtClean="0"/>
              <a:t> in ground-state precursor cells</a:t>
            </a:r>
            <a:endParaRPr lang="en-US" dirty="0"/>
          </a:p>
        </p:txBody>
      </p:sp>
      <p:sp>
        <p:nvSpPr>
          <p:cNvPr id="4" name="Slide Number Placeholder 3"/>
          <p:cNvSpPr>
            <a:spLocks noGrp="1"/>
          </p:cNvSpPr>
          <p:nvPr>
            <p:ph type="sldNum" sz="quarter" idx="10"/>
          </p:nvPr>
        </p:nvSpPr>
        <p:spPr/>
        <p:txBody>
          <a:bodyPr/>
          <a:lstStyle/>
          <a:p>
            <a:fld id="{9426E606-3D27-4AB1-8873-A0DD79BBB60F}" type="slidenum">
              <a:rPr lang="en-US" smtClean="0"/>
              <a:t>4</a:t>
            </a:fld>
            <a:endParaRPr lang="en-US"/>
          </a:p>
        </p:txBody>
      </p:sp>
    </p:spTree>
    <p:extLst>
      <p:ext uri="{BB962C8B-B14F-4D97-AF65-F5344CB8AC3E}">
        <p14:creationId xmlns:p14="http://schemas.microsoft.com/office/powerpoint/2010/main" val="3886266761"/>
      </p:ext>
    </p:extLst>
  </p:cSld>
  <p:clrMapOvr>
    <a:masterClrMapping/>
  </p:clrMapOvr>
</p:notes>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2538569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1358049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363584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726812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2939024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254881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65C0C0-B12A-4BA8-8A83-1D012D019158}" type="datetimeFigureOut">
              <a:rPr lang="en-US" smtClean="0"/>
              <a:t>5/3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710651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65C0C0-B12A-4BA8-8A83-1D012D019158}" type="datetimeFigureOut">
              <a:rPr lang="en-US" smtClean="0"/>
              <a:t>5/3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001237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65C0C0-B12A-4BA8-8A83-1D012D019158}" type="datetimeFigureOut">
              <a:rPr lang="en-US" smtClean="0"/>
              <a:t>5/3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533466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8526337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379744470"/>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865C0C0-B12A-4BA8-8A83-1D012D019158}" type="datetimeFigureOut">
              <a:rPr lang="en-US" smtClean="0"/>
              <a:t>5/31/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BCB4C7F-67AB-4CD2-85B5-72AB5B0D54BD}" type="slidenum">
              <a:rPr lang="en-US" smtClean="0"/>
              <a:t>‹#›</a:t>
            </a:fld>
            <a:endParaRPr lang="en-US"/>
          </a:p>
        </p:txBody>
      </p:sp>
    </p:spTree>
    <p:extLst>
      <p:ext uri="{BB962C8B-B14F-4D97-AF65-F5344CB8AC3E}">
        <p14:creationId xmlns:p14="http://schemas.microsoft.com/office/powerpoint/2010/main" val="1980844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hyperlink" TargetMode="External" Target="http://web.stanford.edu/~sunilpai/HumanBlastocystViewer.html"/>
</Relationships>
</file>

<file path=ppt/slides/_rels/slide2.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1.xml"/>
</Relationships>
</file>

<file path=ppt/slides/_rels/slide3.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2.xml"/>
</Relationships>
</file>

<file path=ppt/slides/_rels/slide4.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notesSlide" Target="../notesSlides/notesSlide1.xml"/>
   <Relationship Id="rId3" Type="http://schemas.openxmlformats.org/officeDocument/2006/relationships/chart" Target="../charts/chart3.xml"/>
</Relationships>
</file>

<file path=ppt/slides/_rels/slide5.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4.xml"/>
</Relationships>
</file>

<file path=ppt/slides/_rels/slide6.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1.TIF"/>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239886"/>
            <a:ext cx="12037324" cy="6376104"/>
          </a:xfrm>
          <a:prstGeom prst="rect">
            <a:avLst/>
          </a:prstGeom>
        </p:spPr>
        <p:txBody>
          <a:bodyPr wrap="square">
            <a:spAutoFit/>
          </a:bodyPr>
          <a:lstStyle/>
          <a:p>
            <a:pPr algn="ctr">
              <a:spcAft>
                <a:spcPts val="1000"/>
              </a:spcAft>
            </a:pPr>
            <a:r>
              <a:rPr lang="en-US" sz="1600" b="1" dirty="0">
                <a:latin typeface="Arial" panose="020B0604020202020204" pitchFamily="34" charset="0"/>
                <a:ea typeface="Calibri" panose="020F0502020204030204" pitchFamily="34" charset="0"/>
                <a:cs typeface="Arial" panose="020B0604020202020204" pitchFamily="34" charset="0"/>
              </a:rPr>
              <a:t>Supplemental Figure S4.</a:t>
            </a:r>
            <a:r>
              <a:rPr lang="en-US" sz="1600" dirty="0">
                <a:latin typeface="Arial" panose="020B0604020202020204" pitchFamily="34" charset="0"/>
                <a:ea typeface="Calibri" panose="020F0502020204030204" pitchFamily="34" charset="0"/>
                <a:cs typeface="Arial" panose="020B0604020202020204" pitchFamily="34" charset="0"/>
              </a:rPr>
              <a:t> Identification and characterization of telomerase-positive MLME cells created during human blastocyst differentiation.</a:t>
            </a:r>
            <a:r>
              <a:rPr lang="en-US" sz="1600" b="1" dirty="0">
                <a:latin typeface="Arial" panose="020B0604020202020204" pitchFamily="34" charset="0"/>
                <a:ea typeface="Calibri" panose="020F0502020204030204" pitchFamily="34" charset="0"/>
                <a:cs typeface="Arial" panose="020B0604020202020204" pitchFamily="34" charset="0"/>
              </a:rPr>
              <a:t> </a:t>
            </a:r>
            <a:endParaRPr lang="en-US" sz="1600" dirty="0">
              <a:latin typeface="Arial" panose="020B0604020202020204" pitchFamily="34" charset="0"/>
              <a:ea typeface="Calibri" panose="020F0502020204030204" pitchFamily="34" charset="0"/>
              <a:cs typeface="Arial" panose="020B0604020202020204" pitchFamily="34" charset="0"/>
            </a:endParaRPr>
          </a:p>
          <a:p>
            <a:pPr marL="342900" marR="0" lvl="0" indent="-342900" algn="ctr">
              <a:spcBef>
                <a:spcPts val="0"/>
              </a:spcBef>
              <a:spcAft>
                <a:spcPts val="0"/>
              </a:spcAft>
              <a:buFont typeface="Helvetica" panose="020B0604020202020204" pitchFamily="34" charset="0"/>
              <a:buAutoNum type="alphaUcParenBoth"/>
            </a:pPr>
            <a:r>
              <a:rPr lang="en-US" sz="1600" dirty="0">
                <a:latin typeface="Arial" panose="020B0604020202020204" pitchFamily="34" charset="0"/>
                <a:ea typeface="Calibri" panose="020F0502020204030204" pitchFamily="34" charset="0"/>
                <a:cs typeface="Arial" panose="020B0604020202020204" pitchFamily="34" charset="0"/>
              </a:rPr>
              <a:t>Expression profiles of the human telomerase reverse transcriptase </a:t>
            </a:r>
            <a:r>
              <a:rPr lang="en-US" sz="1600" i="1" dirty="0">
                <a:latin typeface="Arial" panose="020B0604020202020204" pitchFamily="34" charset="0"/>
                <a:ea typeface="Calibri" panose="020F0502020204030204" pitchFamily="34" charset="0"/>
                <a:cs typeface="Arial" panose="020B0604020202020204" pitchFamily="34" charset="0"/>
              </a:rPr>
              <a:t>(TERT)</a:t>
            </a:r>
            <a:r>
              <a:rPr lang="en-US" sz="1600" dirty="0">
                <a:latin typeface="Arial" panose="020B0604020202020204" pitchFamily="34" charset="0"/>
                <a:ea typeface="Calibri" panose="020F0502020204030204" pitchFamily="34" charset="0"/>
                <a:cs typeface="Arial" panose="020B0604020202020204" pitchFamily="34" charset="0"/>
              </a:rPr>
              <a:t> gene transcript and </a:t>
            </a:r>
            <a:r>
              <a:rPr lang="en-US" sz="1600" i="1" dirty="0">
                <a:latin typeface="Arial" panose="020B0604020202020204" pitchFamily="34" charset="0"/>
                <a:ea typeface="Calibri" panose="020F0502020204030204" pitchFamily="34" charset="0"/>
                <a:cs typeface="Arial" panose="020B0604020202020204" pitchFamily="34" charset="0"/>
              </a:rPr>
              <a:t>HPAT21; HPAT15</a:t>
            </a:r>
            <a:r>
              <a:rPr lang="en-US" sz="1600" dirty="0">
                <a:latin typeface="Arial" panose="020B0604020202020204" pitchFamily="34" charset="0"/>
                <a:ea typeface="Calibri" panose="020F0502020204030204" pitchFamily="34" charset="0"/>
                <a:cs typeface="Arial" panose="020B0604020202020204" pitchFamily="34" charset="0"/>
              </a:rPr>
              <a:t>; and </a:t>
            </a:r>
            <a:r>
              <a:rPr lang="en-US" sz="1600" i="1" dirty="0">
                <a:latin typeface="Arial" panose="020B0604020202020204" pitchFamily="34" charset="0"/>
                <a:ea typeface="Calibri" panose="020F0502020204030204" pitchFamily="34" charset="0"/>
                <a:cs typeface="Arial" panose="020B0604020202020204" pitchFamily="34" charset="0"/>
              </a:rPr>
              <a:t>HAPT2</a:t>
            </a:r>
            <a:r>
              <a:rPr lang="en-US" sz="1600" dirty="0">
                <a:latin typeface="Arial" panose="020B0604020202020204" pitchFamily="34" charset="0"/>
                <a:ea typeface="Calibri" panose="020F0502020204030204" pitchFamily="34" charset="0"/>
                <a:cs typeface="Arial" panose="020B0604020202020204" pitchFamily="34" charset="0"/>
              </a:rPr>
              <a:t> </a:t>
            </a:r>
            <a:r>
              <a:rPr lang="en-US" sz="1600" dirty="0" err="1">
                <a:latin typeface="Arial" panose="020B0604020202020204" pitchFamily="34" charset="0"/>
                <a:ea typeface="Calibri" panose="020F0502020204030204" pitchFamily="34" charset="0"/>
                <a:cs typeface="Arial" panose="020B0604020202020204" pitchFamily="34" charset="0"/>
              </a:rPr>
              <a:t>lincRNAs</a:t>
            </a:r>
            <a:r>
              <a:rPr lang="en-US" sz="1600" dirty="0">
                <a:latin typeface="Arial" panose="020B0604020202020204" pitchFamily="34" charset="0"/>
                <a:ea typeface="Calibri" panose="020F0502020204030204" pitchFamily="34" charset="0"/>
                <a:cs typeface="Arial" panose="020B0604020202020204" pitchFamily="34" charset="0"/>
              </a:rPr>
              <a:t> in human blastocyst cells. A color-coded stacked area plot depicts relative expression values of the </a:t>
            </a:r>
            <a:r>
              <a:rPr lang="en-US" sz="1600" i="1" dirty="0">
                <a:latin typeface="Arial" panose="020B0604020202020204" pitchFamily="34" charset="0"/>
                <a:ea typeface="Calibri" panose="020F0502020204030204" pitchFamily="34" charset="0"/>
                <a:cs typeface="Arial" panose="020B0604020202020204" pitchFamily="34" charset="0"/>
              </a:rPr>
              <a:t>TERT</a:t>
            </a:r>
            <a:r>
              <a:rPr lang="en-US" sz="1600" dirty="0">
                <a:latin typeface="Arial" panose="020B0604020202020204" pitchFamily="34" charset="0"/>
                <a:ea typeface="Calibri" panose="020F0502020204030204" pitchFamily="34" charset="0"/>
                <a:cs typeface="Arial" panose="020B0604020202020204" pitchFamily="34" charset="0"/>
              </a:rPr>
              <a:t> gene transcript and designated HPAT </a:t>
            </a:r>
            <a:r>
              <a:rPr lang="en-US" sz="1600" dirty="0" err="1">
                <a:latin typeface="Arial" panose="020B0604020202020204" pitchFamily="34" charset="0"/>
                <a:ea typeface="Calibri" panose="020F0502020204030204" pitchFamily="34" charset="0"/>
                <a:cs typeface="Arial" panose="020B0604020202020204" pitchFamily="34" charset="0"/>
              </a:rPr>
              <a:t>lincRNAs</a:t>
            </a:r>
            <a:r>
              <a:rPr lang="en-US" sz="1600" dirty="0">
                <a:latin typeface="Arial" panose="020B0604020202020204" pitchFamily="34" charset="0"/>
                <a:ea typeface="Calibri" panose="020F0502020204030204" pitchFamily="34" charset="0"/>
                <a:cs typeface="Arial" panose="020B0604020202020204" pitchFamily="34" charset="0"/>
              </a:rPr>
              <a:t> in individual blastocyst cells. Note that a vast majority (89%) of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emerged within the HPAT21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HPAT15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HPAT2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amp; HPAT21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HPAT15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HPAT2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sub-populations of human blastocyst cells. </a:t>
            </a:r>
          </a:p>
          <a:p>
            <a:pPr marL="342900" marR="0" lvl="0" indent="-342900" algn="ctr">
              <a:spcBef>
                <a:spcPts val="0"/>
              </a:spcBef>
              <a:spcAft>
                <a:spcPts val="0"/>
              </a:spcAft>
              <a:buFont typeface="Helvetica" panose="020B0604020202020204" pitchFamily="34" charset="0"/>
              <a:buAutoNum type="alphaUcParenBoth"/>
            </a:pPr>
            <a:r>
              <a:rPr lang="en-US" sz="1600" dirty="0">
                <a:latin typeface="Arial" panose="020B0604020202020204" pitchFamily="34" charset="0"/>
                <a:ea typeface="Calibri" panose="020F0502020204030204" pitchFamily="34" charset="0"/>
                <a:cs typeface="Arial" panose="020B0604020202020204" pitchFamily="34" charset="0"/>
              </a:rPr>
              <a:t>Marked expansion of </a:t>
            </a:r>
            <a:r>
              <a:rPr lang="en-US" sz="1600" i="1" dirty="0">
                <a:latin typeface="Arial" panose="020B0604020202020204" pitchFamily="34" charset="0"/>
                <a:ea typeface="Calibri" panose="020F0502020204030204" pitchFamily="34" charset="0"/>
                <a:cs typeface="Arial" panose="020B0604020202020204" pitchFamily="34" charset="0"/>
              </a:rPr>
              <a:t>TERT</a:t>
            </a:r>
            <a:r>
              <a:rPr lang="en-US" sz="1600" dirty="0">
                <a:latin typeface="Arial" panose="020B0604020202020204" pitchFamily="34" charset="0"/>
                <a:ea typeface="Calibri" panose="020F0502020204030204" pitchFamily="34" charset="0"/>
                <a:cs typeface="Arial" panose="020B0604020202020204" pitchFamily="34" charset="0"/>
              </a:rPr>
              <a:t>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during human blastocyst differentiation. Note that there is only a single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 was detected in the population of the early-stage blastocyst cells (~1%) whereas the </a:t>
            </a:r>
            <a:r>
              <a:rPr lang="en-US" sz="1600" i="1" dirty="0">
                <a:latin typeface="Arial" panose="020B0604020202020204" pitchFamily="34" charset="0"/>
                <a:ea typeface="Calibri" panose="020F0502020204030204" pitchFamily="34" charset="0"/>
                <a:cs typeface="Arial" panose="020B0604020202020204" pitchFamily="34" charset="0"/>
              </a:rPr>
              <a:t>TERT</a:t>
            </a:r>
            <a:r>
              <a:rPr lang="en-US" sz="1600" dirty="0">
                <a:latin typeface="Arial" panose="020B0604020202020204" pitchFamily="34" charset="0"/>
                <a:ea typeface="Calibri" panose="020F0502020204030204" pitchFamily="34" charset="0"/>
                <a:cs typeface="Arial" panose="020B0604020202020204" pitchFamily="34" charset="0"/>
              </a:rPr>
              <a:t> gene expression was detected in a relatively large sub-population (11%) of the late-stage blastocyst cells.  The inset lists genes that are expressed in a vast majority (89% to 100%) of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recovered from human blastocysts. </a:t>
            </a:r>
          </a:p>
          <a:p>
            <a:pPr marL="342900" marR="0" lvl="0" indent="-342900" algn="ctr">
              <a:spcBef>
                <a:spcPts val="0"/>
              </a:spcBef>
              <a:spcAft>
                <a:spcPts val="0"/>
              </a:spcAft>
              <a:buFont typeface="Helvetica" panose="020B0604020202020204" pitchFamily="34" charset="0"/>
              <a:buAutoNum type="alphaUcParenBoth"/>
            </a:pPr>
            <a:r>
              <a:rPr lang="en-US" sz="1600" dirty="0">
                <a:latin typeface="Arial" panose="020B0604020202020204" pitchFamily="34" charset="0"/>
                <a:ea typeface="Calibri" panose="020F0502020204030204" pitchFamily="34" charset="0"/>
                <a:cs typeface="Arial" panose="020B0604020202020204" pitchFamily="34" charset="0"/>
              </a:rPr>
              <a:t>Cell identity gene expression signature (GES) of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recovered from human blastocysts. The list includes genes that are not expressed in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and genes that are expressed in at least two-third of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from 67% to 100% of telomerase-positive cells). Stars in (C) and (D) designate genes that were identified as pluripotency regulators, inducers, or markers of the pluripotent state, including eight HPAT </a:t>
            </a:r>
            <a:r>
              <a:rPr lang="en-US" sz="1600" dirty="0" err="1">
                <a:latin typeface="Arial" panose="020B0604020202020204" pitchFamily="34" charset="0"/>
                <a:ea typeface="Calibri" panose="020F0502020204030204" pitchFamily="34" charset="0"/>
                <a:cs typeface="Arial" panose="020B0604020202020204" pitchFamily="34" charset="0"/>
              </a:rPr>
              <a:t>lincRNAs</a:t>
            </a:r>
            <a:r>
              <a:rPr lang="en-US" sz="1600" dirty="0">
                <a:latin typeface="Arial" panose="020B0604020202020204" pitchFamily="34" charset="0"/>
                <a:ea typeface="Calibri" panose="020F0502020204030204" pitchFamily="34" charset="0"/>
                <a:cs typeface="Arial" panose="020B0604020202020204" pitchFamily="34" charset="0"/>
              </a:rPr>
              <a:t> that are expressed in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Right brace in (C) designates eight </a:t>
            </a:r>
            <a:r>
              <a:rPr lang="en-US" sz="1600" dirty="0" err="1">
                <a:latin typeface="Arial" panose="020B0604020202020204" pitchFamily="34" charset="0"/>
                <a:ea typeface="Calibri" panose="020F0502020204030204" pitchFamily="34" charset="0"/>
                <a:cs typeface="Arial" panose="020B0604020202020204" pitchFamily="34" charset="0"/>
              </a:rPr>
              <a:t>lincRNAs</a:t>
            </a:r>
            <a:r>
              <a:rPr lang="en-US" sz="1600" dirty="0">
                <a:latin typeface="Arial" panose="020B0604020202020204" pitchFamily="34" charset="0"/>
                <a:ea typeface="Calibri" panose="020F0502020204030204" pitchFamily="34" charset="0"/>
                <a:cs typeface="Arial" panose="020B0604020202020204" pitchFamily="34" charset="0"/>
              </a:rPr>
              <a:t> expression of which appears repressed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Positions of the blue line inside the circle reflect the percentage of cells within the TERT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population that express transcripts encoded by the corresponding genes. </a:t>
            </a:r>
          </a:p>
          <a:p>
            <a:pPr marL="342900" marR="0" lvl="0" indent="-342900" algn="ctr">
              <a:spcBef>
                <a:spcPts val="0"/>
              </a:spcBef>
              <a:spcAft>
                <a:spcPts val="0"/>
              </a:spcAft>
              <a:buFont typeface="Helvetica" panose="020B0604020202020204" pitchFamily="34" charset="0"/>
              <a:buAutoNum type="alphaUcParenBoth"/>
            </a:pPr>
            <a:r>
              <a:rPr lang="en-US" sz="1600" dirty="0">
                <a:latin typeface="Arial" panose="020B0604020202020204" pitchFamily="34" charset="0"/>
                <a:ea typeface="Calibri" panose="020F0502020204030204" pitchFamily="34" charset="0"/>
                <a:cs typeface="Arial" panose="020B0604020202020204" pitchFamily="34" charset="0"/>
              </a:rPr>
              <a:t>List of genes that are expressed in 6%-56% of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recovered from human blastocysts. Bar heights correspond to the percentage of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cells expressing designated genes. </a:t>
            </a:r>
          </a:p>
          <a:p>
            <a:pPr marL="342900" marR="0" lvl="0" indent="-342900" algn="ctr">
              <a:spcBef>
                <a:spcPts val="0"/>
              </a:spcBef>
              <a:spcAft>
                <a:spcPts val="800"/>
              </a:spcAft>
              <a:buFont typeface="Helvetica" panose="020B0604020202020204" pitchFamily="34" charset="0"/>
              <a:buAutoNum type="alphaUcParenBoth"/>
            </a:pPr>
            <a:r>
              <a:rPr lang="en-US" sz="1600" dirty="0">
                <a:latin typeface="Arial" panose="020B0604020202020204" pitchFamily="34" charset="0"/>
                <a:ea typeface="Calibri" panose="020F0502020204030204" pitchFamily="34" charset="0"/>
                <a:cs typeface="Arial" panose="020B0604020202020204" pitchFamily="34" charset="0"/>
              </a:rPr>
              <a:t>Visualization of </a:t>
            </a:r>
            <a:r>
              <a:rPr lang="en-US" sz="1600" i="1" dirty="0">
                <a:latin typeface="Arial" panose="020B0604020202020204" pitchFamily="34" charset="0"/>
                <a:ea typeface="Calibri" panose="020F0502020204030204" pitchFamily="34" charset="0"/>
                <a:cs typeface="Arial" panose="020B0604020202020204" pitchFamily="34" charset="0"/>
              </a:rPr>
              <a:t>TERT </a:t>
            </a:r>
            <a:r>
              <a:rPr lang="en-US" sz="1600" i="1"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putative immortal ground-state pluripotency precursor cells using the 3D reconstructed blastocyst model that was utilized to design the first web-based online tool to study early cell fate decisions in the human blastocyst, which is available online at </a:t>
            </a:r>
            <a:r>
              <a:rPr lang="en-US" sz="1600" u="sng" dirty="0">
                <a:solidFill>
                  <a:srgbClr val="0000FF"/>
                </a:solidFill>
                <a:latin typeface="Arial" panose="020B0604020202020204" pitchFamily="34" charset="0"/>
                <a:ea typeface="Calibri" panose="020F0502020204030204" pitchFamily="34" charset="0"/>
                <a:cs typeface="Arial" panose="020B0604020202020204" pitchFamily="34" charset="0"/>
                <a:hlinkClick r:id="rId2"/>
              </a:rPr>
              <a:t>http://web.stanford.edu/~sunilpai/HumanBlastocystViewer.html</a:t>
            </a:r>
            <a:r>
              <a:rPr lang="en-US" sz="1600" dirty="0">
                <a:latin typeface="Arial" panose="020B0604020202020204" pitchFamily="34" charset="0"/>
                <a:ea typeface="Calibri" panose="020F0502020204030204" pitchFamily="34" charset="0"/>
                <a:cs typeface="Arial" panose="020B0604020202020204" pitchFamily="34" charset="0"/>
              </a:rPr>
              <a:t> (Firefox/Chrome compatible). A single frame of the 3D blastocyst sphere is shown that captured ten TERT </a:t>
            </a:r>
            <a:r>
              <a:rPr lang="en-US" sz="1600" baseline="30000" dirty="0">
                <a:latin typeface="Arial" panose="020B0604020202020204" pitchFamily="34" charset="0"/>
                <a:ea typeface="Calibri" panose="020F0502020204030204" pitchFamily="34" charset="0"/>
                <a:cs typeface="Arial" panose="020B0604020202020204" pitchFamily="34" charset="0"/>
              </a:rPr>
              <a:t>(+)</a:t>
            </a:r>
            <a:r>
              <a:rPr lang="en-US" sz="1600" dirty="0">
                <a:latin typeface="Arial" panose="020B0604020202020204" pitchFamily="34" charset="0"/>
                <a:ea typeface="Calibri" panose="020F0502020204030204" pitchFamily="34" charset="0"/>
                <a:cs typeface="Arial" panose="020B0604020202020204" pitchFamily="34" charset="0"/>
              </a:rPr>
              <a:t> human late blastocyst cells. Expression patterns of other genetic markers in individual human blastocyst cells located within the same field of the 3D reconstructed blastocyst sphere are shown. The extended report of this analysis is available in the Supplemental Movie. </a:t>
            </a:r>
            <a:endParaRPr lang="en-US" sz="16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1270667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4086539537"/>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130588101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1983371112"/>
              </p:ext>
            </p:extLst>
          </p:nvPr>
        </p:nvGraphicFramePr>
        <p:xfrm>
          <a:off x="1764082" y="284445"/>
          <a:ext cx="8663836" cy="6289110"/>
        </p:xfrm>
        <a:graphic>
          <a:graphicData uri="http://schemas.openxmlformats.org/drawingml/2006/chart">
            <c:chart xmlns:c="http://schemas.openxmlformats.org/drawingml/2006/chart" r:id="rId2"/>
          </a:graphicData>
        </a:graphic>
      </p:graphicFrame>
      <p:graphicFrame>
        <p:nvGraphicFramePr>
          <p:cNvPr id="4" name="Table 3"/>
          <p:cNvGraphicFramePr>
            <a:graphicFrameLocks noGrp="1"/>
          </p:cNvGraphicFramePr>
          <p:nvPr>
            <p:extLst/>
          </p:nvPr>
        </p:nvGraphicFramePr>
        <p:xfrm>
          <a:off x="5257800" y="2879678"/>
          <a:ext cx="1676400" cy="2857500"/>
        </p:xfrm>
        <a:graphic>
          <a:graphicData uri="http://schemas.openxmlformats.org/drawingml/2006/table">
            <a:tbl>
              <a:tblPr>
                <a:tableStyleId>{5C22544A-7EE6-4342-B048-85BDC9FD1C3A}</a:tableStyleId>
              </a:tblPr>
              <a:tblGrid>
                <a:gridCol w="838200"/>
                <a:gridCol w="838200"/>
              </a:tblGrid>
              <a:tr h="190500">
                <a:tc>
                  <a:txBody>
                    <a:bodyPr/>
                    <a:lstStyle/>
                    <a:p>
                      <a:pPr algn="ctr" fontAlgn="b"/>
                      <a:r>
                        <a:rPr lang="en-US" sz="1100" b="1" u="none" strike="noStrike" dirty="0">
                          <a:effectLst/>
                        </a:rPr>
                        <a:t>HPAT2</a:t>
                      </a:r>
                      <a:endParaRPr lang="en-US" sz="11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DNMT3B</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SOX2</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TFCP2L1</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LAMC1</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EED</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MBD3</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BRG1</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WDR5</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E_CADHERIN</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PRDM14</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89%</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MLL2</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94%</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HPAT21</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100%</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TERT</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100%</a:t>
                      </a:r>
                      <a:endParaRPr lang="en-US" sz="1100" b="1" i="0" u="none" strike="noStrike" dirty="0">
                        <a:solidFill>
                          <a:srgbClr val="000000"/>
                        </a:solidFill>
                        <a:effectLst/>
                        <a:latin typeface="Calibri" panose="020F0502020204030204" pitchFamily="34" charset="0"/>
                      </a:endParaRPr>
                    </a:p>
                  </a:txBody>
                  <a:tcPr marL="9525" marR="9525" marT="9525" marB="0" anchor="b"/>
                </a:tc>
              </a:tr>
              <a:tr h="190500">
                <a:tc>
                  <a:txBody>
                    <a:bodyPr/>
                    <a:lstStyle/>
                    <a:p>
                      <a:pPr algn="ctr" fontAlgn="b"/>
                      <a:r>
                        <a:rPr lang="en-US" sz="1100" b="1" u="none" strike="noStrike">
                          <a:effectLst/>
                        </a:rPr>
                        <a:t>KLF5</a:t>
                      </a:r>
                      <a:endParaRPr lang="en-US"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b="1" u="none" strike="noStrike" dirty="0" smtClean="0">
                          <a:effectLst/>
                        </a:rPr>
                        <a:t>100%</a:t>
                      </a:r>
                      <a:endParaRPr lang="en-US" sz="1100" b="1" i="0" u="none" strike="noStrike" dirty="0">
                        <a:solidFill>
                          <a:srgbClr val="000000"/>
                        </a:solidFill>
                        <a:effectLst/>
                        <a:latin typeface="Calibri" panose="020F0502020204030204" pitchFamily="34" charset="0"/>
                      </a:endParaRPr>
                    </a:p>
                  </a:txBody>
                  <a:tcPr marL="9525" marR="9525" marT="9525" marB="0" anchor="b"/>
                </a:tc>
              </a:tr>
            </a:tbl>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6712816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1162320061"/>
              </p:ext>
            </p:extLst>
          </p:nvPr>
        </p:nvGraphicFramePr>
        <p:xfrm>
          <a:off x="1764082" y="284445"/>
          <a:ext cx="8663836" cy="6289110"/>
        </p:xfrm>
        <a:graphic>
          <a:graphicData uri="http://schemas.openxmlformats.org/drawingml/2006/chart">
            <c:chart xmlns:c="http://schemas.openxmlformats.org/drawingml/2006/chart" r:id="rId3"/>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4" name="5-Point Star 3"/>
          <p:cNvSpPr/>
          <p:nvPr/>
        </p:nvSpPr>
        <p:spPr>
          <a:xfrm>
            <a:off x="4602816" y="791570"/>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5" name="5-Point Star 4"/>
          <p:cNvSpPr/>
          <p:nvPr/>
        </p:nvSpPr>
        <p:spPr>
          <a:xfrm>
            <a:off x="2692129" y="3534770"/>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6" name="5-Point Star 5"/>
          <p:cNvSpPr/>
          <p:nvPr/>
        </p:nvSpPr>
        <p:spPr>
          <a:xfrm>
            <a:off x="7878278" y="596407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7" name="5-Point Star 6"/>
          <p:cNvSpPr/>
          <p:nvPr/>
        </p:nvSpPr>
        <p:spPr>
          <a:xfrm>
            <a:off x="9283997" y="4135271"/>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8" name="Right Brace 7"/>
          <p:cNvSpPr/>
          <p:nvPr/>
        </p:nvSpPr>
        <p:spPr>
          <a:xfrm rot="18319678">
            <a:off x="7875168" y="272385"/>
            <a:ext cx="388357" cy="1836210"/>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 name="5-Point Star 8"/>
          <p:cNvSpPr/>
          <p:nvPr/>
        </p:nvSpPr>
        <p:spPr>
          <a:xfrm>
            <a:off x="6000465" y="6573555"/>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0" name="5-Point Star 9"/>
          <p:cNvSpPr/>
          <p:nvPr/>
        </p:nvSpPr>
        <p:spPr>
          <a:xfrm>
            <a:off x="4534577" y="6220988"/>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1" name="5-Point Star 10"/>
          <p:cNvSpPr/>
          <p:nvPr/>
        </p:nvSpPr>
        <p:spPr>
          <a:xfrm>
            <a:off x="2728522" y="2672570"/>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2" name="5-Point Star 11"/>
          <p:cNvSpPr/>
          <p:nvPr/>
        </p:nvSpPr>
        <p:spPr>
          <a:xfrm>
            <a:off x="3996518" y="1040365"/>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3" name="5-Point Star 12"/>
          <p:cNvSpPr/>
          <p:nvPr/>
        </p:nvSpPr>
        <p:spPr>
          <a:xfrm>
            <a:off x="5411200" y="641445"/>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4" name="5-Point Star 13"/>
          <p:cNvSpPr/>
          <p:nvPr/>
        </p:nvSpPr>
        <p:spPr>
          <a:xfrm>
            <a:off x="3628030" y="564778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5" name="5-Point Star 14"/>
          <p:cNvSpPr/>
          <p:nvPr/>
        </p:nvSpPr>
        <p:spPr>
          <a:xfrm>
            <a:off x="4793885" y="6373271"/>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6" name="5-Point Star 15"/>
          <p:cNvSpPr/>
          <p:nvPr/>
        </p:nvSpPr>
        <p:spPr>
          <a:xfrm>
            <a:off x="7112485" y="6371113"/>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7" name="5-Point Star 16"/>
          <p:cNvSpPr/>
          <p:nvPr/>
        </p:nvSpPr>
        <p:spPr>
          <a:xfrm>
            <a:off x="8930673" y="4954021"/>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
        <p:nvSpPr>
          <p:cNvPr id="18" name="5-Point Star 17"/>
          <p:cNvSpPr/>
          <p:nvPr/>
        </p:nvSpPr>
        <p:spPr>
          <a:xfrm>
            <a:off x="8644069" y="5465520"/>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Tree>
    <p:extLst>
      <p:ext uri="{BB962C8B-B14F-4D97-AF65-F5344CB8AC3E}">
        <p14:creationId xmlns:p14="http://schemas.microsoft.com/office/powerpoint/2010/main" val="125356365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658877090"/>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5-Point Star 2"/>
          <p:cNvSpPr/>
          <p:nvPr/>
        </p:nvSpPr>
        <p:spPr>
          <a:xfrm>
            <a:off x="1668547" y="1255594"/>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4" name="TextBox 3"/>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
        <p:nvSpPr>
          <p:cNvPr id="5" name="5-Point Star 4"/>
          <p:cNvSpPr/>
          <p:nvPr/>
        </p:nvSpPr>
        <p:spPr>
          <a:xfrm>
            <a:off x="1668547" y="5625153"/>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6" name="5-Point Star 5"/>
          <p:cNvSpPr/>
          <p:nvPr/>
        </p:nvSpPr>
        <p:spPr>
          <a:xfrm>
            <a:off x="1668546" y="3946478"/>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7" name="5-Point Star 6"/>
          <p:cNvSpPr/>
          <p:nvPr/>
        </p:nvSpPr>
        <p:spPr>
          <a:xfrm>
            <a:off x="1668546" y="4188667"/>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8" name="5-Point Star 7"/>
          <p:cNvSpPr/>
          <p:nvPr/>
        </p:nvSpPr>
        <p:spPr>
          <a:xfrm>
            <a:off x="1668546" y="3349330"/>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solidFill>
                <a:srgbClr val="FF0000"/>
              </a:solidFill>
            </a:endParaRPr>
          </a:p>
        </p:txBody>
      </p:sp>
    </p:spTree>
    <p:extLst>
      <p:ext uri="{BB962C8B-B14F-4D97-AF65-F5344CB8AC3E}">
        <p14:creationId xmlns:p14="http://schemas.microsoft.com/office/powerpoint/2010/main" val="23759115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3" name="TextBox 2"/>
          <p:cNvSpPr txBox="1"/>
          <p:nvPr/>
        </p:nvSpPr>
        <p:spPr>
          <a:xfrm flipH="1">
            <a:off x="0" y="-27296"/>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264836538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905</TotalTime>
  <Words>597</Words>
  <Application>Microsoft Office PowerPoint</Application>
  <PresentationFormat>Widescreen</PresentationFormat>
  <Paragraphs>54</Paragraphs>
  <Slides>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xsi="http://www.w3.org/2001/XMLSchema-instance"/>
</file>